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1F9BD-3190-46EB-A22D-0388002B6C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CAC77-4684-4A4B-AEA1-21A6D8E89C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FAF08-44DA-40B2-9C50-D4E7F20B73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993DF-2C6D-447B-AD6F-0A8A69C7B3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A790D-2025-4810-B1D8-950E7D5E01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23EC7-73B3-4E2C-BB1C-FB9509CA02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91E2C-517B-4616-AF67-950BA3CEC9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57152-B13E-4795-980D-3A9C7C8E2B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37C6E4-0553-4408-ABF4-D33EC277C4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4C92A-2720-4BBE-B5F7-2E2155380A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160A6-FC5A-4748-9629-D6FF2459A7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3A6FB-050E-4653-94D6-F2B70942D2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A4B96FB-9930-431F-AFC4-DA445AB132E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0" y="0"/>
            <a:ext cx="137160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1f497d"/>
                </a:solidFill>
                <a:latin typeface="Arial"/>
                <a:ea typeface="Arial"/>
              </a:rPr>
              <a:t>Figure S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528"/>
          <p:cNvGrpSpPr/>
          <p:nvPr/>
        </p:nvGrpSpPr>
        <p:grpSpPr>
          <a:xfrm>
            <a:off x="573120" y="838080"/>
            <a:ext cx="8188200" cy="5941080"/>
            <a:chOff x="573120" y="838080"/>
            <a:chExt cx="8188200" cy="5941080"/>
          </a:xfrm>
        </p:grpSpPr>
        <p:sp>
          <p:nvSpPr>
            <p:cNvPr id="43" name="TextBox 558"/>
            <p:cNvSpPr/>
            <p:nvPr/>
          </p:nvSpPr>
          <p:spPr>
            <a:xfrm>
              <a:off x="4230720" y="6502680"/>
              <a:ext cx="2095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rvival time (months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4" name="TextBox 4" descr=""/>
            <p:cNvPicPr/>
            <p:nvPr/>
          </p:nvPicPr>
          <p:blipFill>
            <a:blip r:embed="rId1"/>
            <a:stretch/>
          </p:blipFill>
          <p:spPr>
            <a:xfrm>
              <a:off x="573120" y="1926000"/>
              <a:ext cx="371520" cy="2395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Line 27"/>
            <p:cNvSpPr/>
            <p:nvPr/>
          </p:nvSpPr>
          <p:spPr>
            <a:xfrm>
              <a:off x="987120" y="921960"/>
              <a:ext cx="0" cy="5577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Line 28"/>
            <p:cNvSpPr/>
            <p:nvPr/>
          </p:nvSpPr>
          <p:spPr>
            <a:xfrm flipH="1">
              <a:off x="988920" y="6499440"/>
              <a:ext cx="7772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7" name="Group 4"/>
            <p:cNvGrpSpPr/>
            <p:nvPr/>
          </p:nvGrpSpPr>
          <p:grpSpPr>
            <a:xfrm>
              <a:off x="990360" y="838080"/>
              <a:ext cx="7699320" cy="5643720"/>
              <a:chOff x="990360" y="838080"/>
              <a:chExt cx="7699320" cy="5643720"/>
            </a:xfrm>
          </p:grpSpPr>
          <p:sp>
            <p:nvSpPr>
              <p:cNvPr id="48" name="AutoShape 3"/>
              <p:cNvSpPr/>
              <p:nvPr/>
            </p:nvSpPr>
            <p:spPr>
              <a:xfrm>
                <a:off x="990360" y="838080"/>
                <a:ext cx="7699320" cy="56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49" name="Group 205"/>
              <p:cNvGrpSpPr/>
              <p:nvPr/>
            </p:nvGrpSpPr>
            <p:grpSpPr>
              <a:xfrm>
                <a:off x="1068120" y="914400"/>
                <a:ext cx="7545240" cy="5489640"/>
                <a:chOff x="1068120" y="914400"/>
                <a:chExt cx="7545240" cy="5489640"/>
              </a:xfrm>
            </p:grpSpPr>
            <p:sp>
              <p:nvSpPr>
                <p:cNvPr id="50" name="Rectangle 5"/>
                <p:cNvSpPr/>
                <p:nvPr/>
              </p:nvSpPr>
              <p:spPr>
                <a:xfrm>
                  <a:off x="1068120" y="914400"/>
                  <a:ext cx="7545240" cy="5489640"/>
                </a:xfrm>
                <a:prstGeom prst="rect">
                  <a:avLst/>
                </a:prstGeom>
                <a:solidFill>
                  <a:srgbClr val="eaf2f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" name="Rectangle 6"/>
                <p:cNvSpPr/>
                <p:nvPr/>
              </p:nvSpPr>
              <p:spPr>
                <a:xfrm>
                  <a:off x="1069560" y="917640"/>
                  <a:ext cx="7540560" cy="548460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Rectangle 7"/>
                <p:cNvSpPr/>
                <p:nvPr/>
              </p:nvSpPr>
              <p:spPr>
                <a:xfrm>
                  <a:off x="1069560" y="917640"/>
                  <a:ext cx="1884240" cy="273996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" name="Rectangle 8"/>
                <p:cNvSpPr/>
                <p:nvPr/>
              </p:nvSpPr>
              <p:spPr>
                <a:xfrm>
                  <a:off x="1298160" y="1089000"/>
                  <a:ext cx="1655640" cy="23414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Freeform 9"/>
                <p:cNvSpPr/>
                <p:nvPr/>
              </p:nvSpPr>
              <p:spPr>
                <a:xfrm>
                  <a:off x="1379160" y="1170000"/>
                  <a:ext cx="1371600" cy="544680"/>
                </a:xfrm>
                <a:custGeom>
                  <a:avLst/>
                  <a:gdLst/>
                  <a:ahLst/>
                  <a:rect l="l" t="t" r="r" b="b"/>
                  <a:pathLst>
                    <a:path w="600" h="238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87" y="0"/>
                      </a:lnTo>
                      <a:lnTo>
                        <a:pt x="87" y="48"/>
                      </a:lnTo>
                      <a:lnTo>
                        <a:pt x="131" y="48"/>
                      </a:lnTo>
                      <a:lnTo>
                        <a:pt x="131" y="98"/>
                      </a:lnTo>
                      <a:lnTo>
                        <a:pt x="327" y="98"/>
                      </a:lnTo>
                      <a:lnTo>
                        <a:pt x="327" y="148"/>
                      </a:lnTo>
                      <a:lnTo>
                        <a:pt x="360" y="148"/>
                      </a:lnTo>
                      <a:lnTo>
                        <a:pt x="382" y="148"/>
                      </a:lnTo>
                      <a:lnTo>
                        <a:pt x="387" y="148"/>
                      </a:lnTo>
                      <a:lnTo>
                        <a:pt x="398" y="148"/>
                      </a:lnTo>
                      <a:lnTo>
                        <a:pt x="420" y="148"/>
                      </a:lnTo>
                      <a:lnTo>
                        <a:pt x="442" y="148"/>
                      </a:lnTo>
                      <a:lnTo>
                        <a:pt x="442" y="238"/>
                      </a:lnTo>
                      <a:lnTo>
                        <a:pt x="518" y="238"/>
                      </a:lnTo>
                      <a:lnTo>
                        <a:pt x="524" y="238"/>
                      </a:lnTo>
                      <a:lnTo>
                        <a:pt x="540" y="238"/>
                      </a:lnTo>
                      <a:lnTo>
                        <a:pt x="545" y="238"/>
                      </a:lnTo>
                      <a:lnTo>
                        <a:pt x="584" y="238"/>
                      </a:lnTo>
                      <a:lnTo>
                        <a:pt x="589" y="238"/>
                      </a:lnTo>
                      <a:lnTo>
                        <a:pt x="600" y="238"/>
                      </a:lnTo>
                    </a:path>
                  </a:pathLst>
                </a:custGeom>
                <a:noFill/>
                <a:ln w="30240">
                  <a:solidFill>
                    <a:srgbClr val="1a476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" name="Freeform 10"/>
                <p:cNvSpPr/>
                <p:nvPr/>
              </p:nvSpPr>
              <p:spPr>
                <a:xfrm>
                  <a:off x="1379160" y="1170000"/>
                  <a:ext cx="1387440" cy="1287360"/>
                </a:xfrm>
                <a:custGeom>
                  <a:avLst/>
                  <a:gdLst/>
                  <a:ahLst/>
                  <a:rect l="l" t="t" r="r" b="b"/>
                  <a:pathLst>
                    <a:path w="607" h="563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6" y="0"/>
                      </a:lnTo>
                      <a:lnTo>
                        <a:pt x="6" y="73"/>
                      </a:lnTo>
                      <a:lnTo>
                        <a:pt x="16" y="73"/>
                      </a:lnTo>
                      <a:lnTo>
                        <a:pt x="16" y="147"/>
                      </a:lnTo>
                      <a:lnTo>
                        <a:pt x="27" y="147"/>
                      </a:lnTo>
                      <a:lnTo>
                        <a:pt x="27" y="220"/>
                      </a:lnTo>
                      <a:lnTo>
                        <a:pt x="120" y="220"/>
                      </a:lnTo>
                      <a:lnTo>
                        <a:pt x="120" y="294"/>
                      </a:lnTo>
                      <a:lnTo>
                        <a:pt x="136" y="294"/>
                      </a:lnTo>
                      <a:lnTo>
                        <a:pt x="136" y="367"/>
                      </a:lnTo>
                      <a:lnTo>
                        <a:pt x="202" y="367"/>
                      </a:lnTo>
                      <a:lnTo>
                        <a:pt x="273" y="367"/>
                      </a:lnTo>
                      <a:lnTo>
                        <a:pt x="278" y="367"/>
                      </a:lnTo>
                      <a:lnTo>
                        <a:pt x="289" y="367"/>
                      </a:lnTo>
                      <a:lnTo>
                        <a:pt x="316" y="367"/>
                      </a:lnTo>
                      <a:lnTo>
                        <a:pt x="322" y="367"/>
                      </a:lnTo>
                      <a:lnTo>
                        <a:pt x="322" y="563"/>
                      </a:lnTo>
                      <a:lnTo>
                        <a:pt x="327" y="563"/>
                      </a:lnTo>
                      <a:lnTo>
                        <a:pt x="329" y="563"/>
                      </a:lnTo>
                      <a:lnTo>
                        <a:pt x="605" y="563"/>
                      </a:lnTo>
                      <a:lnTo>
                        <a:pt x="607" y="563"/>
                      </a:lnTo>
                    </a:path>
                  </a:pathLst>
                </a:custGeom>
                <a:noFill/>
                <a:ln w="30240">
                  <a:solidFill>
                    <a:srgbClr val="90353b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Line 11"/>
                <p:cNvSpPr/>
                <p:nvPr/>
              </p:nvSpPr>
              <p:spPr>
                <a:xfrm flipV="1">
                  <a:off x="1577520" y="123624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Line 12"/>
                <p:cNvSpPr/>
                <p:nvPr/>
              </p:nvSpPr>
              <p:spPr>
                <a:xfrm flipV="1">
                  <a:off x="1841040" y="196524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Line 13"/>
                <p:cNvSpPr/>
                <p:nvPr/>
              </p:nvSpPr>
              <p:spPr>
                <a:xfrm flipV="1">
                  <a:off x="2003040" y="196524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Line 14"/>
                <p:cNvSpPr/>
                <p:nvPr/>
              </p:nvSpPr>
              <p:spPr>
                <a:xfrm flipV="1">
                  <a:off x="2014200" y="196524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Line 15"/>
                <p:cNvSpPr/>
                <p:nvPr/>
              </p:nvSpPr>
              <p:spPr>
                <a:xfrm flipV="1">
                  <a:off x="2039400" y="196524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Line 16"/>
                <p:cNvSpPr/>
                <p:nvPr/>
              </p:nvSpPr>
              <p:spPr>
                <a:xfrm flipV="1">
                  <a:off x="2101320" y="196524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" name="Line 17"/>
                <p:cNvSpPr/>
                <p:nvPr/>
              </p:nvSpPr>
              <p:spPr>
                <a:xfrm flipV="1">
                  <a:off x="2131560" y="2412720"/>
                  <a:ext cx="180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" name="Line 18"/>
                <p:cNvSpPr/>
                <p:nvPr/>
              </p:nvSpPr>
              <p:spPr>
                <a:xfrm flipV="1">
                  <a:off x="2201400" y="146484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" name="Line 19"/>
                <p:cNvSpPr/>
                <p:nvPr/>
              </p:nvSpPr>
              <p:spPr>
                <a:xfrm flipV="1">
                  <a:off x="2252160" y="146484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" name="Line 20"/>
                <p:cNvSpPr/>
                <p:nvPr/>
              </p:nvSpPr>
              <p:spPr>
                <a:xfrm flipV="1">
                  <a:off x="2263320" y="146484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Line 21"/>
                <p:cNvSpPr/>
                <p:nvPr/>
              </p:nvSpPr>
              <p:spPr>
                <a:xfrm flipV="1">
                  <a:off x="2288880" y="14648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Line 22"/>
                <p:cNvSpPr/>
                <p:nvPr/>
              </p:nvSpPr>
              <p:spPr>
                <a:xfrm flipV="1">
                  <a:off x="2339640" y="14648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" name="Line 23"/>
                <p:cNvSpPr/>
                <p:nvPr/>
              </p:nvSpPr>
              <p:spPr>
                <a:xfrm flipV="1">
                  <a:off x="2563560" y="167004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9" name="Line 24"/>
                <p:cNvSpPr/>
                <p:nvPr/>
              </p:nvSpPr>
              <p:spPr>
                <a:xfrm flipV="1">
                  <a:off x="2576160" y="167004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" name="Line 25"/>
                <p:cNvSpPr/>
                <p:nvPr/>
              </p:nvSpPr>
              <p:spPr>
                <a:xfrm flipV="1">
                  <a:off x="2612520" y="167004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" name="Line 26"/>
                <p:cNvSpPr/>
                <p:nvPr/>
              </p:nvSpPr>
              <p:spPr>
                <a:xfrm flipV="1">
                  <a:off x="2626920" y="167004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" name="Line 27"/>
                <p:cNvSpPr/>
                <p:nvPr/>
              </p:nvSpPr>
              <p:spPr>
                <a:xfrm flipV="1">
                  <a:off x="2714400" y="167004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" name="Line 28"/>
                <p:cNvSpPr/>
                <p:nvPr/>
              </p:nvSpPr>
              <p:spPr>
                <a:xfrm flipV="1">
                  <a:off x="2725200" y="167004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4" name="Line 29"/>
                <p:cNvSpPr/>
                <p:nvPr/>
              </p:nvSpPr>
              <p:spPr>
                <a:xfrm flipV="1">
                  <a:off x="2750760" y="167004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5" name="Line 30"/>
                <p:cNvSpPr/>
                <p:nvPr/>
              </p:nvSpPr>
              <p:spPr>
                <a:xfrm flipV="1">
                  <a:off x="2766600" y="2412720"/>
                  <a:ext cx="180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6" name="Line 31"/>
                <p:cNvSpPr/>
                <p:nvPr/>
              </p:nvSpPr>
              <p:spPr>
                <a:xfrm flipV="1">
                  <a:off x="1298160" y="1088640"/>
                  <a:ext cx="1800" cy="234468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" name="Line 32"/>
                <p:cNvSpPr/>
                <p:nvPr/>
              </p:nvSpPr>
              <p:spPr>
                <a:xfrm flipH="1">
                  <a:off x="1248480" y="3351240"/>
                  <a:ext cx="4932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" name="Rectangle 33"/>
                <p:cNvSpPr/>
                <p:nvPr/>
              </p:nvSpPr>
              <p:spPr>
                <a:xfrm rot="16200000">
                  <a:off x="1026000" y="327492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" name="Line 34"/>
                <p:cNvSpPr/>
                <p:nvPr/>
              </p:nvSpPr>
              <p:spPr>
                <a:xfrm flipH="1">
                  <a:off x="1248480" y="2806560"/>
                  <a:ext cx="4932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" name="Rectangle 35"/>
                <p:cNvSpPr/>
                <p:nvPr/>
              </p:nvSpPr>
              <p:spPr>
                <a:xfrm rot="16200000">
                  <a:off x="1027440" y="27302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2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" name="Line 36"/>
                <p:cNvSpPr/>
                <p:nvPr/>
              </p:nvSpPr>
              <p:spPr>
                <a:xfrm flipH="1">
                  <a:off x="1248480" y="2260440"/>
                  <a:ext cx="4932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2" name="Rectangle 37"/>
                <p:cNvSpPr/>
                <p:nvPr/>
              </p:nvSpPr>
              <p:spPr>
                <a:xfrm rot="16200000">
                  <a:off x="1027440" y="21826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5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3" name="Line 38"/>
                <p:cNvSpPr/>
                <p:nvPr/>
              </p:nvSpPr>
              <p:spPr>
                <a:xfrm flipH="1">
                  <a:off x="1248480" y="1716120"/>
                  <a:ext cx="4932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4" name="Rectangle 39"/>
                <p:cNvSpPr/>
                <p:nvPr/>
              </p:nvSpPr>
              <p:spPr>
                <a:xfrm rot="16200000">
                  <a:off x="1027440" y="16398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7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" name="Line 40"/>
                <p:cNvSpPr/>
                <p:nvPr/>
              </p:nvSpPr>
              <p:spPr>
                <a:xfrm flipH="1">
                  <a:off x="1248480" y="1170000"/>
                  <a:ext cx="4932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" name="Rectangle 41"/>
                <p:cNvSpPr/>
                <p:nvPr/>
              </p:nvSpPr>
              <p:spPr>
                <a:xfrm rot="16200000">
                  <a:off x="1027440" y="10922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7" name="Line 42"/>
                <p:cNvSpPr/>
                <p:nvPr/>
              </p:nvSpPr>
              <p:spPr>
                <a:xfrm>
                  <a:off x="1298160" y="3433680"/>
                  <a:ext cx="165744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8" name="Line 43"/>
                <p:cNvSpPr/>
                <p:nvPr/>
              </p:nvSpPr>
              <p:spPr>
                <a:xfrm>
                  <a:off x="137916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9" name="Rectangle 44"/>
                <p:cNvSpPr/>
                <p:nvPr/>
              </p:nvSpPr>
              <p:spPr>
                <a:xfrm>
                  <a:off x="1343520" y="350820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0" name="Line 45"/>
                <p:cNvSpPr/>
                <p:nvPr/>
              </p:nvSpPr>
              <p:spPr>
                <a:xfrm>
                  <a:off x="167760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1" name="Rectangle 46"/>
                <p:cNvSpPr/>
                <p:nvPr/>
              </p:nvSpPr>
              <p:spPr>
                <a:xfrm>
                  <a:off x="160704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4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2" name="Line 47"/>
                <p:cNvSpPr/>
                <p:nvPr/>
              </p:nvSpPr>
              <p:spPr>
                <a:xfrm>
                  <a:off x="197784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" name="Rectangle 48"/>
                <p:cNvSpPr/>
                <p:nvPr/>
              </p:nvSpPr>
              <p:spPr>
                <a:xfrm>
                  <a:off x="190728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48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" name="Line 49"/>
                <p:cNvSpPr/>
                <p:nvPr/>
              </p:nvSpPr>
              <p:spPr>
                <a:xfrm>
                  <a:off x="227772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5" name="Rectangle 50"/>
                <p:cNvSpPr/>
                <p:nvPr/>
              </p:nvSpPr>
              <p:spPr>
                <a:xfrm>
                  <a:off x="220716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72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6" name="Line 51"/>
                <p:cNvSpPr/>
                <p:nvPr/>
              </p:nvSpPr>
              <p:spPr>
                <a:xfrm>
                  <a:off x="257616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7" name="Rectangle 52"/>
                <p:cNvSpPr/>
                <p:nvPr/>
              </p:nvSpPr>
              <p:spPr>
                <a:xfrm>
                  <a:off x="250560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6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8" name="Line 53"/>
                <p:cNvSpPr/>
                <p:nvPr/>
              </p:nvSpPr>
              <p:spPr>
                <a:xfrm>
                  <a:off x="287460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9" name="Rectangle 54"/>
                <p:cNvSpPr/>
                <p:nvPr/>
              </p:nvSpPr>
              <p:spPr>
                <a:xfrm>
                  <a:off x="2769120" y="3508200"/>
                  <a:ext cx="2109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0" name="Rectangle 55"/>
                <p:cNvSpPr/>
                <p:nvPr/>
              </p:nvSpPr>
              <p:spPr>
                <a:xfrm>
                  <a:off x="1342800" y="2873520"/>
                  <a:ext cx="1357200" cy="5126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1" name="Line 56"/>
                <p:cNvSpPr/>
                <p:nvPr/>
              </p:nvSpPr>
              <p:spPr>
                <a:xfrm>
                  <a:off x="1396800" y="2989440"/>
                  <a:ext cx="102960" cy="1440"/>
                </a:xfrm>
                <a:prstGeom prst="line">
                  <a:avLst/>
                </a:prstGeom>
                <a:ln w="30240">
                  <a:solidFill>
                    <a:srgbClr val="1a476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" name="Line 57"/>
                <p:cNvSpPr/>
                <p:nvPr/>
              </p:nvSpPr>
              <p:spPr>
                <a:xfrm>
                  <a:off x="1396800" y="3271680"/>
                  <a:ext cx="102960" cy="1800"/>
                </a:xfrm>
                <a:prstGeom prst="line">
                  <a:avLst/>
                </a:prstGeom>
                <a:ln w="30240">
                  <a:solidFill>
                    <a:srgbClr val="90353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3" name="Rectangle 58"/>
                <p:cNvSpPr/>
                <p:nvPr/>
              </p:nvSpPr>
              <p:spPr>
                <a:xfrm>
                  <a:off x="1661760" y="2936880"/>
                  <a:ext cx="968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ow FAK (E/N =4/20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4" name="Rectangle 59"/>
                <p:cNvSpPr/>
                <p:nvPr/>
              </p:nvSpPr>
              <p:spPr>
                <a:xfrm>
                  <a:off x="1662480" y="3219480"/>
                  <a:ext cx="9622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High FAK (E/N=6/13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5" name="Rectangle 60"/>
                <p:cNvSpPr/>
                <p:nvPr/>
              </p:nvSpPr>
              <p:spPr>
                <a:xfrm>
                  <a:off x="1400760" y="2624040"/>
                  <a:ext cx="44892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P=0.0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6" name="Rectangle 61"/>
                <p:cNvSpPr/>
                <p:nvPr/>
              </p:nvSpPr>
              <p:spPr>
                <a:xfrm>
                  <a:off x="1193040" y="923760"/>
                  <a:ext cx="1841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High LMW-E and  high full length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7" name="Rectangle 62"/>
                <p:cNvSpPr/>
                <p:nvPr/>
              </p:nvSpPr>
              <p:spPr>
                <a:xfrm>
                  <a:off x="2955600" y="917640"/>
                  <a:ext cx="1884240" cy="273996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8" name="Rectangle 63"/>
                <p:cNvSpPr/>
                <p:nvPr/>
              </p:nvSpPr>
              <p:spPr>
                <a:xfrm>
                  <a:off x="3184200" y="1089000"/>
                  <a:ext cx="1655640" cy="23414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9" name="Freeform 64"/>
                <p:cNvSpPr/>
                <p:nvPr/>
              </p:nvSpPr>
              <p:spPr>
                <a:xfrm>
                  <a:off x="3265200" y="1170000"/>
                  <a:ext cx="1495440" cy="1305000"/>
                </a:xfrm>
                <a:custGeom>
                  <a:avLst/>
                  <a:gdLst/>
                  <a:ahLst/>
                  <a:rect l="l" t="t" r="r" b="b"/>
                  <a:pathLst>
                    <a:path w="654" h="571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5" y="0"/>
                      </a:lnTo>
                      <a:lnTo>
                        <a:pt x="15" y="14"/>
                      </a:lnTo>
                      <a:lnTo>
                        <a:pt x="25" y="14"/>
                      </a:lnTo>
                      <a:lnTo>
                        <a:pt x="25" y="29"/>
                      </a:lnTo>
                      <a:lnTo>
                        <a:pt x="30" y="29"/>
                      </a:lnTo>
                      <a:lnTo>
                        <a:pt x="30" y="43"/>
                      </a:lnTo>
                      <a:lnTo>
                        <a:pt x="44" y="43"/>
                      </a:lnTo>
                      <a:lnTo>
                        <a:pt x="44" y="58"/>
                      </a:lnTo>
                      <a:lnTo>
                        <a:pt x="49" y="58"/>
                      </a:lnTo>
                      <a:lnTo>
                        <a:pt x="49" y="72"/>
                      </a:lnTo>
                      <a:lnTo>
                        <a:pt x="59" y="72"/>
                      </a:lnTo>
                      <a:lnTo>
                        <a:pt x="59" y="101"/>
                      </a:lnTo>
                      <a:lnTo>
                        <a:pt x="69" y="101"/>
                      </a:lnTo>
                      <a:lnTo>
                        <a:pt x="69" y="130"/>
                      </a:lnTo>
                      <a:lnTo>
                        <a:pt x="74" y="130"/>
                      </a:lnTo>
                      <a:lnTo>
                        <a:pt x="74" y="159"/>
                      </a:lnTo>
                      <a:lnTo>
                        <a:pt x="84" y="159"/>
                      </a:lnTo>
                      <a:lnTo>
                        <a:pt x="84" y="173"/>
                      </a:lnTo>
                      <a:lnTo>
                        <a:pt x="94" y="173"/>
                      </a:lnTo>
                      <a:lnTo>
                        <a:pt x="94" y="188"/>
                      </a:lnTo>
                      <a:lnTo>
                        <a:pt x="99" y="188"/>
                      </a:lnTo>
                      <a:lnTo>
                        <a:pt x="99" y="202"/>
                      </a:lnTo>
                      <a:lnTo>
                        <a:pt x="104" y="202"/>
                      </a:lnTo>
                      <a:lnTo>
                        <a:pt x="104" y="231"/>
                      </a:lnTo>
                      <a:lnTo>
                        <a:pt x="109" y="231"/>
                      </a:lnTo>
                      <a:lnTo>
                        <a:pt x="109" y="246"/>
                      </a:lnTo>
                      <a:lnTo>
                        <a:pt x="119" y="246"/>
                      </a:lnTo>
                      <a:lnTo>
                        <a:pt x="119" y="260"/>
                      </a:lnTo>
                      <a:lnTo>
                        <a:pt x="129" y="260"/>
                      </a:lnTo>
                      <a:lnTo>
                        <a:pt x="129" y="275"/>
                      </a:lnTo>
                      <a:lnTo>
                        <a:pt x="144" y="275"/>
                      </a:lnTo>
                      <a:lnTo>
                        <a:pt x="144" y="289"/>
                      </a:lnTo>
                      <a:lnTo>
                        <a:pt x="154" y="289"/>
                      </a:lnTo>
                      <a:lnTo>
                        <a:pt x="154" y="304"/>
                      </a:lnTo>
                      <a:lnTo>
                        <a:pt x="168" y="304"/>
                      </a:lnTo>
                      <a:lnTo>
                        <a:pt x="168" y="318"/>
                      </a:lnTo>
                      <a:lnTo>
                        <a:pt x="178" y="318"/>
                      </a:lnTo>
                      <a:lnTo>
                        <a:pt x="178" y="333"/>
                      </a:lnTo>
                      <a:lnTo>
                        <a:pt x="180" y="333"/>
                      </a:lnTo>
                      <a:lnTo>
                        <a:pt x="193" y="333"/>
                      </a:lnTo>
                      <a:lnTo>
                        <a:pt x="193" y="347"/>
                      </a:lnTo>
                      <a:lnTo>
                        <a:pt x="198" y="347"/>
                      </a:lnTo>
                      <a:lnTo>
                        <a:pt x="200" y="347"/>
                      </a:lnTo>
                      <a:lnTo>
                        <a:pt x="213" y="347"/>
                      </a:lnTo>
                      <a:lnTo>
                        <a:pt x="213" y="363"/>
                      </a:lnTo>
                      <a:lnTo>
                        <a:pt x="233" y="363"/>
                      </a:lnTo>
                      <a:lnTo>
                        <a:pt x="233" y="378"/>
                      </a:lnTo>
                      <a:lnTo>
                        <a:pt x="238" y="378"/>
                      </a:lnTo>
                      <a:lnTo>
                        <a:pt x="238" y="423"/>
                      </a:lnTo>
                      <a:lnTo>
                        <a:pt x="243" y="423"/>
                      </a:lnTo>
                      <a:lnTo>
                        <a:pt x="243" y="438"/>
                      </a:lnTo>
                      <a:lnTo>
                        <a:pt x="248" y="438"/>
                      </a:lnTo>
                      <a:lnTo>
                        <a:pt x="248" y="454"/>
                      </a:lnTo>
                      <a:lnTo>
                        <a:pt x="249" y="454"/>
                      </a:lnTo>
                      <a:lnTo>
                        <a:pt x="253" y="454"/>
                      </a:lnTo>
                      <a:lnTo>
                        <a:pt x="253" y="469"/>
                      </a:lnTo>
                      <a:lnTo>
                        <a:pt x="263" y="469"/>
                      </a:lnTo>
                      <a:lnTo>
                        <a:pt x="282" y="469"/>
                      </a:lnTo>
                      <a:lnTo>
                        <a:pt x="297" y="469"/>
                      </a:lnTo>
                      <a:lnTo>
                        <a:pt x="297" y="487"/>
                      </a:lnTo>
                      <a:lnTo>
                        <a:pt x="299" y="487"/>
                      </a:lnTo>
                      <a:lnTo>
                        <a:pt x="307" y="487"/>
                      </a:lnTo>
                      <a:lnTo>
                        <a:pt x="307" y="505"/>
                      </a:lnTo>
                      <a:lnTo>
                        <a:pt x="322" y="505"/>
                      </a:lnTo>
                      <a:lnTo>
                        <a:pt x="327" y="505"/>
                      </a:lnTo>
                      <a:lnTo>
                        <a:pt x="357" y="505"/>
                      </a:lnTo>
                      <a:lnTo>
                        <a:pt x="377" y="505"/>
                      </a:lnTo>
                      <a:lnTo>
                        <a:pt x="411" y="505"/>
                      </a:lnTo>
                      <a:lnTo>
                        <a:pt x="411" y="526"/>
                      </a:lnTo>
                      <a:lnTo>
                        <a:pt x="416" y="526"/>
                      </a:lnTo>
                      <a:lnTo>
                        <a:pt x="416" y="547"/>
                      </a:lnTo>
                      <a:lnTo>
                        <a:pt x="441" y="547"/>
                      </a:lnTo>
                      <a:lnTo>
                        <a:pt x="441" y="571"/>
                      </a:lnTo>
                      <a:lnTo>
                        <a:pt x="446" y="571"/>
                      </a:lnTo>
                      <a:lnTo>
                        <a:pt x="451" y="571"/>
                      </a:lnTo>
                      <a:lnTo>
                        <a:pt x="456" y="571"/>
                      </a:lnTo>
                      <a:lnTo>
                        <a:pt x="461" y="571"/>
                      </a:lnTo>
                      <a:lnTo>
                        <a:pt x="471" y="571"/>
                      </a:lnTo>
                      <a:lnTo>
                        <a:pt x="476" y="571"/>
                      </a:lnTo>
                      <a:lnTo>
                        <a:pt x="491" y="571"/>
                      </a:lnTo>
                      <a:lnTo>
                        <a:pt x="520" y="571"/>
                      </a:lnTo>
                      <a:lnTo>
                        <a:pt x="530" y="571"/>
                      </a:lnTo>
                      <a:lnTo>
                        <a:pt x="535" y="571"/>
                      </a:lnTo>
                      <a:lnTo>
                        <a:pt x="545" y="571"/>
                      </a:lnTo>
                      <a:lnTo>
                        <a:pt x="555" y="571"/>
                      </a:lnTo>
                      <a:lnTo>
                        <a:pt x="654" y="571"/>
                      </a:lnTo>
                    </a:path>
                  </a:pathLst>
                </a:custGeom>
                <a:noFill/>
                <a:ln w="30240">
                  <a:solidFill>
                    <a:srgbClr val="1a476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0" name="Freeform 65"/>
                <p:cNvSpPr/>
                <p:nvPr/>
              </p:nvSpPr>
              <p:spPr>
                <a:xfrm>
                  <a:off x="3265200" y="1170000"/>
                  <a:ext cx="1262160" cy="1682640"/>
                </a:xfrm>
                <a:custGeom>
                  <a:avLst/>
                  <a:gdLst/>
                  <a:ahLst/>
                  <a:rect l="l" t="t" r="r" b="b"/>
                  <a:pathLst>
                    <a:path w="552" h="73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" y="0"/>
                      </a:lnTo>
                      <a:lnTo>
                        <a:pt x="5" y="15"/>
                      </a:lnTo>
                      <a:lnTo>
                        <a:pt x="10" y="15"/>
                      </a:lnTo>
                      <a:lnTo>
                        <a:pt x="10" y="30"/>
                      </a:lnTo>
                      <a:lnTo>
                        <a:pt x="15" y="30"/>
                      </a:lnTo>
                      <a:lnTo>
                        <a:pt x="15" y="45"/>
                      </a:lnTo>
                      <a:lnTo>
                        <a:pt x="35" y="45"/>
                      </a:lnTo>
                      <a:lnTo>
                        <a:pt x="35" y="61"/>
                      </a:lnTo>
                      <a:lnTo>
                        <a:pt x="44" y="61"/>
                      </a:lnTo>
                      <a:lnTo>
                        <a:pt x="44" y="106"/>
                      </a:lnTo>
                      <a:lnTo>
                        <a:pt x="54" y="106"/>
                      </a:lnTo>
                      <a:lnTo>
                        <a:pt x="54" y="121"/>
                      </a:lnTo>
                      <a:lnTo>
                        <a:pt x="59" y="121"/>
                      </a:lnTo>
                      <a:lnTo>
                        <a:pt x="59" y="136"/>
                      </a:lnTo>
                      <a:lnTo>
                        <a:pt x="64" y="136"/>
                      </a:lnTo>
                      <a:lnTo>
                        <a:pt x="64" y="151"/>
                      </a:lnTo>
                      <a:lnTo>
                        <a:pt x="69" y="151"/>
                      </a:lnTo>
                      <a:lnTo>
                        <a:pt x="69" y="167"/>
                      </a:lnTo>
                      <a:lnTo>
                        <a:pt x="74" y="167"/>
                      </a:lnTo>
                      <a:lnTo>
                        <a:pt x="74" y="182"/>
                      </a:lnTo>
                      <a:lnTo>
                        <a:pt x="79" y="182"/>
                      </a:lnTo>
                      <a:lnTo>
                        <a:pt x="79" y="212"/>
                      </a:lnTo>
                      <a:lnTo>
                        <a:pt x="84" y="212"/>
                      </a:lnTo>
                      <a:lnTo>
                        <a:pt x="84" y="227"/>
                      </a:lnTo>
                      <a:lnTo>
                        <a:pt x="89" y="227"/>
                      </a:lnTo>
                      <a:lnTo>
                        <a:pt x="89" y="242"/>
                      </a:lnTo>
                      <a:lnTo>
                        <a:pt x="94" y="242"/>
                      </a:lnTo>
                      <a:lnTo>
                        <a:pt x="94" y="273"/>
                      </a:lnTo>
                      <a:lnTo>
                        <a:pt x="99" y="273"/>
                      </a:lnTo>
                      <a:lnTo>
                        <a:pt x="99" y="303"/>
                      </a:lnTo>
                      <a:lnTo>
                        <a:pt x="109" y="303"/>
                      </a:lnTo>
                      <a:lnTo>
                        <a:pt x="109" y="318"/>
                      </a:lnTo>
                      <a:lnTo>
                        <a:pt x="114" y="318"/>
                      </a:lnTo>
                      <a:lnTo>
                        <a:pt x="114" y="364"/>
                      </a:lnTo>
                      <a:lnTo>
                        <a:pt x="119" y="364"/>
                      </a:lnTo>
                      <a:lnTo>
                        <a:pt x="119" y="409"/>
                      </a:lnTo>
                      <a:lnTo>
                        <a:pt x="124" y="409"/>
                      </a:lnTo>
                      <a:lnTo>
                        <a:pt x="124" y="424"/>
                      </a:lnTo>
                      <a:lnTo>
                        <a:pt x="129" y="424"/>
                      </a:lnTo>
                      <a:lnTo>
                        <a:pt x="129" y="470"/>
                      </a:lnTo>
                      <a:lnTo>
                        <a:pt x="154" y="470"/>
                      </a:lnTo>
                      <a:lnTo>
                        <a:pt x="154" y="515"/>
                      </a:lnTo>
                      <a:lnTo>
                        <a:pt x="163" y="515"/>
                      </a:lnTo>
                      <a:lnTo>
                        <a:pt x="163" y="530"/>
                      </a:lnTo>
                      <a:lnTo>
                        <a:pt x="173" y="530"/>
                      </a:lnTo>
                      <a:lnTo>
                        <a:pt x="173" y="545"/>
                      </a:lnTo>
                      <a:lnTo>
                        <a:pt x="188" y="545"/>
                      </a:lnTo>
                      <a:lnTo>
                        <a:pt x="188" y="576"/>
                      </a:lnTo>
                      <a:lnTo>
                        <a:pt x="193" y="576"/>
                      </a:lnTo>
                      <a:lnTo>
                        <a:pt x="193" y="591"/>
                      </a:lnTo>
                      <a:lnTo>
                        <a:pt x="223" y="591"/>
                      </a:lnTo>
                      <a:lnTo>
                        <a:pt x="223" y="606"/>
                      </a:lnTo>
                      <a:lnTo>
                        <a:pt x="238" y="606"/>
                      </a:lnTo>
                      <a:lnTo>
                        <a:pt x="238" y="621"/>
                      </a:lnTo>
                      <a:lnTo>
                        <a:pt x="243" y="621"/>
                      </a:lnTo>
                      <a:lnTo>
                        <a:pt x="243" y="636"/>
                      </a:lnTo>
                      <a:lnTo>
                        <a:pt x="253" y="636"/>
                      </a:lnTo>
                      <a:lnTo>
                        <a:pt x="254" y="636"/>
                      </a:lnTo>
                      <a:lnTo>
                        <a:pt x="263" y="636"/>
                      </a:lnTo>
                      <a:lnTo>
                        <a:pt x="264" y="636"/>
                      </a:lnTo>
                      <a:lnTo>
                        <a:pt x="277" y="636"/>
                      </a:lnTo>
                      <a:lnTo>
                        <a:pt x="279" y="636"/>
                      </a:lnTo>
                      <a:lnTo>
                        <a:pt x="282" y="636"/>
                      </a:lnTo>
                      <a:lnTo>
                        <a:pt x="284" y="636"/>
                      </a:lnTo>
                      <a:lnTo>
                        <a:pt x="312" y="636"/>
                      </a:lnTo>
                      <a:lnTo>
                        <a:pt x="314" y="636"/>
                      </a:lnTo>
                      <a:lnTo>
                        <a:pt x="322" y="636"/>
                      </a:lnTo>
                      <a:lnTo>
                        <a:pt x="324" y="636"/>
                      </a:lnTo>
                      <a:lnTo>
                        <a:pt x="352" y="636"/>
                      </a:lnTo>
                      <a:lnTo>
                        <a:pt x="353" y="636"/>
                      </a:lnTo>
                      <a:lnTo>
                        <a:pt x="367" y="636"/>
                      </a:lnTo>
                      <a:lnTo>
                        <a:pt x="367" y="663"/>
                      </a:lnTo>
                      <a:lnTo>
                        <a:pt x="372" y="663"/>
                      </a:lnTo>
                      <a:lnTo>
                        <a:pt x="416" y="663"/>
                      </a:lnTo>
                      <a:lnTo>
                        <a:pt x="431" y="663"/>
                      </a:lnTo>
                      <a:lnTo>
                        <a:pt x="461" y="663"/>
                      </a:lnTo>
                      <a:lnTo>
                        <a:pt x="476" y="663"/>
                      </a:lnTo>
                      <a:lnTo>
                        <a:pt x="496" y="663"/>
                      </a:lnTo>
                      <a:lnTo>
                        <a:pt x="535" y="663"/>
                      </a:lnTo>
                      <a:lnTo>
                        <a:pt x="535" y="736"/>
                      </a:lnTo>
                      <a:lnTo>
                        <a:pt x="537" y="736"/>
                      </a:lnTo>
                      <a:lnTo>
                        <a:pt x="550" y="736"/>
                      </a:lnTo>
                      <a:lnTo>
                        <a:pt x="552" y="736"/>
                      </a:lnTo>
                    </a:path>
                  </a:pathLst>
                </a:custGeom>
                <a:noFill/>
                <a:ln w="30240">
                  <a:solidFill>
                    <a:srgbClr val="90353b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1" name="Line 66"/>
                <p:cNvSpPr/>
                <p:nvPr/>
              </p:nvSpPr>
              <p:spPr>
                <a:xfrm flipV="1">
                  <a:off x="3676320" y="1886040"/>
                  <a:ext cx="1440" cy="46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2" name="Line 67"/>
                <p:cNvSpPr/>
                <p:nvPr/>
              </p:nvSpPr>
              <p:spPr>
                <a:xfrm flipV="1">
                  <a:off x="3722400" y="191916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3" name="Line 68"/>
                <p:cNvSpPr/>
                <p:nvPr/>
              </p:nvSpPr>
              <p:spPr>
                <a:xfrm flipV="1">
                  <a:off x="3833280" y="2162160"/>
                  <a:ext cx="1800" cy="46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4" name="Line 69"/>
                <p:cNvSpPr/>
                <p:nvPr/>
              </p:nvSpPr>
              <p:spPr>
                <a:xfrm flipV="1">
                  <a:off x="3846240" y="25808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" name="Line 70"/>
                <p:cNvSpPr/>
                <p:nvPr/>
              </p:nvSpPr>
              <p:spPr>
                <a:xfrm flipV="1">
                  <a:off x="3868200" y="258084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6" name="Line 71"/>
                <p:cNvSpPr/>
                <p:nvPr/>
              </p:nvSpPr>
              <p:spPr>
                <a:xfrm flipV="1">
                  <a:off x="3866760" y="2198520"/>
                  <a:ext cx="1440" cy="432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7" name="Line 72"/>
                <p:cNvSpPr/>
                <p:nvPr/>
              </p:nvSpPr>
              <p:spPr>
                <a:xfrm flipV="1">
                  <a:off x="3903480" y="25808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" name="Line 73"/>
                <p:cNvSpPr/>
                <p:nvPr/>
              </p:nvSpPr>
              <p:spPr>
                <a:xfrm flipV="1">
                  <a:off x="3914280" y="258084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9" name="Line 74"/>
                <p:cNvSpPr/>
                <p:nvPr/>
              </p:nvSpPr>
              <p:spPr>
                <a:xfrm flipV="1">
                  <a:off x="3909600" y="2198520"/>
                  <a:ext cx="1800" cy="432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600" bIns="-36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0" name="Line 75"/>
                <p:cNvSpPr/>
                <p:nvPr/>
              </p:nvSpPr>
              <p:spPr>
                <a:xfrm flipV="1">
                  <a:off x="3947760" y="2238120"/>
                  <a:ext cx="144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" name="Line 76"/>
                <p:cNvSpPr/>
                <p:nvPr/>
              </p:nvSpPr>
              <p:spPr>
                <a:xfrm flipV="1">
                  <a:off x="3982680" y="25808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2" name="Line 77"/>
                <p:cNvSpPr/>
                <p:nvPr/>
              </p:nvSpPr>
              <p:spPr>
                <a:xfrm flipV="1">
                  <a:off x="4005000" y="25808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3" name="Line 78"/>
                <p:cNvSpPr/>
                <p:nvPr/>
              </p:nvSpPr>
              <p:spPr>
                <a:xfrm flipV="1">
                  <a:off x="4000320" y="227916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4" name="Line 79"/>
                <p:cNvSpPr/>
                <p:nvPr/>
              </p:nvSpPr>
              <p:spPr>
                <a:xfrm flipV="1">
                  <a:off x="4012920" y="227916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5" name="Line 80"/>
                <p:cNvSpPr/>
                <p:nvPr/>
              </p:nvSpPr>
              <p:spPr>
                <a:xfrm flipV="1">
                  <a:off x="4071600" y="25808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6" name="Line 81"/>
                <p:cNvSpPr/>
                <p:nvPr/>
              </p:nvSpPr>
              <p:spPr>
                <a:xfrm flipV="1">
                  <a:off x="4080960" y="227916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7" name="Line 82"/>
                <p:cNvSpPr/>
                <p:nvPr/>
              </p:nvSpPr>
              <p:spPr>
                <a:xfrm flipV="1">
                  <a:off x="4114440" y="264276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8" name="Line 83"/>
                <p:cNvSpPr/>
                <p:nvPr/>
              </p:nvSpPr>
              <p:spPr>
                <a:xfrm flipV="1">
                  <a:off x="4127040" y="227916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9" name="Line 84"/>
                <p:cNvSpPr/>
                <p:nvPr/>
              </p:nvSpPr>
              <p:spPr>
                <a:xfrm flipV="1">
                  <a:off x="4215960" y="264276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0" name="Line 85"/>
                <p:cNvSpPr/>
                <p:nvPr/>
              </p:nvSpPr>
              <p:spPr>
                <a:xfrm flipV="1">
                  <a:off x="4215960" y="237636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1" name="Line 86"/>
                <p:cNvSpPr/>
                <p:nvPr/>
              </p:nvSpPr>
              <p:spPr>
                <a:xfrm flipV="1">
                  <a:off x="4249440" y="264276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2" name="Line 87"/>
                <p:cNvSpPr/>
                <p:nvPr/>
              </p:nvSpPr>
              <p:spPr>
                <a:xfrm flipV="1">
                  <a:off x="4284360" y="24318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3" name="Line 88"/>
                <p:cNvSpPr/>
                <p:nvPr/>
              </p:nvSpPr>
              <p:spPr>
                <a:xfrm flipV="1">
                  <a:off x="4295520" y="24318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4" name="Line 89"/>
                <p:cNvSpPr/>
                <p:nvPr/>
              </p:nvSpPr>
              <p:spPr>
                <a:xfrm flipV="1">
                  <a:off x="4306680" y="24318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5" name="Line 90"/>
                <p:cNvSpPr/>
                <p:nvPr/>
              </p:nvSpPr>
              <p:spPr>
                <a:xfrm flipV="1">
                  <a:off x="4319280" y="264276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6" name="Line 91"/>
                <p:cNvSpPr/>
                <p:nvPr/>
              </p:nvSpPr>
              <p:spPr>
                <a:xfrm flipV="1">
                  <a:off x="4319280" y="24318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7" name="Line 92"/>
                <p:cNvSpPr/>
                <p:nvPr/>
              </p:nvSpPr>
              <p:spPr>
                <a:xfrm flipV="1">
                  <a:off x="4341600" y="24318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8" name="Line 93"/>
                <p:cNvSpPr/>
                <p:nvPr/>
              </p:nvSpPr>
              <p:spPr>
                <a:xfrm flipV="1">
                  <a:off x="4352400" y="264276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9" name="Line 94"/>
                <p:cNvSpPr/>
                <p:nvPr/>
              </p:nvSpPr>
              <p:spPr>
                <a:xfrm flipV="1">
                  <a:off x="4352400" y="24318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0" name="Line 95"/>
                <p:cNvSpPr/>
                <p:nvPr/>
              </p:nvSpPr>
              <p:spPr>
                <a:xfrm flipV="1">
                  <a:off x="4387320" y="24318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1" name="Line 96"/>
                <p:cNvSpPr/>
                <p:nvPr/>
              </p:nvSpPr>
              <p:spPr>
                <a:xfrm flipV="1">
                  <a:off x="4398480" y="264276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2" name="Line 97"/>
                <p:cNvSpPr/>
                <p:nvPr/>
              </p:nvSpPr>
              <p:spPr>
                <a:xfrm flipV="1">
                  <a:off x="4454280" y="24318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3" name="Line 98"/>
                <p:cNvSpPr/>
                <p:nvPr/>
              </p:nvSpPr>
              <p:spPr>
                <a:xfrm flipV="1">
                  <a:off x="4476240" y="24318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4" name="Line 99"/>
                <p:cNvSpPr/>
                <p:nvPr/>
              </p:nvSpPr>
              <p:spPr>
                <a:xfrm flipV="1">
                  <a:off x="4492440" y="28094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5" name="Line 100"/>
                <p:cNvSpPr/>
                <p:nvPr/>
              </p:nvSpPr>
              <p:spPr>
                <a:xfrm flipV="1">
                  <a:off x="4487400" y="24318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6" name="Line 101"/>
                <p:cNvSpPr/>
                <p:nvPr/>
              </p:nvSpPr>
              <p:spPr>
                <a:xfrm flipV="1">
                  <a:off x="4511160" y="24318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7" name="Line 102"/>
                <p:cNvSpPr/>
                <p:nvPr/>
              </p:nvSpPr>
              <p:spPr>
                <a:xfrm flipV="1">
                  <a:off x="4527360" y="28094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8" name="Line 103"/>
                <p:cNvSpPr/>
                <p:nvPr/>
              </p:nvSpPr>
              <p:spPr>
                <a:xfrm flipV="1">
                  <a:off x="4533480" y="24318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9" name="Line 104"/>
                <p:cNvSpPr/>
                <p:nvPr/>
              </p:nvSpPr>
              <p:spPr>
                <a:xfrm flipV="1">
                  <a:off x="4760640" y="24318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0" name="Line 105"/>
                <p:cNvSpPr/>
                <p:nvPr/>
              </p:nvSpPr>
              <p:spPr>
                <a:xfrm flipV="1">
                  <a:off x="3184200" y="1088640"/>
                  <a:ext cx="1440" cy="234468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1" name="Line 106"/>
                <p:cNvSpPr/>
                <p:nvPr/>
              </p:nvSpPr>
              <p:spPr>
                <a:xfrm flipH="1">
                  <a:off x="3131640" y="3351240"/>
                  <a:ext cx="525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2" name="Rectangle 107"/>
                <p:cNvSpPr/>
                <p:nvPr/>
              </p:nvSpPr>
              <p:spPr>
                <a:xfrm rot="16200000">
                  <a:off x="2910240" y="327492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3" name="Line 108"/>
                <p:cNvSpPr/>
                <p:nvPr/>
              </p:nvSpPr>
              <p:spPr>
                <a:xfrm flipH="1">
                  <a:off x="3131640" y="2806560"/>
                  <a:ext cx="5256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4" name="Rectangle 109"/>
                <p:cNvSpPr/>
                <p:nvPr/>
              </p:nvSpPr>
              <p:spPr>
                <a:xfrm rot="16200000">
                  <a:off x="2910240" y="27288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2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5" name="Line 110"/>
                <p:cNvSpPr/>
                <p:nvPr/>
              </p:nvSpPr>
              <p:spPr>
                <a:xfrm flipH="1">
                  <a:off x="3131640" y="2260440"/>
                  <a:ext cx="5256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6" name="Rectangle 111"/>
                <p:cNvSpPr/>
                <p:nvPr/>
              </p:nvSpPr>
              <p:spPr>
                <a:xfrm rot="16200000">
                  <a:off x="2910240" y="21826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5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7" name="Line 112"/>
                <p:cNvSpPr/>
                <p:nvPr/>
              </p:nvSpPr>
              <p:spPr>
                <a:xfrm flipH="1">
                  <a:off x="3131640" y="1716120"/>
                  <a:ext cx="525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8" name="Rectangle 113"/>
                <p:cNvSpPr/>
                <p:nvPr/>
              </p:nvSpPr>
              <p:spPr>
                <a:xfrm rot="16200000">
                  <a:off x="2910240" y="16380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7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59" name="Line 114"/>
                <p:cNvSpPr/>
                <p:nvPr/>
              </p:nvSpPr>
              <p:spPr>
                <a:xfrm flipH="1">
                  <a:off x="3131640" y="1170000"/>
                  <a:ext cx="525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0" name="Rectangle 115"/>
                <p:cNvSpPr/>
                <p:nvPr/>
              </p:nvSpPr>
              <p:spPr>
                <a:xfrm rot="16200000">
                  <a:off x="2910240" y="10922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1" name="Line 116"/>
                <p:cNvSpPr/>
                <p:nvPr/>
              </p:nvSpPr>
              <p:spPr>
                <a:xfrm>
                  <a:off x="3184200" y="3433680"/>
                  <a:ext cx="165744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2" name="Line 117"/>
                <p:cNvSpPr/>
                <p:nvPr/>
              </p:nvSpPr>
              <p:spPr>
                <a:xfrm>
                  <a:off x="326520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3" name="Rectangle 118"/>
                <p:cNvSpPr/>
                <p:nvPr/>
              </p:nvSpPr>
              <p:spPr>
                <a:xfrm>
                  <a:off x="3229560" y="350820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4" name="Line 119"/>
                <p:cNvSpPr/>
                <p:nvPr/>
              </p:nvSpPr>
              <p:spPr>
                <a:xfrm>
                  <a:off x="353664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5" name="Rectangle 120"/>
                <p:cNvSpPr/>
                <p:nvPr/>
              </p:nvSpPr>
              <p:spPr>
                <a:xfrm>
                  <a:off x="346608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4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6" name="Line 121"/>
                <p:cNvSpPr/>
                <p:nvPr/>
              </p:nvSpPr>
              <p:spPr>
                <a:xfrm>
                  <a:off x="3809520" y="3433680"/>
                  <a:ext cx="180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7" name="Rectangle 122"/>
                <p:cNvSpPr/>
                <p:nvPr/>
              </p:nvSpPr>
              <p:spPr>
                <a:xfrm>
                  <a:off x="373896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48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8" name="Line 123"/>
                <p:cNvSpPr/>
                <p:nvPr/>
              </p:nvSpPr>
              <p:spPr>
                <a:xfrm>
                  <a:off x="4080960" y="3433680"/>
                  <a:ext cx="180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9" name="Rectangle 124"/>
                <p:cNvSpPr/>
                <p:nvPr/>
              </p:nvSpPr>
              <p:spPr>
                <a:xfrm>
                  <a:off x="401076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72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0" name="Line 125"/>
                <p:cNvSpPr/>
                <p:nvPr/>
              </p:nvSpPr>
              <p:spPr>
                <a:xfrm>
                  <a:off x="4352400" y="3433680"/>
                  <a:ext cx="180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1" name="Rectangle 126"/>
                <p:cNvSpPr/>
                <p:nvPr/>
              </p:nvSpPr>
              <p:spPr>
                <a:xfrm>
                  <a:off x="428220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6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2" name="Line 127"/>
                <p:cNvSpPr/>
                <p:nvPr/>
              </p:nvSpPr>
              <p:spPr>
                <a:xfrm>
                  <a:off x="462564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3" name="Rectangle 128"/>
                <p:cNvSpPr/>
                <p:nvPr/>
              </p:nvSpPr>
              <p:spPr>
                <a:xfrm>
                  <a:off x="4520160" y="3508200"/>
                  <a:ext cx="2109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4" name="Rectangle 129"/>
                <p:cNvSpPr/>
                <p:nvPr/>
              </p:nvSpPr>
              <p:spPr>
                <a:xfrm>
                  <a:off x="3228480" y="2873520"/>
                  <a:ext cx="1414440" cy="5126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5" name="Line 130"/>
                <p:cNvSpPr/>
                <p:nvPr/>
              </p:nvSpPr>
              <p:spPr>
                <a:xfrm>
                  <a:off x="3282480" y="2989440"/>
                  <a:ext cx="101880" cy="1440"/>
                </a:xfrm>
                <a:prstGeom prst="line">
                  <a:avLst/>
                </a:prstGeom>
                <a:ln w="30240">
                  <a:solidFill>
                    <a:srgbClr val="1a476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6" name="Line 131"/>
                <p:cNvSpPr/>
                <p:nvPr/>
              </p:nvSpPr>
              <p:spPr>
                <a:xfrm>
                  <a:off x="3282480" y="3271680"/>
                  <a:ext cx="101880" cy="1800"/>
                </a:xfrm>
                <a:prstGeom prst="line">
                  <a:avLst/>
                </a:prstGeom>
                <a:ln w="30240">
                  <a:solidFill>
                    <a:srgbClr val="90353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7" name="Rectangle 132"/>
                <p:cNvSpPr/>
                <p:nvPr/>
              </p:nvSpPr>
              <p:spPr>
                <a:xfrm>
                  <a:off x="3546360" y="2936880"/>
                  <a:ext cx="1024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ow FAK (E/N =37/66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8" name="Rectangle 133"/>
                <p:cNvSpPr/>
                <p:nvPr/>
              </p:nvSpPr>
              <p:spPr>
                <a:xfrm>
                  <a:off x="3548520" y="3219480"/>
                  <a:ext cx="10188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High FAK (E/N=44/63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79" name="Rectangle 134"/>
                <p:cNvSpPr/>
                <p:nvPr/>
              </p:nvSpPr>
              <p:spPr>
                <a:xfrm>
                  <a:off x="3234240" y="2612880"/>
                  <a:ext cx="44892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P=0.04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0" name="Rectangle 135"/>
                <p:cNvSpPr/>
                <p:nvPr/>
              </p:nvSpPr>
              <p:spPr>
                <a:xfrm>
                  <a:off x="3002040" y="923760"/>
                  <a:ext cx="179280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High LMW-E and  low full length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1" name="Rectangle 136"/>
                <p:cNvSpPr/>
                <p:nvPr/>
              </p:nvSpPr>
              <p:spPr>
                <a:xfrm>
                  <a:off x="4841640" y="917640"/>
                  <a:ext cx="1882800" cy="273996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2" name="Rectangle 137"/>
                <p:cNvSpPr/>
                <p:nvPr/>
              </p:nvSpPr>
              <p:spPr>
                <a:xfrm>
                  <a:off x="5068440" y="1089000"/>
                  <a:ext cx="1656000" cy="23414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3" name="Freeform 138"/>
                <p:cNvSpPr/>
                <p:nvPr/>
              </p:nvSpPr>
              <p:spPr>
                <a:xfrm>
                  <a:off x="5151240" y="1170000"/>
                  <a:ext cx="1334880" cy="1147680"/>
                </a:xfrm>
                <a:custGeom>
                  <a:avLst/>
                  <a:gdLst/>
                  <a:ahLst/>
                  <a:rect l="l" t="t" r="r" b="b"/>
                  <a:pathLst>
                    <a:path w="584" h="502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" y="0"/>
                      </a:lnTo>
                      <a:lnTo>
                        <a:pt x="5" y="64"/>
                      </a:lnTo>
                      <a:lnTo>
                        <a:pt x="120" y="64"/>
                      </a:lnTo>
                      <a:lnTo>
                        <a:pt x="120" y="127"/>
                      </a:lnTo>
                      <a:lnTo>
                        <a:pt x="136" y="127"/>
                      </a:lnTo>
                      <a:lnTo>
                        <a:pt x="136" y="191"/>
                      </a:lnTo>
                      <a:lnTo>
                        <a:pt x="201" y="191"/>
                      </a:lnTo>
                      <a:lnTo>
                        <a:pt x="272" y="191"/>
                      </a:lnTo>
                      <a:lnTo>
                        <a:pt x="278" y="191"/>
                      </a:lnTo>
                      <a:lnTo>
                        <a:pt x="321" y="191"/>
                      </a:lnTo>
                      <a:lnTo>
                        <a:pt x="321" y="276"/>
                      </a:lnTo>
                      <a:lnTo>
                        <a:pt x="327" y="276"/>
                      </a:lnTo>
                      <a:lnTo>
                        <a:pt x="359" y="276"/>
                      </a:lnTo>
                      <a:lnTo>
                        <a:pt x="381" y="276"/>
                      </a:lnTo>
                      <a:lnTo>
                        <a:pt x="387" y="276"/>
                      </a:lnTo>
                      <a:lnTo>
                        <a:pt x="398" y="276"/>
                      </a:lnTo>
                      <a:lnTo>
                        <a:pt x="441" y="276"/>
                      </a:lnTo>
                      <a:lnTo>
                        <a:pt x="441" y="502"/>
                      </a:lnTo>
                      <a:lnTo>
                        <a:pt x="539" y="502"/>
                      </a:lnTo>
                      <a:lnTo>
                        <a:pt x="541" y="502"/>
                      </a:lnTo>
                      <a:lnTo>
                        <a:pt x="583" y="502"/>
                      </a:lnTo>
                      <a:lnTo>
                        <a:pt x="584" y="502"/>
                      </a:lnTo>
                    </a:path>
                  </a:pathLst>
                </a:custGeom>
                <a:noFill/>
                <a:ln w="30240">
                  <a:solidFill>
                    <a:srgbClr val="1a476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4" name="Freeform 139"/>
                <p:cNvSpPr/>
                <p:nvPr/>
              </p:nvSpPr>
              <p:spPr>
                <a:xfrm>
                  <a:off x="5151240" y="1170000"/>
                  <a:ext cx="1382400" cy="647640"/>
                </a:xfrm>
                <a:custGeom>
                  <a:avLst/>
                  <a:gdLst/>
                  <a:ahLst/>
                  <a:rect l="l" t="t" r="r" b="b"/>
                  <a:pathLst>
                    <a:path w="605" h="283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6" y="0"/>
                      </a:lnTo>
                      <a:lnTo>
                        <a:pt x="16" y="53"/>
                      </a:lnTo>
                      <a:lnTo>
                        <a:pt x="27" y="53"/>
                      </a:lnTo>
                      <a:lnTo>
                        <a:pt x="27" y="106"/>
                      </a:lnTo>
                      <a:lnTo>
                        <a:pt x="87" y="106"/>
                      </a:lnTo>
                      <a:lnTo>
                        <a:pt x="87" y="159"/>
                      </a:lnTo>
                      <a:lnTo>
                        <a:pt x="88" y="159"/>
                      </a:lnTo>
                      <a:lnTo>
                        <a:pt x="130" y="159"/>
                      </a:lnTo>
                      <a:lnTo>
                        <a:pt x="130" y="216"/>
                      </a:lnTo>
                      <a:lnTo>
                        <a:pt x="289" y="216"/>
                      </a:lnTo>
                      <a:lnTo>
                        <a:pt x="290" y="216"/>
                      </a:lnTo>
                      <a:lnTo>
                        <a:pt x="316" y="216"/>
                      </a:lnTo>
                      <a:lnTo>
                        <a:pt x="317" y="216"/>
                      </a:lnTo>
                      <a:lnTo>
                        <a:pt x="327" y="216"/>
                      </a:lnTo>
                      <a:lnTo>
                        <a:pt x="327" y="283"/>
                      </a:lnTo>
                      <a:lnTo>
                        <a:pt x="381" y="283"/>
                      </a:lnTo>
                      <a:lnTo>
                        <a:pt x="398" y="283"/>
                      </a:lnTo>
                      <a:lnTo>
                        <a:pt x="419" y="283"/>
                      </a:lnTo>
                      <a:lnTo>
                        <a:pt x="518" y="283"/>
                      </a:lnTo>
                      <a:lnTo>
                        <a:pt x="523" y="283"/>
                      </a:lnTo>
                      <a:lnTo>
                        <a:pt x="545" y="283"/>
                      </a:lnTo>
                      <a:lnTo>
                        <a:pt x="589" y="283"/>
                      </a:lnTo>
                      <a:lnTo>
                        <a:pt x="599" y="283"/>
                      </a:lnTo>
                      <a:lnTo>
                        <a:pt x="605" y="283"/>
                      </a:lnTo>
                    </a:path>
                  </a:pathLst>
                </a:custGeom>
                <a:noFill/>
                <a:ln w="30240">
                  <a:solidFill>
                    <a:srgbClr val="90353b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5" name="Line 140"/>
                <p:cNvSpPr/>
                <p:nvPr/>
              </p:nvSpPr>
              <p:spPr>
                <a:xfrm flipV="1">
                  <a:off x="5352840" y="14904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6" name="Line 141"/>
                <p:cNvSpPr/>
                <p:nvPr/>
              </p:nvSpPr>
              <p:spPr>
                <a:xfrm flipV="1">
                  <a:off x="5609880" y="15634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7" name="Line 142"/>
                <p:cNvSpPr/>
                <p:nvPr/>
              </p:nvSpPr>
              <p:spPr>
                <a:xfrm flipV="1">
                  <a:off x="5771880" y="15634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8" name="Line 143"/>
                <p:cNvSpPr/>
                <p:nvPr/>
              </p:nvSpPr>
              <p:spPr>
                <a:xfrm flipV="1">
                  <a:off x="5785920" y="156348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89" name="Line 144"/>
                <p:cNvSpPr/>
                <p:nvPr/>
              </p:nvSpPr>
              <p:spPr>
                <a:xfrm flipV="1">
                  <a:off x="5812920" y="162036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0" name="Line 145"/>
                <p:cNvSpPr/>
                <p:nvPr/>
              </p:nvSpPr>
              <p:spPr>
                <a:xfrm flipV="1">
                  <a:off x="5874840" y="162036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1" name="Line 146"/>
                <p:cNvSpPr/>
                <p:nvPr/>
              </p:nvSpPr>
              <p:spPr>
                <a:xfrm flipV="1">
                  <a:off x="5898960" y="175716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2" name="Line 147"/>
                <p:cNvSpPr/>
                <p:nvPr/>
              </p:nvSpPr>
              <p:spPr>
                <a:xfrm flipV="1">
                  <a:off x="5973480" y="175716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3" name="Line 148"/>
                <p:cNvSpPr/>
                <p:nvPr/>
              </p:nvSpPr>
              <p:spPr>
                <a:xfrm flipV="1">
                  <a:off x="6021000" y="1773000"/>
                  <a:ext cx="144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4" name="Line 149"/>
                <p:cNvSpPr/>
                <p:nvPr/>
              </p:nvSpPr>
              <p:spPr>
                <a:xfrm flipV="1">
                  <a:off x="6021000" y="175716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5" name="Line 150"/>
                <p:cNvSpPr/>
                <p:nvPr/>
              </p:nvSpPr>
              <p:spPr>
                <a:xfrm flipV="1">
                  <a:off x="6035400" y="175716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6" name="Line 151"/>
                <p:cNvSpPr/>
                <p:nvPr/>
              </p:nvSpPr>
              <p:spPr>
                <a:xfrm flipV="1">
                  <a:off x="6060600" y="1773000"/>
                  <a:ext cx="180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7" name="Line 152"/>
                <p:cNvSpPr/>
                <p:nvPr/>
              </p:nvSpPr>
              <p:spPr>
                <a:xfrm flipV="1">
                  <a:off x="6060600" y="175716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8" name="Line 153"/>
                <p:cNvSpPr/>
                <p:nvPr/>
              </p:nvSpPr>
              <p:spPr>
                <a:xfrm flipV="1">
                  <a:off x="6108480" y="1773000"/>
                  <a:ext cx="144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99" name="Line 154"/>
                <p:cNvSpPr/>
                <p:nvPr/>
              </p:nvSpPr>
              <p:spPr>
                <a:xfrm flipV="1">
                  <a:off x="6335280" y="1773000"/>
                  <a:ext cx="180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0" name="Line 155"/>
                <p:cNvSpPr/>
                <p:nvPr/>
              </p:nvSpPr>
              <p:spPr>
                <a:xfrm flipV="1">
                  <a:off x="6346440" y="1773000"/>
                  <a:ext cx="144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1" name="Line 156"/>
                <p:cNvSpPr/>
                <p:nvPr/>
              </p:nvSpPr>
              <p:spPr>
                <a:xfrm flipV="1">
                  <a:off x="6387840" y="22744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2" name="Line 157"/>
                <p:cNvSpPr/>
                <p:nvPr/>
              </p:nvSpPr>
              <p:spPr>
                <a:xfrm flipV="1">
                  <a:off x="6397200" y="1773000"/>
                  <a:ext cx="180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3" name="Line 158"/>
                <p:cNvSpPr/>
                <p:nvPr/>
              </p:nvSpPr>
              <p:spPr>
                <a:xfrm flipV="1">
                  <a:off x="6486120" y="227448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4" name="Line 159"/>
                <p:cNvSpPr/>
                <p:nvPr/>
              </p:nvSpPr>
              <p:spPr>
                <a:xfrm flipV="1">
                  <a:off x="6497280" y="1773000"/>
                  <a:ext cx="144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5" name="Line 160"/>
                <p:cNvSpPr/>
                <p:nvPr/>
              </p:nvSpPr>
              <p:spPr>
                <a:xfrm flipV="1">
                  <a:off x="6519600" y="1773000"/>
                  <a:ext cx="144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6" name="Line 161"/>
                <p:cNvSpPr/>
                <p:nvPr/>
              </p:nvSpPr>
              <p:spPr>
                <a:xfrm flipV="1">
                  <a:off x="6533640" y="1773000"/>
                  <a:ext cx="180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7" name="Line 162"/>
                <p:cNvSpPr/>
                <p:nvPr/>
              </p:nvSpPr>
              <p:spPr>
                <a:xfrm flipV="1">
                  <a:off x="5068440" y="1088640"/>
                  <a:ext cx="1800" cy="234468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8" name="Line 163"/>
                <p:cNvSpPr/>
                <p:nvPr/>
              </p:nvSpPr>
              <p:spPr>
                <a:xfrm flipH="1">
                  <a:off x="5017320" y="3351240"/>
                  <a:ext cx="507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09" name="Rectangle 164"/>
                <p:cNvSpPr/>
                <p:nvPr/>
              </p:nvSpPr>
              <p:spPr>
                <a:xfrm rot="16200000">
                  <a:off x="4796280" y="327312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0" name="Line 165"/>
                <p:cNvSpPr/>
                <p:nvPr/>
              </p:nvSpPr>
              <p:spPr>
                <a:xfrm flipH="1">
                  <a:off x="5017320" y="2806560"/>
                  <a:ext cx="5076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1" name="Rectangle 166"/>
                <p:cNvSpPr/>
                <p:nvPr/>
              </p:nvSpPr>
              <p:spPr>
                <a:xfrm rot="16200000">
                  <a:off x="4796280" y="27288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2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2" name="Line 167"/>
                <p:cNvSpPr/>
                <p:nvPr/>
              </p:nvSpPr>
              <p:spPr>
                <a:xfrm flipH="1">
                  <a:off x="5017320" y="2260440"/>
                  <a:ext cx="5076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3" name="Rectangle 168"/>
                <p:cNvSpPr/>
                <p:nvPr/>
              </p:nvSpPr>
              <p:spPr>
                <a:xfrm rot="16200000">
                  <a:off x="4796280" y="21826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5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4" name="Line 169"/>
                <p:cNvSpPr/>
                <p:nvPr/>
              </p:nvSpPr>
              <p:spPr>
                <a:xfrm flipH="1">
                  <a:off x="5017320" y="1716120"/>
                  <a:ext cx="507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5" name="Rectangle 170"/>
                <p:cNvSpPr/>
                <p:nvPr/>
              </p:nvSpPr>
              <p:spPr>
                <a:xfrm rot="16200000">
                  <a:off x="4796280" y="16380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7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6" name="Line 171"/>
                <p:cNvSpPr/>
                <p:nvPr/>
              </p:nvSpPr>
              <p:spPr>
                <a:xfrm flipH="1">
                  <a:off x="5017320" y="1170000"/>
                  <a:ext cx="507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7" name="Rectangle 172"/>
                <p:cNvSpPr/>
                <p:nvPr/>
              </p:nvSpPr>
              <p:spPr>
                <a:xfrm rot="16200000">
                  <a:off x="4796280" y="10922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8" name="Line 173"/>
                <p:cNvSpPr/>
                <p:nvPr/>
              </p:nvSpPr>
              <p:spPr>
                <a:xfrm>
                  <a:off x="5068440" y="3433680"/>
                  <a:ext cx="165744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19" name="Line 174"/>
                <p:cNvSpPr/>
                <p:nvPr/>
              </p:nvSpPr>
              <p:spPr>
                <a:xfrm>
                  <a:off x="515124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0" name="Rectangle 175"/>
                <p:cNvSpPr/>
                <p:nvPr/>
              </p:nvSpPr>
              <p:spPr>
                <a:xfrm>
                  <a:off x="5115600" y="350820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1" name="Line 176"/>
                <p:cNvSpPr/>
                <p:nvPr/>
              </p:nvSpPr>
              <p:spPr>
                <a:xfrm>
                  <a:off x="5447880" y="3433680"/>
                  <a:ext cx="180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2" name="Rectangle 177"/>
                <p:cNvSpPr/>
                <p:nvPr/>
              </p:nvSpPr>
              <p:spPr>
                <a:xfrm>
                  <a:off x="537732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4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3" name="Line 178"/>
                <p:cNvSpPr/>
                <p:nvPr/>
              </p:nvSpPr>
              <p:spPr>
                <a:xfrm>
                  <a:off x="574812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4" name="Rectangle 179"/>
                <p:cNvSpPr/>
                <p:nvPr/>
              </p:nvSpPr>
              <p:spPr>
                <a:xfrm>
                  <a:off x="567756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48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5" name="Line 180"/>
                <p:cNvSpPr/>
                <p:nvPr/>
              </p:nvSpPr>
              <p:spPr>
                <a:xfrm>
                  <a:off x="604656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6" name="Rectangle 181"/>
                <p:cNvSpPr/>
                <p:nvPr/>
              </p:nvSpPr>
              <p:spPr>
                <a:xfrm>
                  <a:off x="597600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72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7" name="Line 182"/>
                <p:cNvSpPr/>
                <p:nvPr/>
              </p:nvSpPr>
              <p:spPr>
                <a:xfrm>
                  <a:off x="634644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8" name="Rectangle 183"/>
                <p:cNvSpPr/>
                <p:nvPr/>
              </p:nvSpPr>
              <p:spPr>
                <a:xfrm>
                  <a:off x="627588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6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29" name="Line 184"/>
                <p:cNvSpPr/>
                <p:nvPr/>
              </p:nvSpPr>
              <p:spPr>
                <a:xfrm>
                  <a:off x="664668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0" name="Rectangle 185"/>
                <p:cNvSpPr/>
                <p:nvPr/>
              </p:nvSpPr>
              <p:spPr>
                <a:xfrm>
                  <a:off x="6540840" y="3508200"/>
                  <a:ext cx="2109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1" name="Rectangle 186"/>
                <p:cNvSpPr/>
                <p:nvPr/>
              </p:nvSpPr>
              <p:spPr>
                <a:xfrm>
                  <a:off x="5114520" y="2873520"/>
                  <a:ext cx="1330200" cy="5126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2" name="Line 187"/>
                <p:cNvSpPr/>
                <p:nvPr/>
              </p:nvSpPr>
              <p:spPr>
                <a:xfrm>
                  <a:off x="5168520" y="2989440"/>
                  <a:ext cx="101520" cy="1440"/>
                </a:xfrm>
                <a:prstGeom prst="line">
                  <a:avLst/>
                </a:prstGeom>
                <a:ln w="30240">
                  <a:solidFill>
                    <a:srgbClr val="1a476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3" name="Line 188"/>
                <p:cNvSpPr/>
                <p:nvPr/>
              </p:nvSpPr>
              <p:spPr>
                <a:xfrm>
                  <a:off x="5168520" y="3271680"/>
                  <a:ext cx="101520" cy="1800"/>
                </a:xfrm>
                <a:prstGeom prst="line">
                  <a:avLst/>
                </a:prstGeom>
                <a:ln w="30240">
                  <a:solidFill>
                    <a:srgbClr val="90353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4" name="Rectangle 189"/>
                <p:cNvSpPr/>
                <p:nvPr/>
              </p:nvSpPr>
              <p:spPr>
                <a:xfrm>
                  <a:off x="5434920" y="2936880"/>
                  <a:ext cx="9518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ow BIM (E/N =5/15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5" name="Rectangle 190"/>
                <p:cNvSpPr/>
                <p:nvPr/>
              </p:nvSpPr>
              <p:spPr>
                <a:xfrm>
                  <a:off x="5435280" y="3219480"/>
                  <a:ext cx="9457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High BIM (E/N=5/18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6" name="Rectangle 191"/>
                <p:cNvSpPr/>
                <p:nvPr/>
              </p:nvSpPr>
              <p:spPr>
                <a:xfrm>
                  <a:off x="5090760" y="2624040"/>
                  <a:ext cx="37116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P=0.7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7" name="Rectangle 192"/>
                <p:cNvSpPr/>
                <p:nvPr/>
              </p:nvSpPr>
              <p:spPr>
                <a:xfrm>
                  <a:off x="4880880" y="923760"/>
                  <a:ext cx="18068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High LMW-E and high full length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8" name="Rectangle 193"/>
                <p:cNvSpPr/>
                <p:nvPr/>
              </p:nvSpPr>
              <p:spPr>
                <a:xfrm>
                  <a:off x="6725880" y="917640"/>
                  <a:ext cx="1884240" cy="273996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39" name="Rectangle 194"/>
                <p:cNvSpPr/>
                <p:nvPr/>
              </p:nvSpPr>
              <p:spPr>
                <a:xfrm>
                  <a:off x="6954480" y="1089000"/>
                  <a:ext cx="1655640" cy="23414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0" name="Freeform 195"/>
                <p:cNvSpPr/>
                <p:nvPr/>
              </p:nvSpPr>
              <p:spPr>
                <a:xfrm>
                  <a:off x="7033680" y="1170000"/>
                  <a:ext cx="1262160" cy="1652400"/>
                </a:xfrm>
                <a:custGeom>
                  <a:avLst/>
                  <a:gdLst/>
                  <a:ahLst/>
                  <a:rect l="l" t="t" r="r" b="b"/>
                  <a:pathLst>
                    <a:path w="552" h="723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" y="0"/>
                      </a:lnTo>
                      <a:lnTo>
                        <a:pt x="5" y="18"/>
                      </a:lnTo>
                      <a:lnTo>
                        <a:pt x="10" y="18"/>
                      </a:lnTo>
                      <a:lnTo>
                        <a:pt x="10" y="36"/>
                      </a:lnTo>
                      <a:lnTo>
                        <a:pt x="15" y="36"/>
                      </a:lnTo>
                      <a:lnTo>
                        <a:pt x="15" y="72"/>
                      </a:lnTo>
                      <a:lnTo>
                        <a:pt x="25" y="72"/>
                      </a:lnTo>
                      <a:lnTo>
                        <a:pt x="25" y="90"/>
                      </a:lnTo>
                      <a:lnTo>
                        <a:pt x="30" y="90"/>
                      </a:lnTo>
                      <a:lnTo>
                        <a:pt x="30" y="108"/>
                      </a:lnTo>
                      <a:lnTo>
                        <a:pt x="45" y="108"/>
                      </a:lnTo>
                      <a:lnTo>
                        <a:pt x="45" y="162"/>
                      </a:lnTo>
                      <a:lnTo>
                        <a:pt x="60" y="162"/>
                      </a:lnTo>
                      <a:lnTo>
                        <a:pt x="60" y="180"/>
                      </a:lnTo>
                      <a:lnTo>
                        <a:pt x="75" y="180"/>
                      </a:lnTo>
                      <a:lnTo>
                        <a:pt x="75" y="216"/>
                      </a:lnTo>
                      <a:lnTo>
                        <a:pt x="80" y="216"/>
                      </a:lnTo>
                      <a:lnTo>
                        <a:pt x="80" y="234"/>
                      </a:lnTo>
                      <a:lnTo>
                        <a:pt x="85" y="234"/>
                      </a:lnTo>
                      <a:lnTo>
                        <a:pt x="85" y="252"/>
                      </a:lnTo>
                      <a:lnTo>
                        <a:pt x="94" y="252"/>
                      </a:lnTo>
                      <a:lnTo>
                        <a:pt x="94" y="270"/>
                      </a:lnTo>
                      <a:lnTo>
                        <a:pt x="99" y="270"/>
                      </a:lnTo>
                      <a:lnTo>
                        <a:pt x="99" y="306"/>
                      </a:lnTo>
                      <a:lnTo>
                        <a:pt x="104" y="306"/>
                      </a:lnTo>
                      <a:lnTo>
                        <a:pt x="104" y="342"/>
                      </a:lnTo>
                      <a:lnTo>
                        <a:pt x="109" y="342"/>
                      </a:lnTo>
                      <a:lnTo>
                        <a:pt x="109" y="360"/>
                      </a:lnTo>
                      <a:lnTo>
                        <a:pt x="114" y="360"/>
                      </a:lnTo>
                      <a:lnTo>
                        <a:pt x="114" y="396"/>
                      </a:lnTo>
                      <a:lnTo>
                        <a:pt x="119" y="396"/>
                      </a:lnTo>
                      <a:lnTo>
                        <a:pt x="119" y="450"/>
                      </a:lnTo>
                      <a:lnTo>
                        <a:pt x="124" y="450"/>
                      </a:lnTo>
                      <a:lnTo>
                        <a:pt x="124" y="468"/>
                      </a:lnTo>
                      <a:lnTo>
                        <a:pt x="129" y="468"/>
                      </a:lnTo>
                      <a:lnTo>
                        <a:pt x="129" y="522"/>
                      </a:lnTo>
                      <a:lnTo>
                        <a:pt x="144" y="522"/>
                      </a:lnTo>
                      <a:lnTo>
                        <a:pt x="144" y="540"/>
                      </a:lnTo>
                      <a:lnTo>
                        <a:pt x="154" y="540"/>
                      </a:lnTo>
                      <a:lnTo>
                        <a:pt x="154" y="558"/>
                      </a:lnTo>
                      <a:lnTo>
                        <a:pt x="169" y="558"/>
                      </a:lnTo>
                      <a:lnTo>
                        <a:pt x="169" y="576"/>
                      </a:lnTo>
                      <a:lnTo>
                        <a:pt x="189" y="576"/>
                      </a:lnTo>
                      <a:lnTo>
                        <a:pt x="189" y="594"/>
                      </a:lnTo>
                      <a:lnTo>
                        <a:pt x="194" y="594"/>
                      </a:lnTo>
                      <a:lnTo>
                        <a:pt x="194" y="612"/>
                      </a:lnTo>
                      <a:lnTo>
                        <a:pt x="213" y="612"/>
                      </a:lnTo>
                      <a:lnTo>
                        <a:pt x="213" y="630"/>
                      </a:lnTo>
                      <a:lnTo>
                        <a:pt x="238" y="630"/>
                      </a:lnTo>
                      <a:lnTo>
                        <a:pt x="238" y="648"/>
                      </a:lnTo>
                      <a:lnTo>
                        <a:pt x="243" y="648"/>
                      </a:lnTo>
                      <a:lnTo>
                        <a:pt x="243" y="666"/>
                      </a:lnTo>
                      <a:lnTo>
                        <a:pt x="248" y="666"/>
                      </a:lnTo>
                      <a:lnTo>
                        <a:pt x="248" y="684"/>
                      </a:lnTo>
                      <a:lnTo>
                        <a:pt x="253" y="684"/>
                      </a:lnTo>
                      <a:lnTo>
                        <a:pt x="253" y="702"/>
                      </a:lnTo>
                      <a:lnTo>
                        <a:pt x="263" y="702"/>
                      </a:lnTo>
                      <a:lnTo>
                        <a:pt x="278" y="702"/>
                      </a:lnTo>
                      <a:lnTo>
                        <a:pt x="308" y="702"/>
                      </a:lnTo>
                      <a:lnTo>
                        <a:pt x="308" y="723"/>
                      </a:lnTo>
                      <a:lnTo>
                        <a:pt x="313" y="723"/>
                      </a:lnTo>
                      <a:lnTo>
                        <a:pt x="314" y="723"/>
                      </a:lnTo>
                      <a:lnTo>
                        <a:pt x="322" y="723"/>
                      </a:lnTo>
                      <a:lnTo>
                        <a:pt x="324" y="723"/>
                      </a:lnTo>
                      <a:lnTo>
                        <a:pt x="352" y="723"/>
                      </a:lnTo>
                      <a:lnTo>
                        <a:pt x="354" y="723"/>
                      </a:lnTo>
                      <a:lnTo>
                        <a:pt x="417" y="723"/>
                      </a:lnTo>
                      <a:lnTo>
                        <a:pt x="418" y="723"/>
                      </a:lnTo>
                      <a:lnTo>
                        <a:pt x="432" y="723"/>
                      </a:lnTo>
                      <a:lnTo>
                        <a:pt x="433" y="723"/>
                      </a:lnTo>
                      <a:lnTo>
                        <a:pt x="461" y="723"/>
                      </a:lnTo>
                      <a:lnTo>
                        <a:pt x="463" y="723"/>
                      </a:lnTo>
                      <a:lnTo>
                        <a:pt x="476" y="723"/>
                      </a:lnTo>
                      <a:lnTo>
                        <a:pt x="478" y="723"/>
                      </a:lnTo>
                      <a:lnTo>
                        <a:pt x="491" y="723"/>
                      </a:lnTo>
                      <a:lnTo>
                        <a:pt x="492" y="723"/>
                      </a:lnTo>
                      <a:lnTo>
                        <a:pt x="521" y="723"/>
                      </a:lnTo>
                      <a:lnTo>
                        <a:pt x="522" y="723"/>
                      </a:lnTo>
                      <a:lnTo>
                        <a:pt x="536" y="723"/>
                      </a:lnTo>
                      <a:lnTo>
                        <a:pt x="537" y="723"/>
                      </a:lnTo>
                      <a:lnTo>
                        <a:pt x="551" y="723"/>
                      </a:lnTo>
                      <a:lnTo>
                        <a:pt x="552" y="723"/>
                      </a:lnTo>
                    </a:path>
                  </a:pathLst>
                </a:custGeom>
                <a:noFill/>
                <a:ln w="30240">
                  <a:solidFill>
                    <a:srgbClr val="1a476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1" name="Freeform 196"/>
                <p:cNvSpPr/>
                <p:nvPr/>
              </p:nvSpPr>
              <p:spPr>
                <a:xfrm>
                  <a:off x="7033680" y="1170000"/>
                  <a:ext cx="1498680" cy="1376280"/>
                </a:xfrm>
                <a:custGeom>
                  <a:avLst/>
                  <a:gdLst/>
                  <a:ahLst/>
                  <a:rect l="l" t="t" r="r" b="b"/>
                  <a:pathLst>
                    <a:path w="655" h="602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35" y="0"/>
                      </a:lnTo>
                      <a:lnTo>
                        <a:pt x="35" y="13"/>
                      </a:lnTo>
                      <a:lnTo>
                        <a:pt x="45" y="13"/>
                      </a:lnTo>
                      <a:lnTo>
                        <a:pt x="45" y="25"/>
                      </a:lnTo>
                      <a:lnTo>
                        <a:pt x="50" y="25"/>
                      </a:lnTo>
                      <a:lnTo>
                        <a:pt x="50" y="38"/>
                      </a:lnTo>
                      <a:lnTo>
                        <a:pt x="55" y="38"/>
                      </a:lnTo>
                      <a:lnTo>
                        <a:pt x="55" y="50"/>
                      </a:lnTo>
                      <a:lnTo>
                        <a:pt x="60" y="50"/>
                      </a:lnTo>
                      <a:lnTo>
                        <a:pt x="60" y="75"/>
                      </a:lnTo>
                      <a:lnTo>
                        <a:pt x="65" y="75"/>
                      </a:lnTo>
                      <a:lnTo>
                        <a:pt x="65" y="88"/>
                      </a:lnTo>
                      <a:lnTo>
                        <a:pt x="70" y="88"/>
                      </a:lnTo>
                      <a:lnTo>
                        <a:pt x="70" y="126"/>
                      </a:lnTo>
                      <a:lnTo>
                        <a:pt x="75" y="126"/>
                      </a:lnTo>
                      <a:lnTo>
                        <a:pt x="75" y="138"/>
                      </a:lnTo>
                      <a:lnTo>
                        <a:pt x="80" y="138"/>
                      </a:lnTo>
                      <a:lnTo>
                        <a:pt x="80" y="151"/>
                      </a:lnTo>
                      <a:lnTo>
                        <a:pt x="85" y="151"/>
                      </a:lnTo>
                      <a:lnTo>
                        <a:pt x="85" y="163"/>
                      </a:lnTo>
                      <a:lnTo>
                        <a:pt x="89" y="163"/>
                      </a:lnTo>
                      <a:lnTo>
                        <a:pt x="89" y="176"/>
                      </a:lnTo>
                      <a:lnTo>
                        <a:pt x="94" y="176"/>
                      </a:lnTo>
                      <a:lnTo>
                        <a:pt x="94" y="201"/>
                      </a:lnTo>
                      <a:lnTo>
                        <a:pt x="99" y="201"/>
                      </a:lnTo>
                      <a:lnTo>
                        <a:pt x="99" y="213"/>
                      </a:lnTo>
                      <a:lnTo>
                        <a:pt x="109" y="213"/>
                      </a:lnTo>
                      <a:lnTo>
                        <a:pt x="109" y="226"/>
                      </a:lnTo>
                      <a:lnTo>
                        <a:pt x="114" y="226"/>
                      </a:lnTo>
                      <a:lnTo>
                        <a:pt x="114" y="239"/>
                      </a:lnTo>
                      <a:lnTo>
                        <a:pt x="119" y="239"/>
                      </a:lnTo>
                      <a:lnTo>
                        <a:pt x="119" y="251"/>
                      </a:lnTo>
                      <a:lnTo>
                        <a:pt x="129" y="251"/>
                      </a:lnTo>
                      <a:lnTo>
                        <a:pt x="129" y="264"/>
                      </a:lnTo>
                      <a:lnTo>
                        <a:pt x="154" y="264"/>
                      </a:lnTo>
                      <a:lnTo>
                        <a:pt x="154" y="301"/>
                      </a:lnTo>
                      <a:lnTo>
                        <a:pt x="164" y="301"/>
                      </a:lnTo>
                      <a:lnTo>
                        <a:pt x="164" y="314"/>
                      </a:lnTo>
                      <a:lnTo>
                        <a:pt x="174" y="314"/>
                      </a:lnTo>
                      <a:lnTo>
                        <a:pt x="174" y="326"/>
                      </a:lnTo>
                      <a:lnTo>
                        <a:pt x="179" y="326"/>
                      </a:lnTo>
                      <a:lnTo>
                        <a:pt x="179" y="339"/>
                      </a:lnTo>
                      <a:lnTo>
                        <a:pt x="189" y="339"/>
                      </a:lnTo>
                      <a:lnTo>
                        <a:pt x="189" y="352"/>
                      </a:lnTo>
                      <a:lnTo>
                        <a:pt x="194" y="352"/>
                      </a:lnTo>
                      <a:lnTo>
                        <a:pt x="194" y="365"/>
                      </a:lnTo>
                      <a:lnTo>
                        <a:pt x="199" y="365"/>
                      </a:lnTo>
                      <a:lnTo>
                        <a:pt x="200" y="365"/>
                      </a:lnTo>
                      <a:lnTo>
                        <a:pt x="223" y="365"/>
                      </a:lnTo>
                      <a:lnTo>
                        <a:pt x="223" y="378"/>
                      </a:lnTo>
                      <a:lnTo>
                        <a:pt x="233" y="378"/>
                      </a:lnTo>
                      <a:lnTo>
                        <a:pt x="233" y="391"/>
                      </a:lnTo>
                      <a:lnTo>
                        <a:pt x="238" y="391"/>
                      </a:lnTo>
                      <a:lnTo>
                        <a:pt x="238" y="430"/>
                      </a:lnTo>
                      <a:lnTo>
                        <a:pt x="243" y="430"/>
                      </a:lnTo>
                      <a:lnTo>
                        <a:pt x="243" y="443"/>
                      </a:lnTo>
                      <a:lnTo>
                        <a:pt x="248" y="443"/>
                      </a:lnTo>
                      <a:lnTo>
                        <a:pt x="253" y="443"/>
                      </a:lnTo>
                      <a:lnTo>
                        <a:pt x="263" y="443"/>
                      </a:lnTo>
                      <a:lnTo>
                        <a:pt x="283" y="443"/>
                      </a:lnTo>
                      <a:lnTo>
                        <a:pt x="298" y="443"/>
                      </a:lnTo>
                      <a:lnTo>
                        <a:pt x="298" y="459"/>
                      </a:lnTo>
                      <a:lnTo>
                        <a:pt x="322" y="459"/>
                      </a:lnTo>
                      <a:lnTo>
                        <a:pt x="327" y="459"/>
                      </a:lnTo>
                      <a:lnTo>
                        <a:pt x="352" y="459"/>
                      </a:lnTo>
                      <a:lnTo>
                        <a:pt x="357" y="459"/>
                      </a:lnTo>
                      <a:lnTo>
                        <a:pt x="367" y="459"/>
                      </a:lnTo>
                      <a:lnTo>
                        <a:pt x="367" y="478"/>
                      </a:lnTo>
                      <a:lnTo>
                        <a:pt x="372" y="478"/>
                      </a:lnTo>
                      <a:lnTo>
                        <a:pt x="374" y="478"/>
                      </a:lnTo>
                      <a:lnTo>
                        <a:pt x="377" y="478"/>
                      </a:lnTo>
                      <a:lnTo>
                        <a:pt x="378" y="478"/>
                      </a:lnTo>
                      <a:lnTo>
                        <a:pt x="412" y="478"/>
                      </a:lnTo>
                      <a:lnTo>
                        <a:pt x="412" y="499"/>
                      </a:lnTo>
                      <a:lnTo>
                        <a:pt x="417" y="499"/>
                      </a:lnTo>
                      <a:lnTo>
                        <a:pt x="417" y="519"/>
                      </a:lnTo>
                      <a:lnTo>
                        <a:pt x="432" y="519"/>
                      </a:lnTo>
                      <a:lnTo>
                        <a:pt x="441" y="519"/>
                      </a:lnTo>
                      <a:lnTo>
                        <a:pt x="441" y="543"/>
                      </a:lnTo>
                      <a:lnTo>
                        <a:pt x="446" y="543"/>
                      </a:lnTo>
                      <a:lnTo>
                        <a:pt x="451" y="543"/>
                      </a:lnTo>
                      <a:lnTo>
                        <a:pt x="456" y="543"/>
                      </a:lnTo>
                      <a:lnTo>
                        <a:pt x="461" y="543"/>
                      </a:lnTo>
                      <a:lnTo>
                        <a:pt x="471" y="543"/>
                      </a:lnTo>
                      <a:lnTo>
                        <a:pt x="476" y="543"/>
                      </a:lnTo>
                      <a:lnTo>
                        <a:pt x="496" y="543"/>
                      </a:lnTo>
                      <a:lnTo>
                        <a:pt x="531" y="543"/>
                      </a:lnTo>
                      <a:lnTo>
                        <a:pt x="536" y="543"/>
                      </a:lnTo>
                      <a:lnTo>
                        <a:pt x="536" y="602"/>
                      </a:lnTo>
                      <a:lnTo>
                        <a:pt x="546" y="602"/>
                      </a:lnTo>
                      <a:lnTo>
                        <a:pt x="555" y="602"/>
                      </a:lnTo>
                      <a:lnTo>
                        <a:pt x="655" y="602"/>
                      </a:lnTo>
                    </a:path>
                  </a:pathLst>
                </a:custGeom>
                <a:noFill/>
                <a:ln w="30240">
                  <a:solidFill>
                    <a:srgbClr val="90353b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2" name="Line 197"/>
                <p:cNvSpPr/>
                <p:nvPr/>
              </p:nvSpPr>
              <p:spPr>
                <a:xfrm flipV="1">
                  <a:off x="7443360" y="190152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3" name="Line 198"/>
                <p:cNvSpPr/>
                <p:nvPr/>
              </p:nvSpPr>
              <p:spPr>
                <a:xfrm flipV="1">
                  <a:off x="7490880" y="1960200"/>
                  <a:ext cx="1800" cy="44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" bIns="-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4" name="Line 199"/>
                <p:cNvSpPr/>
                <p:nvPr/>
              </p:nvSpPr>
              <p:spPr>
                <a:xfrm flipV="1">
                  <a:off x="7602120" y="213948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5" name="Line 200"/>
                <p:cNvSpPr/>
                <p:nvPr/>
              </p:nvSpPr>
              <p:spPr>
                <a:xfrm flipV="1">
                  <a:off x="7613280" y="21394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6" name="Line 201"/>
                <p:cNvSpPr/>
                <p:nvPr/>
              </p:nvSpPr>
              <p:spPr>
                <a:xfrm flipV="1">
                  <a:off x="7635600" y="27316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7" name="Line 202"/>
                <p:cNvSpPr/>
                <p:nvPr/>
              </p:nvSpPr>
              <p:spPr>
                <a:xfrm flipV="1">
                  <a:off x="7635600" y="21394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8" name="Line 203"/>
                <p:cNvSpPr/>
                <p:nvPr/>
              </p:nvSpPr>
              <p:spPr>
                <a:xfrm flipV="1">
                  <a:off x="7670520" y="27316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49" name="Line 204"/>
                <p:cNvSpPr/>
                <p:nvPr/>
              </p:nvSpPr>
              <p:spPr>
                <a:xfrm flipV="1">
                  <a:off x="7681680" y="21394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50" name="Group 406"/>
              <p:cNvGrpSpPr/>
              <p:nvPr/>
            </p:nvGrpSpPr>
            <p:grpSpPr>
              <a:xfrm>
                <a:off x="1069560" y="923760"/>
                <a:ext cx="7542360" cy="5480280"/>
                <a:chOff x="1069560" y="923760"/>
                <a:chExt cx="7542360" cy="5480280"/>
              </a:xfrm>
            </p:grpSpPr>
            <p:sp>
              <p:nvSpPr>
                <p:cNvPr id="251" name="Line 206"/>
                <p:cNvSpPr/>
                <p:nvPr/>
              </p:nvSpPr>
              <p:spPr>
                <a:xfrm flipV="1">
                  <a:off x="7716600" y="21762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2" name="Line 207"/>
                <p:cNvSpPr/>
                <p:nvPr/>
              </p:nvSpPr>
              <p:spPr>
                <a:xfrm flipV="1">
                  <a:off x="7752960" y="27792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3" name="Line 208"/>
                <p:cNvSpPr/>
                <p:nvPr/>
              </p:nvSpPr>
              <p:spPr>
                <a:xfrm flipV="1">
                  <a:off x="7775280" y="27792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4" name="Line 209"/>
                <p:cNvSpPr/>
                <p:nvPr/>
              </p:nvSpPr>
              <p:spPr>
                <a:xfrm flipV="1">
                  <a:off x="7773480" y="21762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5" name="Line 210"/>
                <p:cNvSpPr/>
                <p:nvPr/>
              </p:nvSpPr>
              <p:spPr>
                <a:xfrm flipV="1">
                  <a:off x="7784640" y="21762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6" name="Line 211"/>
                <p:cNvSpPr/>
                <p:nvPr/>
              </p:nvSpPr>
              <p:spPr>
                <a:xfrm flipV="1">
                  <a:off x="7843320" y="27792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7" name="Line 212"/>
                <p:cNvSpPr/>
                <p:nvPr/>
              </p:nvSpPr>
              <p:spPr>
                <a:xfrm flipV="1">
                  <a:off x="7838640" y="21762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8" name="Line 213"/>
                <p:cNvSpPr/>
                <p:nvPr/>
              </p:nvSpPr>
              <p:spPr>
                <a:xfrm flipV="1">
                  <a:off x="7849800" y="21762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59" name="Line 214"/>
                <p:cNvSpPr/>
                <p:nvPr/>
              </p:nvSpPr>
              <p:spPr>
                <a:xfrm flipV="1">
                  <a:off x="7889400" y="221904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0" name="Line 215"/>
                <p:cNvSpPr/>
                <p:nvPr/>
              </p:nvSpPr>
              <p:spPr>
                <a:xfrm flipV="1">
                  <a:off x="7900560" y="221904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1" name="Line 216"/>
                <p:cNvSpPr/>
                <p:nvPr/>
              </p:nvSpPr>
              <p:spPr>
                <a:xfrm flipV="1">
                  <a:off x="7989480" y="27792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2" name="Line 217"/>
                <p:cNvSpPr/>
                <p:nvPr/>
              </p:nvSpPr>
              <p:spPr>
                <a:xfrm flipV="1">
                  <a:off x="7988040" y="231264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3" name="Line 218"/>
                <p:cNvSpPr/>
                <p:nvPr/>
              </p:nvSpPr>
              <p:spPr>
                <a:xfrm flipV="1">
                  <a:off x="8024400" y="27792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4" name="Line 219"/>
                <p:cNvSpPr/>
                <p:nvPr/>
              </p:nvSpPr>
              <p:spPr>
                <a:xfrm flipV="1">
                  <a:off x="8021160" y="231264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5" name="Line 220"/>
                <p:cNvSpPr/>
                <p:nvPr/>
              </p:nvSpPr>
              <p:spPr>
                <a:xfrm flipV="1">
                  <a:off x="8054640" y="2368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6" name="Line 221"/>
                <p:cNvSpPr/>
                <p:nvPr/>
              </p:nvSpPr>
              <p:spPr>
                <a:xfrm flipV="1">
                  <a:off x="8065800" y="2368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7" name="Line 222"/>
                <p:cNvSpPr/>
                <p:nvPr/>
              </p:nvSpPr>
              <p:spPr>
                <a:xfrm flipV="1">
                  <a:off x="8076960" y="2368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8" name="Line 223"/>
                <p:cNvSpPr/>
                <p:nvPr/>
              </p:nvSpPr>
              <p:spPr>
                <a:xfrm flipV="1">
                  <a:off x="8092800" y="27792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69" name="Line 224"/>
                <p:cNvSpPr/>
                <p:nvPr/>
              </p:nvSpPr>
              <p:spPr>
                <a:xfrm flipV="1">
                  <a:off x="8088120" y="2368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0" name="Line 225"/>
                <p:cNvSpPr/>
                <p:nvPr/>
              </p:nvSpPr>
              <p:spPr>
                <a:xfrm flipV="1">
                  <a:off x="8111880" y="2368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1" name="Line 226"/>
                <p:cNvSpPr/>
                <p:nvPr/>
              </p:nvSpPr>
              <p:spPr>
                <a:xfrm flipV="1">
                  <a:off x="8127720" y="27792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2" name="Line 227"/>
                <p:cNvSpPr/>
                <p:nvPr/>
              </p:nvSpPr>
              <p:spPr>
                <a:xfrm flipV="1">
                  <a:off x="8123040" y="2368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3" name="Line 228"/>
                <p:cNvSpPr/>
                <p:nvPr/>
              </p:nvSpPr>
              <p:spPr>
                <a:xfrm flipV="1">
                  <a:off x="8160840" y="27792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4" name="Line 229"/>
                <p:cNvSpPr/>
                <p:nvPr/>
              </p:nvSpPr>
              <p:spPr>
                <a:xfrm flipV="1">
                  <a:off x="8168760" y="236808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5" name="Line 230"/>
                <p:cNvSpPr/>
                <p:nvPr/>
              </p:nvSpPr>
              <p:spPr>
                <a:xfrm flipV="1">
                  <a:off x="8227800" y="27792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6" name="Line 231"/>
                <p:cNvSpPr/>
                <p:nvPr/>
              </p:nvSpPr>
              <p:spPr>
                <a:xfrm flipV="1">
                  <a:off x="8248320" y="2368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7" name="Line 232"/>
                <p:cNvSpPr/>
                <p:nvPr/>
              </p:nvSpPr>
              <p:spPr>
                <a:xfrm flipV="1">
                  <a:off x="8262720" y="277920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8" name="Line 233"/>
                <p:cNvSpPr/>
                <p:nvPr/>
              </p:nvSpPr>
              <p:spPr>
                <a:xfrm flipV="1">
                  <a:off x="8259480" y="2503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79" name="Line 234"/>
                <p:cNvSpPr/>
                <p:nvPr/>
              </p:nvSpPr>
              <p:spPr>
                <a:xfrm flipV="1">
                  <a:off x="8283240" y="2503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0" name="Line 235"/>
                <p:cNvSpPr/>
                <p:nvPr/>
              </p:nvSpPr>
              <p:spPr>
                <a:xfrm flipV="1">
                  <a:off x="8295840" y="277920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1" name="Line 236"/>
                <p:cNvSpPr/>
                <p:nvPr/>
              </p:nvSpPr>
              <p:spPr>
                <a:xfrm flipV="1">
                  <a:off x="8305560" y="2503080"/>
                  <a:ext cx="144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2" name="Line 237"/>
                <p:cNvSpPr/>
                <p:nvPr/>
              </p:nvSpPr>
              <p:spPr>
                <a:xfrm flipV="1">
                  <a:off x="8532360" y="2503080"/>
                  <a:ext cx="1800" cy="42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3" name="Line 238"/>
                <p:cNvSpPr/>
                <p:nvPr/>
              </p:nvSpPr>
              <p:spPr>
                <a:xfrm flipV="1">
                  <a:off x="6954480" y="1088640"/>
                  <a:ext cx="1440" cy="234468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4" name="Line 239"/>
                <p:cNvSpPr/>
                <p:nvPr/>
              </p:nvSpPr>
              <p:spPr>
                <a:xfrm flipH="1">
                  <a:off x="6903360" y="3351240"/>
                  <a:ext cx="507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5" name="Rectangle 240"/>
                <p:cNvSpPr/>
                <p:nvPr/>
              </p:nvSpPr>
              <p:spPr>
                <a:xfrm rot="16200000">
                  <a:off x="6682320" y="327312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6" name="Line 241"/>
                <p:cNvSpPr/>
                <p:nvPr/>
              </p:nvSpPr>
              <p:spPr>
                <a:xfrm flipH="1">
                  <a:off x="6903360" y="2806560"/>
                  <a:ext cx="5076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7" name="Rectangle 242"/>
                <p:cNvSpPr/>
                <p:nvPr/>
              </p:nvSpPr>
              <p:spPr>
                <a:xfrm rot="16200000">
                  <a:off x="6682320" y="27288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2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8" name="Line 243"/>
                <p:cNvSpPr/>
                <p:nvPr/>
              </p:nvSpPr>
              <p:spPr>
                <a:xfrm flipH="1">
                  <a:off x="6903360" y="2260440"/>
                  <a:ext cx="5076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89" name="Rectangle 244"/>
                <p:cNvSpPr/>
                <p:nvPr/>
              </p:nvSpPr>
              <p:spPr>
                <a:xfrm rot="16200000">
                  <a:off x="6682320" y="21826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5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0" name="Line 245"/>
                <p:cNvSpPr/>
                <p:nvPr/>
              </p:nvSpPr>
              <p:spPr>
                <a:xfrm flipH="1">
                  <a:off x="6903360" y="1716120"/>
                  <a:ext cx="507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1" name="Rectangle 246"/>
                <p:cNvSpPr/>
                <p:nvPr/>
              </p:nvSpPr>
              <p:spPr>
                <a:xfrm rot="16200000">
                  <a:off x="6682320" y="16380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7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2" name="Line 247"/>
                <p:cNvSpPr/>
                <p:nvPr/>
              </p:nvSpPr>
              <p:spPr>
                <a:xfrm flipH="1">
                  <a:off x="6903360" y="1170000"/>
                  <a:ext cx="507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3" name="Rectangle 248"/>
                <p:cNvSpPr/>
                <p:nvPr/>
              </p:nvSpPr>
              <p:spPr>
                <a:xfrm rot="16200000">
                  <a:off x="6682320" y="10922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4" name="Line 249"/>
                <p:cNvSpPr/>
                <p:nvPr/>
              </p:nvSpPr>
              <p:spPr>
                <a:xfrm>
                  <a:off x="6954480" y="3433680"/>
                  <a:ext cx="165744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5" name="Line 250"/>
                <p:cNvSpPr/>
                <p:nvPr/>
              </p:nvSpPr>
              <p:spPr>
                <a:xfrm>
                  <a:off x="7033680" y="3433680"/>
                  <a:ext cx="180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6" name="Rectangle 251"/>
                <p:cNvSpPr/>
                <p:nvPr/>
              </p:nvSpPr>
              <p:spPr>
                <a:xfrm>
                  <a:off x="6998400" y="350820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7" name="Line 252"/>
                <p:cNvSpPr/>
                <p:nvPr/>
              </p:nvSpPr>
              <p:spPr>
                <a:xfrm>
                  <a:off x="730692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8" name="Rectangle 253"/>
                <p:cNvSpPr/>
                <p:nvPr/>
              </p:nvSpPr>
              <p:spPr>
                <a:xfrm>
                  <a:off x="723636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4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299" name="Line 254"/>
                <p:cNvSpPr/>
                <p:nvPr/>
              </p:nvSpPr>
              <p:spPr>
                <a:xfrm>
                  <a:off x="757836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0" name="Rectangle 255"/>
                <p:cNvSpPr/>
                <p:nvPr/>
              </p:nvSpPr>
              <p:spPr>
                <a:xfrm>
                  <a:off x="750780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48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1" name="Line 256"/>
                <p:cNvSpPr/>
                <p:nvPr/>
              </p:nvSpPr>
              <p:spPr>
                <a:xfrm>
                  <a:off x="784980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2" name="Rectangle 257"/>
                <p:cNvSpPr/>
                <p:nvPr/>
              </p:nvSpPr>
              <p:spPr>
                <a:xfrm>
                  <a:off x="777924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72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3" name="Line 258"/>
                <p:cNvSpPr/>
                <p:nvPr/>
              </p:nvSpPr>
              <p:spPr>
                <a:xfrm>
                  <a:off x="812304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4" name="Rectangle 259"/>
                <p:cNvSpPr/>
                <p:nvPr/>
              </p:nvSpPr>
              <p:spPr>
                <a:xfrm>
                  <a:off x="8052480" y="35082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6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5" name="Line 260"/>
                <p:cNvSpPr/>
                <p:nvPr/>
              </p:nvSpPr>
              <p:spPr>
                <a:xfrm>
                  <a:off x="8394480" y="343368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6" name="Rectangle 261"/>
                <p:cNvSpPr/>
                <p:nvPr/>
              </p:nvSpPr>
              <p:spPr>
                <a:xfrm>
                  <a:off x="8289000" y="3508200"/>
                  <a:ext cx="2109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7" name="Rectangle 262"/>
                <p:cNvSpPr/>
                <p:nvPr/>
              </p:nvSpPr>
              <p:spPr>
                <a:xfrm>
                  <a:off x="6997320" y="2873520"/>
                  <a:ext cx="1390680" cy="5126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8" name="Line 263"/>
                <p:cNvSpPr/>
                <p:nvPr/>
              </p:nvSpPr>
              <p:spPr>
                <a:xfrm>
                  <a:off x="7052760" y="2989440"/>
                  <a:ext cx="103320" cy="1440"/>
                </a:xfrm>
                <a:prstGeom prst="line">
                  <a:avLst/>
                </a:prstGeom>
                <a:ln w="30240">
                  <a:solidFill>
                    <a:srgbClr val="1a476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09" name="Line 264"/>
                <p:cNvSpPr/>
                <p:nvPr/>
              </p:nvSpPr>
              <p:spPr>
                <a:xfrm>
                  <a:off x="7052760" y="3271680"/>
                  <a:ext cx="103320" cy="1800"/>
                </a:xfrm>
                <a:prstGeom prst="line">
                  <a:avLst/>
                </a:prstGeom>
                <a:ln w="30240">
                  <a:solidFill>
                    <a:srgbClr val="90353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0" name="Rectangle 265"/>
                <p:cNvSpPr/>
                <p:nvPr/>
              </p:nvSpPr>
              <p:spPr>
                <a:xfrm>
                  <a:off x="7318800" y="2936880"/>
                  <a:ext cx="1008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ow BIM (E/N =40/53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1" name="Rectangle 266"/>
                <p:cNvSpPr/>
                <p:nvPr/>
              </p:nvSpPr>
              <p:spPr>
                <a:xfrm>
                  <a:off x="7320240" y="3219480"/>
                  <a:ext cx="10018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High BIM (E/N=41/76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2" name="Rectangle 267"/>
                <p:cNvSpPr/>
                <p:nvPr/>
              </p:nvSpPr>
              <p:spPr>
                <a:xfrm>
                  <a:off x="7015680" y="2624040"/>
                  <a:ext cx="52668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P=0.003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3" name="Rectangle 268"/>
                <p:cNvSpPr/>
                <p:nvPr/>
              </p:nvSpPr>
              <p:spPr>
                <a:xfrm>
                  <a:off x="6718320" y="923760"/>
                  <a:ext cx="175788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High LMW-E and low full length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4" name="Rectangle 269"/>
                <p:cNvSpPr/>
                <p:nvPr/>
              </p:nvSpPr>
              <p:spPr>
                <a:xfrm>
                  <a:off x="1069560" y="3660840"/>
                  <a:ext cx="1884240" cy="274140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5" name="Rectangle 270"/>
                <p:cNvSpPr/>
                <p:nvPr/>
              </p:nvSpPr>
              <p:spPr>
                <a:xfrm>
                  <a:off x="1298160" y="3660840"/>
                  <a:ext cx="1655640" cy="251280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6" name="Freeform 271"/>
                <p:cNvSpPr/>
                <p:nvPr/>
              </p:nvSpPr>
              <p:spPr>
                <a:xfrm>
                  <a:off x="1379160" y="3741840"/>
                  <a:ext cx="1249560" cy="1373040"/>
                </a:xfrm>
                <a:custGeom>
                  <a:avLst/>
                  <a:gdLst/>
                  <a:ahLst/>
                  <a:rect l="l" t="t" r="r" b="b"/>
                  <a:pathLst>
                    <a:path w="547" h="60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6" y="0"/>
                      </a:lnTo>
                      <a:lnTo>
                        <a:pt x="6" y="128"/>
                      </a:lnTo>
                      <a:lnTo>
                        <a:pt x="16" y="128"/>
                      </a:lnTo>
                      <a:lnTo>
                        <a:pt x="16" y="257"/>
                      </a:lnTo>
                      <a:lnTo>
                        <a:pt x="120" y="257"/>
                      </a:lnTo>
                      <a:lnTo>
                        <a:pt x="120" y="386"/>
                      </a:lnTo>
                      <a:lnTo>
                        <a:pt x="289" y="386"/>
                      </a:lnTo>
                      <a:lnTo>
                        <a:pt x="327" y="386"/>
                      </a:lnTo>
                      <a:lnTo>
                        <a:pt x="442" y="386"/>
                      </a:lnTo>
                      <a:lnTo>
                        <a:pt x="442" y="600"/>
                      </a:lnTo>
                      <a:lnTo>
                        <a:pt x="540" y="600"/>
                      </a:lnTo>
                      <a:lnTo>
                        <a:pt x="541" y="600"/>
                      </a:lnTo>
                      <a:lnTo>
                        <a:pt x="545" y="600"/>
                      </a:lnTo>
                      <a:lnTo>
                        <a:pt x="547" y="600"/>
                      </a:lnTo>
                    </a:path>
                  </a:pathLst>
                </a:custGeom>
                <a:noFill/>
                <a:ln w="30240">
                  <a:solidFill>
                    <a:srgbClr val="1a476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7" name="Freeform 272"/>
                <p:cNvSpPr/>
                <p:nvPr/>
              </p:nvSpPr>
              <p:spPr>
                <a:xfrm>
                  <a:off x="1379160" y="3741840"/>
                  <a:ext cx="1382760" cy="631800"/>
                </a:xfrm>
                <a:custGeom>
                  <a:avLst/>
                  <a:gdLst/>
                  <a:ahLst/>
                  <a:rect l="l" t="t" r="r" b="b"/>
                  <a:pathLst>
                    <a:path w="605" h="27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27" y="0"/>
                      </a:lnTo>
                      <a:lnTo>
                        <a:pt x="27" y="41"/>
                      </a:lnTo>
                      <a:lnTo>
                        <a:pt x="87" y="41"/>
                      </a:lnTo>
                      <a:lnTo>
                        <a:pt x="87" y="82"/>
                      </a:lnTo>
                      <a:lnTo>
                        <a:pt x="89" y="82"/>
                      </a:lnTo>
                      <a:lnTo>
                        <a:pt x="131" y="82"/>
                      </a:lnTo>
                      <a:lnTo>
                        <a:pt x="131" y="125"/>
                      </a:lnTo>
                      <a:lnTo>
                        <a:pt x="136" y="125"/>
                      </a:lnTo>
                      <a:lnTo>
                        <a:pt x="136" y="168"/>
                      </a:lnTo>
                      <a:lnTo>
                        <a:pt x="202" y="168"/>
                      </a:lnTo>
                      <a:lnTo>
                        <a:pt x="203" y="168"/>
                      </a:lnTo>
                      <a:lnTo>
                        <a:pt x="273" y="168"/>
                      </a:lnTo>
                      <a:lnTo>
                        <a:pt x="274" y="168"/>
                      </a:lnTo>
                      <a:lnTo>
                        <a:pt x="278" y="168"/>
                      </a:lnTo>
                      <a:lnTo>
                        <a:pt x="280" y="168"/>
                      </a:lnTo>
                      <a:lnTo>
                        <a:pt x="316" y="168"/>
                      </a:lnTo>
                      <a:lnTo>
                        <a:pt x="318" y="168"/>
                      </a:lnTo>
                      <a:lnTo>
                        <a:pt x="322" y="168"/>
                      </a:lnTo>
                      <a:lnTo>
                        <a:pt x="322" y="222"/>
                      </a:lnTo>
                      <a:lnTo>
                        <a:pt x="327" y="222"/>
                      </a:lnTo>
                      <a:lnTo>
                        <a:pt x="327" y="276"/>
                      </a:lnTo>
                      <a:lnTo>
                        <a:pt x="360" y="276"/>
                      </a:lnTo>
                      <a:lnTo>
                        <a:pt x="382" y="276"/>
                      </a:lnTo>
                      <a:lnTo>
                        <a:pt x="387" y="276"/>
                      </a:lnTo>
                      <a:lnTo>
                        <a:pt x="398" y="276"/>
                      </a:lnTo>
                      <a:lnTo>
                        <a:pt x="420" y="276"/>
                      </a:lnTo>
                      <a:lnTo>
                        <a:pt x="518" y="276"/>
                      </a:lnTo>
                      <a:lnTo>
                        <a:pt x="524" y="276"/>
                      </a:lnTo>
                      <a:lnTo>
                        <a:pt x="584" y="276"/>
                      </a:lnTo>
                      <a:lnTo>
                        <a:pt x="589" y="276"/>
                      </a:lnTo>
                      <a:lnTo>
                        <a:pt x="600" y="276"/>
                      </a:lnTo>
                      <a:lnTo>
                        <a:pt x="605" y="276"/>
                      </a:lnTo>
                    </a:path>
                  </a:pathLst>
                </a:custGeom>
                <a:noFill/>
                <a:ln w="30240">
                  <a:solidFill>
                    <a:srgbClr val="90353b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8" name="Line 273"/>
                <p:cNvSpPr/>
                <p:nvPr/>
              </p:nvSpPr>
              <p:spPr>
                <a:xfrm flipV="1">
                  <a:off x="1582200" y="3881520"/>
                  <a:ext cx="1800" cy="489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60" bIns="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19" name="Line 274"/>
                <p:cNvSpPr/>
                <p:nvPr/>
              </p:nvSpPr>
              <p:spPr>
                <a:xfrm flipV="1">
                  <a:off x="1842840" y="4078440"/>
                  <a:ext cx="1440" cy="47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0" name="Line 275"/>
                <p:cNvSpPr/>
                <p:nvPr/>
              </p:nvSpPr>
              <p:spPr>
                <a:xfrm flipV="1">
                  <a:off x="2004480" y="4078440"/>
                  <a:ext cx="1800" cy="47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1" name="Line 276"/>
                <p:cNvSpPr/>
                <p:nvPr/>
              </p:nvSpPr>
              <p:spPr>
                <a:xfrm flipV="1">
                  <a:off x="2018880" y="4078440"/>
                  <a:ext cx="1800" cy="47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2" name="Line 277"/>
                <p:cNvSpPr/>
                <p:nvPr/>
              </p:nvSpPr>
              <p:spPr>
                <a:xfrm flipV="1">
                  <a:off x="2039400" y="457632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3" name="Line 278"/>
                <p:cNvSpPr/>
                <p:nvPr/>
              </p:nvSpPr>
              <p:spPr>
                <a:xfrm flipV="1">
                  <a:off x="2106360" y="4078440"/>
                  <a:ext cx="1440" cy="47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4" name="Line 279"/>
                <p:cNvSpPr/>
                <p:nvPr/>
              </p:nvSpPr>
              <p:spPr>
                <a:xfrm flipV="1">
                  <a:off x="2126880" y="457632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5" name="Line 280"/>
                <p:cNvSpPr/>
                <p:nvPr/>
              </p:nvSpPr>
              <p:spPr>
                <a:xfrm flipV="1">
                  <a:off x="2201400" y="432540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6" name="Line 281"/>
                <p:cNvSpPr/>
                <p:nvPr/>
              </p:nvSpPr>
              <p:spPr>
                <a:xfrm flipV="1">
                  <a:off x="2252160" y="432540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7" name="Line 282"/>
                <p:cNvSpPr/>
                <p:nvPr/>
              </p:nvSpPr>
              <p:spPr>
                <a:xfrm flipV="1">
                  <a:off x="2263320" y="432540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8" name="Line 283"/>
                <p:cNvSpPr/>
                <p:nvPr/>
              </p:nvSpPr>
              <p:spPr>
                <a:xfrm flipV="1">
                  <a:off x="2288880" y="432540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29" name="Line 284"/>
                <p:cNvSpPr/>
                <p:nvPr/>
              </p:nvSpPr>
              <p:spPr>
                <a:xfrm flipV="1">
                  <a:off x="2339640" y="432540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0" name="Line 285"/>
                <p:cNvSpPr/>
                <p:nvPr/>
              </p:nvSpPr>
              <p:spPr>
                <a:xfrm flipV="1">
                  <a:off x="2563560" y="432540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1" name="Line 286"/>
                <p:cNvSpPr/>
                <p:nvPr/>
              </p:nvSpPr>
              <p:spPr>
                <a:xfrm flipV="1">
                  <a:off x="2576160" y="432540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2" name="Line 287"/>
                <p:cNvSpPr/>
                <p:nvPr/>
              </p:nvSpPr>
              <p:spPr>
                <a:xfrm flipV="1">
                  <a:off x="2615760" y="5065200"/>
                  <a:ext cx="1800" cy="49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" bIns="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3" name="Line 288"/>
                <p:cNvSpPr/>
                <p:nvPr/>
              </p:nvSpPr>
              <p:spPr>
                <a:xfrm flipV="1">
                  <a:off x="2628720" y="5065200"/>
                  <a:ext cx="1440" cy="49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" bIns="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4" name="Line 289"/>
                <p:cNvSpPr/>
                <p:nvPr/>
              </p:nvSpPr>
              <p:spPr>
                <a:xfrm flipV="1">
                  <a:off x="2714400" y="432540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5" name="Line 290"/>
                <p:cNvSpPr/>
                <p:nvPr/>
              </p:nvSpPr>
              <p:spPr>
                <a:xfrm flipV="1">
                  <a:off x="2725200" y="432540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6" name="Line 291"/>
                <p:cNvSpPr/>
                <p:nvPr/>
              </p:nvSpPr>
              <p:spPr>
                <a:xfrm flipV="1">
                  <a:off x="2750760" y="432540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7" name="Line 292"/>
                <p:cNvSpPr/>
                <p:nvPr/>
              </p:nvSpPr>
              <p:spPr>
                <a:xfrm flipV="1">
                  <a:off x="2761920" y="432540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8" name="Line 293"/>
                <p:cNvSpPr/>
                <p:nvPr/>
              </p:nvSpPr>
              <p:spPr>
                <a:xfrm flipV="1">
                  <a:off x="1298160" y="3660480"/>
                  <a:ext cx="1800" cy="25146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9" name="Line 294"/>
                <p:cNvSpPr/>
                <p:nvPr/>
              </p:nvSpPr>
              <p:spPr>
                <a:xfrm flipH="1">
                  <a:off x="1248480" y="6095880"/>
                  <a:ext cx="4932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0" name="Rectangle 295"/>
                <p:cNvSpPr/>
                <p:nvPr/>
              </p:nvSpPr>
              <p:spPr>
                <a:xfrm rot="16200000">
                  <a:off x="1026000" y="601956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1" name="Line 296"/>
                <p:cNvSpPr/>
                <p:nvPr/>
              </p:nvSpPr>
              <p:spPr>
                <a:xfrm flipH="1">
                  <a:off x="1248480" y="5506920"/>
                  <a:ext cx="4932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2" name="Rectangle 297"/>
                <p:cNvSpPr/>
                <p:nvPr/>
              </p:nvSpPr>
              <p:spPr>
                <a:xfrm rot="16200000">
                  <a:off x="1026000" y="54306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2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3" name="Line 298"/>
                <p:cNvSpPr/>
                <p:nvPr/>
              </p:nvSpPr>
              <p:spPr>
                <a:xfrm flipH="1">
                  <a:off x="1248480" y="4917960"/>
                  <a:ext cx="4932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4" name="Rectangle 299"/>
                <p:cNvSpPr/>
                <p:nvPr/>
              </p:nvSpPr>
              <p:spPr>
                <a:xfrm rot="16200000">
                  <a:off x="1026000" y="48416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5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5" name="Line 300"/>
                <p:cNvSpPr/>
                <p:nvPr/>
              </p:nvSpPr>
              <p:spPr>
                <a:xfrm flipH="1">
                  <a:off x="1248480" y="4330800"/>
                  <a:ext cx="4932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6" name="Rectangle 301"/>
                <p:cNvSpPr/>
                <p:nvPr/>
              </p:nvSpPr>
              <p:spPr>
                <a:xfrm rot="16200000">
                  <a:off x="1026000" y="42544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7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7" name="Line 302"/>
                <p:cNvSpPr/>
                <p:nvPr/>
              </p:nvSpPr>
              <p:spPr>
                <a:xfrm flipH="1">
                  <a:off x="1248480" y="3741840"/>
                  <a:ext cx="4932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8" name="Rectangle 303"/>
                <p:cNvSpPr/>
                <p:nvPr/>
              </p:nvSpPr>
              <p:spPr>
                <a:xfrm rot="16200000">
                  <a:off x="1026000" y="366552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9" name="Line 304"/>
                <p:cNvSpPr/>
                <p:nvPr/>
              </p:nvSpPr>
              <p:spPr>
                <a:xfrm>
                  <a:off x="1298160" y="6175440"/>
                  <a:ext cx="165744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0" name="Line 305"/>
                <p:cNvSpPr/>
                <p:nvPr/>
              </p:nvSpPr>
              <p:spPr>
                <a:xfrm>
                  <a:off x="1379160" y="617544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1" name="Rectangle 306"/>
                <p:cNvSpPr/>
                <p:nvPr/>
              </p:nvSpPr>
              <p:spPr>
                <a:xfrm>
                  <a:off x="1343520" y="625140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2" name="Line 307"/>
                <p:cNvSpPr/>
                <p:nvPr/>
              </p:nvSpPr>
              <p:spPr>
                <a:xfrm>
                  <a:off x="1677600" y="617544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3" name="Rectangle 308"/>
                <p:cNvSpPr/>
                <p:nvPr/>
              </p:nvSpPr>
              <p:spPr>
                <a:xfrm>
                  <a:off x="1607040" y="62514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4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4" name="Line 309"/>
                <p:cNvSpPr/>
                <p:nvPr/>
              </p:nvSpPr>
              <p:spPr>
                <a:xfrm>
                  <a:off x="1977840" y="617544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5" name="Rectangle 310"/>
                <p:cNvSpPr/>
                <p:nvPr/>
              </p:nvSpPr>
              <p:spPr>
                <a:xfrm>
                  <a:off x="1907280" y="62514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48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6" name="Line 311"/>
                <p:cNvSpPr/>
                <p:nvPr/>
              </p:nvSpPr>
              <p:spPr>
                <a:xfrm>
                  <a:off x="2277720" y="617544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7" name="Rectangle 312"/>
                <p:cNvSpPr/>
                <p:nvPr/>
              </p:nvSpPr>
              <p:spPr>
                <a:xfrm>
                  <a:off x="2207160" y="62514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72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8" name="Line 313"/>
                <p:cNvSpPr/>
                <p:nvPr/>
              </p:nvSpPr>
              <p:spPr>
                <a:xfrm>
                  <a:off x="2576160" y="617544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59" name="Rectangle 314"/>
                <p:cNvSpPr/>
                <p:nvPr/>
              </p:nvSpPr>
              <p:spPr>
                <a:xfrm>
                  <a:off x="2505600" y="62514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6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0" name="Line 315"/>
                <p:cNvSpPr/>
                <p:nvPr/>
              </p:nvSpPr>
              <p:spPr>
                <a:xfrm>
                  <a:off x="2874600" y="617544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1" name="Rectangle 316"/>
                <p:cNvSpPr/>
                <p:nvPr/>
              </p:nvSpPr>
              <p:spPr>
                <a:xfrm>
                  <a:off x="2769120" y="6251400"/>
                  <a:ext cx="2109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2" name="Rectangle 317"/>
                <p:cNvSpPr/>
                <p:nvPr/>
              </p:nvSpPr>
              <p:spPr>
                <a:xfrm>
                  <a:off x="1342800" y="5614920"/>
                  <a:ext cx="1350720" cy="5144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3" name="Line 318"/>
                <p:cNvSpPr/>
                <p:nvPr/>
              </p:nvSpPr>
              <p:spPr>
                <a:xfrm>
                  <a:off x="1396800" y="5734080"/>
                  <a:ext cx="102960" cy="1440"/>
                </a:xfrm>
                <a:prstGeom prst="line">
                  <a:avLst/>
                </a:prstGeom>
                <a:ln w="30240">
                  <a:solidFill>
                    <a:srgbClr val="1a476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4" name="Line 319"/>
                <p:cNvSpPr/>
                <p:nvPr/>
              </p:nvSpPr>
              <p:spPr>
                <a:xfrm>
                  <a:off x="1396800" y="6013440"/>
                  <a:ext cx="102960" cy="1440"/>
                </a:xfrm>
                <a:prstGeom prst="line">
                  <a:avLst/>
                </a:prstGeom>
                <a:ln w="30240">
                  <a:solidFill>
                    <a:srgbClr val="90353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5" name="Rectangle 320"/>
                <p:cNvSpPr/>
                <p:nvPr/>
              </p:nvSpPr>
              <p:spPr>
                <a:xfrm>
                  <a:off x="1661760" y="5681520"/>
                  <a:ext cx="912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ow AKT (E/N =4/8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6" name="Rectangle 321"/>
                <p:cNvSpPr/>
                <p:nvPr/>
              </p:nvSpPr>
              <p:spPr>
                <a:xfrm>
                  <a:off x="1662480" y="5961240"/>
                  <a:ext cx="9622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High AKT (E/N=6/25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7" name="Rectangle 322"/>
                <p:cNvSpPr/>
                <p:nvPr/>
              </p:nvSpPr>
              <p:spPr>
                <a:xfrm>
                  <a:off x="1400760" y="5343480"/>
                  <a:ext cx="37116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P=0.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8" name="Rectangle 323"/>
                <p:cNvSpPr/>
                <p:nvPr/>
              </p:nvSpPr>
              <p:spPr>
                <a:xfrm>
                  <a:off x="2955600" y="3660840"/>
                  <a:ext cx="1884240" cy="274140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69" name="Rectangle 324"/>
                <p:cNvSpPr/>
                <p:nvPr/>
              </p:nvSpPr>
              <p:spPr>
                <a:xfrm>
                  <a:off x="3184200" y="3660840"/>
                  <a:ext cx="1655640" cy="251280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0" name="Freeform 325"/>
                <p:cNvSpPr/>
                <p:nvPr/>
              </p:nvSpPr>
              <p:spPr>
                <a:xfrm>
                  <a:off x="3265200" y="3741840"/>
                  <a:ext cx="1262160" cy="1785960"/>
                </a:xfrm>
                <a:custGeom>
                  <a:avLst/>
                  <a:gdLst/>
                  <a:ahLst/>
                  <a:rect l="l" t="t" r="r" b="b"/>
                  <a:pathLst>
                    <a:path w="552" h="781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" y="0"/>
                      </a:lnTo>
                      <a:lnTo>
                        <a:pt x="5" y="14"/>
                      </a:lnTo>
                      <a:lnTo>
                        <a:pt x="10" y="14"/>
                      </a:lnTo>
                      <a:lnTo>
                        <a:pt x="10" y="29"/>
                      </a:lnTo>
                      <a:lnTo>
                        <a:pt x="15" y="29"/>
                      </a:lnTo>
                      <a:lnTo>
                        <a:pt x="15" y="58"/>
                      </a:lnTo>
                      <a:lnTo>
                        <a:pt x="35" y="58"/>
                      </a:lnTo>
                      <a:lnTo>
                        <a:pt x="35" y="72"/>
                      </a:lnTo>
                      <a:lnTo>
                        <a:pt x="44" y="72"/>
                      </a:lnTo>
                      <a:lnTo>
                        <a:pt x="44" y="130"/>
                      </a:lnTo>
                      <a:lnTo>
                        <a:pt x="49" y="130"/>
                      </a:lnTo>
                      <a:lnTo>
                        <a:pt x="49" y="145"/>
                      </a:lnTo>
                      <a:lnTo>
                        <a:pt x="54" y="145"/>
                      </a:lnTo>
                      <a:lnTo>
                        <a:pt x="54" y="159"/>
                      </a:lnTo>
                      <a:lnTo>
                        <a:pt x="59" y="159"/>
                      </a:lnTo>
                      <a:lnTo>
                        <a:pt x="59" y="203"/>
                      </a:lnTo>
                      <a:lnTo>
                        <a:pt x="64" y="203"/>
                      </a:lnTo>
                      <a:lnTo>
                        <a:pt x="64" y="217"/>
                      </a:lnTo>
                      <a:lnTo>
                        <a:pt x="69" y="217"/>
                      </a:lnTo>
                      <a:lnTo>
                        <a:pt x="69" y="246"/>
                      </a:lnTo>
                      <a:lnTo>
                        <a:pt x="74" y="246"/>
                      </a:lnTo>
                      <a:lnTo>
                        <a:pt x="74" y="261"/>
                      </a:lnTo>
                      <a:lnTo>
                        <a:pt x="79" y="261"/>
                      </a:lnTo>
                      <a:lnTo>
                        <a:pt x="79" y="275"/>
                      </a:lnTo>
                      <a:lnTo>
                        <a:pt x="84" y="275"/>
                      </a:lnTo>
                      <a:lnTo>
                        <a:pt x="84" y="290"/>
                      </a:lnTo>
                      <a:lnTo>
                        <a:pt x="89" y="290"/>
                      </a:lnTo>
                      <a:lnTo>
                        <a:pt x="89" y="304"/>
                      </a:lnTo>
                      <a:lnTo>
                        <a:pt x="94" y="304"/>
                      </a:lnTo>
                      <a:lnTo>
                        <a:pt x="94" y="348"/>
                      </a:lnTo>
                      <a:lnTo>
                        <a:pt x="99" y="348"/>
                      </a:lnTo>
                      <a:lnTo>
                        <a:pt x="99" y="362"/>
                      </a:lnTo>
                      <a:lnTo>
                        <a:pt x="114" y="362"/>
                      </a:lnTo>
                      <a:lnTo>
                        <a:pt x="114" y="377"/>
                      </a:lnTo>
                      <a:lnTo>
                        <a:pt x="119" y="377"/>
                      </a:lnTo>
                      <a:lnTo>
                        <a:pt x="119" y="435"/>
                      </a:lnTo>
                      <a:lnTo>
                        <a:pt x="124" y="435"/>
                      </a:lnTo>
                      <a:lnTo>
                        <a:pt x="124" y="449"/>
                      </a:lnTo>
                      <a:lnTo>
                        <a:pt x="129" y="449"/>
                      </a:lnTo>
                      <a:lnTo>
                        <a:pt x="129" y="478"/>
                      </a:lnTo>
                      <a:lnTo>
                        <a:pt x="154" y="478"/>
                      </a:lnTo>
                      <a:lnTo>
                        <a:pt x="154" y="493"/>
                      </a:lnTo>
                      <a:lnTo>
                        <a:pt x="163" y="493"/>
                      </a:lnTo>
                      <a:lnTo>
                        <a:pt x="163" y="507"/>
                      </a:lnTo>
                      <a:lnTo>
                        <a:pt x="168" y="507"/>
                      </a:lnTo>
                      <a:lnTo>
                        <a:pt x="168" y="522"/>
                      </a:lnTo>
                      <a:lnTo>
                        <a:pt x="173" y="522"/>
                      </a:lnTo>
                      <a:lnTo>
                        <a:pt x="173" y="536"/>
                      </a:lnTo>
                      <a:lnTo>
                        <a:pt x="178" y="536"/>
                      </a:lnTo>
                      <a:lnTo>
                        <a:pt x="178" y="551"/>
                      </a:lnTo>
                      <a:lnTo>
                        <a:pt x="188" y="551"/>
                      </a:lnTo>
                      <a:lnTo>
                        <a:pt x="188" y="580"/>
                      </a:lnTo>
                      <a:lnTo>
                        <a:pt x="193" y="580"/>
                      </a:lnTo>
                      <a:lnTo>
                        <a:pt x="193" y="594"/>
                      </a:lnTo>
                      <a:lnTo>
                        <a:pt x="213" y="594"/>
                      </a:lnTo>
                      <a:lnTo>
                        <a:pt x="213" y="609"/>
                      </a:lnTo>
                      <a:lnTo>
                        <a:pt x="223" y="609"/>
                      </a:lnTo>
                      <a:lnTo>
                        <a:pt x="223" y="623"/>
                      </a:lnTo>
                      <a:lnTo>
                        <a:pt x="233" y="623"/>
                      </a:lnTo>
                      <a:lnTo>
                        <a:pt x="233" y="638"/>
                      </a:lnTo>
                      <a:lnTo>
                        <a:pt x="238" y="638"/>
                      </a:lnTo>
                      <a:lnTo>
                        <a:pt x="238" y="652"/>
                      </a:lnTo>
                      <a:lnTo>
                        <a:pt x="243" y="652"/>
                      </a:lnTo>
                      <a:lnTo>
                        <a:pt x="243" y="681"/>
                      </a:lnTo>
                      <a:lnTo>
                        <a:pt x="248" y="681"/>
                      </a:lnTo>
                      <a:lnTo>
                        <a:pt x="248" y="695"/>
                      </a:lnTo>
                      <a:lnTo>
                        <a:pt x="249" y="695"/>
                      </a:lnTo>
                      <a:lnTo>
                        <a:pt x="263" y="695"/>
                      </a:lnTo>
                      <a:lnTo>
                        <a:pt x="264" y="695"/>
                      </a:lnTo>
                      <a:lnTo>
                        <a:pt x="282" y="695"/>
                      </a:lnTo>
                      <a:lnTo>
                        <a:pt x="284" y="695"/>
                      </a:lnTo>
                      <a:lnTo>
                        <a:pt x="297" y="695"/>
                      </a:lnTo>
                      <a:lnTo>
                        <a:pt x="297" y="713"/>
                      </a:lnTo>
                      <a:lnTo>
                        <a:pt x="312" y="713"/>
                      </a:lnTo>
                      <a:lnTo>
                        <a:pt x="314" y="713"/>
                      </a:lnTo>
                      <a:lnTo>
                        <a:pt x="322" y="713"/>
                      </a:lnTo>
                      <a:lnTo>
                        <a:pt x="324" y="713"/>
                      </a:lnTo>
                      <a:lnTo>
                        <a:pt x="367" y="713"/>
                      </a:lnTo>
                      <a:lnTo>
                        <a:pt x="367" y="733"/>
                      </a:lnTo>
                      <a:lnTo>
                        <a:pt x="377" y="733"/>
                      </a:lnTo>
                      <a:lnTo>
                        <a:pt x="378" y="733"/>
                      </a:lnTo>
                      <a:lnTo>
                        <a:pt x="411" y="733"/>
                      </a:lnTo>
                      <a:lnTo>
                        <a:pt x="411" y="754"/>
                      </a:lnTo>
                      <a:lnTo>
                        <a:pt x="416" y="754"/>
                      </a:lnTo>
                      <a:lnTo>
                        <a:pt x="431" y="754"/>
                      </a:lnTo>
                      <a:lnTo>
                        <a:pt x="441" y="754"/>
                      </a:lnTo>
                      <a:lnTo>
                        <a:pt x="441" y="781"/>
                      </a:lnTo>
                      <a:lnTo>
                        <a:pt x="446" y="781"/>
                      </a:lnTo>
                      <a:lnTo>
                        <a:pt x="447" y="781"/>
                      </a:lnTo>
                      <a:lnTo>
                        <a:pt x="461" y="781"/>
                      </a:lnTo>
                      <a:lnTo>
                        <a:pt x="462" y="781"/>
                      </a:lnTo>
                      <a:lnTo>
                        <a:pt x="476" y="781"/>
                      </a:lnTo>
                      <a:lnTo>
                        <a:pt x="477" y="781"/>
                      </a:lnTo>
                      <a:lnTo>
                        <a:pt x="496" y="781"/>
                      </a:lnTo>
                      <a:lnTo>
                        <a:pt x="497" y="781"/>
                      </a:lnTo>
                      <a:lnTo>
                        <a:pt x="520" y="781"/>
                      </a:lnTo>
                      <a:lnTo>
                        <a:pt x="522" y="781"/>
                      </a:lnTo>
                      <a:lnTo>
                        <a:pt x="545" y="781"/>
                      </a:lnTo>
                      <a:lnTo>
                        <a:pt x="547" y="781"/>
                      </a:lnTo>
                      <a:lnTo>
                        <a:pt x="550" y="781"/>
                      </a:lnTo>
                      <a:lnTo>
                        <a:pt x="552" y="781"/>
                      </a:lnTo>
                    </a:path>
                  </a:pathLst>
                </a:custGeom>
                <a:noFill/>
                <a:ln w="30240">
                  <a:solidFill>
                    <a:srgbClr val="1a476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1" name="Freeform 326"/>
                <p:cNvSpPr/>
                <p:nvPr/>
              </p:nvSpPr>
              <p:spPr>
                <a:xfrm>
                  <a:off x="3265200" y="3741840"/>
                  <a:ext cx="1495440" cy="1384200"/>
                </a:xfrm>
                <a:custGeom>
                  <a:avLst/>
                  <a:gdLst/>
                  <a:ahLst/>
                  <a:rect l="l" t="t" r="r" b="b"/>
                  <a:pathLst>
                    <a:path w="654" h="605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25" y="0"/>
                      </a:lnTo>
                      <a:lnTo>
                        <a:pt x="25" y="17"/>
                      </a:lnTo>
                      <a:lnTo>
                        <a:pt x="30" y="17"/>
                      </a:lnTo>
                      <a:lnTo>
                        <a:pt x="30" y="35"/>
                      </a:lnTo>
                      <a:lnTo>
                        <a:pt x="69" y="35"/>
                      </a:lnTo>
                      <a:lnTo>
                        <a:pt x="69" y="53"/>
                      </a:lnTo>
                      <a:lnTo>
                        <a:pt x="74" y="53"/>
                      </a:lnTo>
                      <a:lnTo>
                        <a:pt x="74" y="88"/>
                      </a:lnTo>
                      <a:lnTo>
                        <a:pt x="79" y="88"/>
                      </a:lnTo>
                      <a:lnTo>
                        <a:pt x="79" y="106"/>
                      </a:lnTo>
                      <a:lnTo>
                        <a:pt x="84" y="106"/>
                      </a:lnTo>
                      <a:lnTo>
                        <a:pt x="84" y="124"/>
                      </a:lnTo>
                      <a:lnTo>
                        <a:pt x="99" y="124"/>
                      </a:lnTo>
                      <a:lnTo>
                        <a:pt x="99" y="159"/>
                      </a:lnTo>
                      <a:lnTo>
                        <a:pt x="104" y="159"/>
                      </a:lnTo>
                      <a:lnTo>
                        <a:pt x="104" y="195"/>
                      </a:lnTo>
                      <a:lnTo>
                        <a:pt x="109" y="195"/>
                      </a:lnTo>
                      <a:lnTo>
                        <a:pt x="109" y="230"/>
                      </a:lnTo>
                      <a:lnTo>
                        <a:pt x="114" y="230"/>
                      </a:lnTo>
                      <a:lnTo>
                        <a:pt x="114" y="266"/>
                      </a:lnTo>
                      <a:lnTo>
                        <a:pt x="129" y="266"/>
                      </a:lnTo>
                      <a:lnTo>
                        <a:pt x="129" y="301"/>
                      </a:lnTo>
                      <a:lnTo>
                        <a:pt x="144" y="301"/>
                      </a:lnTo>
                      <a:lnTo>
                        <a:pt x="144" y="319"/>
                      </a:lnTo>
                      <a:lnTo>
                        <a:pt x="154" y="319"/>
                      </a:lnTo>
                      <a:lnTo>
                        <a:pt x="154" y="372"/>
                      </a:lnTo>
                      <a:lnTo>
                        <a:pt x="178" y="372"/>
                      </a:lnTo>
                      <a:lnTo>
                        <a:pt x="193" y="372"/>
                      </a:lnTo>
                      <a:lnTo>
                        <a:pt x="193" y="391"/>
                      </a:lnTo>
                      <a:lnTo>
                        <a:pt x="198" y="391"/>
                      </a:lnTo>
                      <a:lnTo>
                        <a:pt x="238" y="391"/>
                      </a:lnTo>
                      <a:lnTo>
                        <a:pt x="238" y="447"/>
                      </a:lnTo>
                      <a:lnTo>
                        <a:pt x="253" y="447"/>
                      </a:lnTo>
                      <a:lnTo>
                        <a:pt x="253" y="466"/>
                      </a:lnTo>
                      <a:lnTo>
                        <a:pt x="263" y="466"/>
                      </a:lnTo>
                      <a:lnTo>
                        <a:pt x="277" y="466"/>
                      </a:lnTo>
                      <a:lnTo>
                        <a:pt x="282" y="466"/>
                      </a:lnTo>
                      <a:lnTo>
                        <a:pt x="297" y="466"/>
                      </a:lnTo>
                      <a:lnTo>
                        <a:pt x="307" y="466"/>
                      </a:lnTo>
                      <a:lnTo>
                        <a:pt x="307" y="488"/>
                      </a:lnTo>
                      <a:lnTo>
                        <a:pt x="322" y="488"/>
                      </a:lnTo>
                      <a:lnTo>
                        <a:pt x="327" y="488"/>
                      </a:lnTo>
                      <a:lnTo>
                        <a:pt x="352" y="488"/>
                      </a:lnTo>
                      <a:lnTo>
                        <a:pt x="357" y="488"/>
                      </a:lnTo>
                      <a:lnTo>
                        <a:pt x="372" y="488"/>
                      </a:lnTo>
                      <a:lnTo>
                        <a:pt x="416" y="488"/>
                      </a:lnTo>
                      <a:lnTo>
                        <a:pt x="416" y="520"/>
                      </a:lnTo>
                      <a:lnTo>
                        <a:pt x="451" y="520"/>
                      </a:lnTo>
                      <a:lnTo>
                        <a:pt x="456" y="520"/>
                      </a:lnTo>
                      <a:lnTo>
                        <a:pt x="461" y="520"/>
                      </a:lnTo>
                      <a:lnTo>
                        <a:pt x="471" y="520"/>
                      </a:lnTo>
                      <a:lnTo>
                        <a:pt x="476" y="520"/>
                      </a:lnTo>
                      <a:lnTo>
                        <a:pt x="491" y="520"/>
                      </a:lnTo>
                      <a:lnTo>
                        <a:pt x="530" y="520"/>
                      </a:lnTo>
                      <a:lnTo>
                        <a:pt x="535" y="520"/>
                      </a:lnTo>
                      <a:lnTo>
                        <a:pt x="535" y="605"/>
                      </a:lnTo>
                      <a:lnTo>
                        <a:pt x="555" y="605"/>
                      </a:lnTo>
                      <a:lnTo>
                        <a:pt x="654" y="605"/>
                      </a:lnTo>
                    </a:path>
                  </a:pathLst>
                </a:custGeom>
                <a:noFill/>
                <a:ln w="30240">
                  <a:solidFill>
                    <a:srgbClr val="90353b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2" name="Line 327"/>
                <p:cNvSpPr/>
                <p:nvPr/>
              </p:nvSpPr>
              <p:spPr>
                <a:xfrm flipV="1">
                  <a:off x="3671640" y="4546440"/>
                  <a:ext cx="1440" cy="46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3" name="Line 328"/>
                <p:cNvSpPr/>
                <p:nvPr/>
              </p:nvSpPr>
              <p:spPr>
                <a:xfrm flipV="1">
                  <a:off x="3717720" y="4587480"/>
                  <a:ext cx="1440" cy="49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" bIns="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4" name="Line 329"/>
                <p:cNvSpPr/>
                <p:nvPr/>
              </p:nvSpPr>
              <p:spPr>
                <a:xfrm flipV="1">
                  <a:off x="3833280" y="5286240"/>
                  <a:ext cx="1800" cy="46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5" name="Line 330"/>
                <p:cNvSpPr/>
                <p:nvPr/>
              </p:nvSpPr>
              <p:spPr>
                <a:xfrm flipV="1">
                  <a:off x="3843000" y="4758840"/>
                  <a:ext cx="1440" cy="49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" bIns="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6" name="Line 331"/>
                <p:cNvSpPr/>
                <p:nvPr/>
              </p:nvSpPr>
              <p:spPr>
                <a:xfrm flipV="1">
                  <a:off x="3868200" y="5286240"/>
                  <a:ext cx="1800" cy="46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7" name="Line 332"/>
                <p:cNvSpPr/>
                <p:nvPr/>
              </p:nvSpPr>
              <p:spPr>
                <a:xfrm flipV="1">
                  <a:off x="3866760" y="4758840"/>
                  <a:ext cx="1440" cy="49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" bIns="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8" name="Line 333"/>
                <p:cNvSpPr/>
                <p:nvPr/>
              </p:nvSpPr>
              <p:spPr>
                <a:xfrm flipV="1">
                  <a:off x="3900240" y="4758840"/>
                  <a:ext cx="1440" cy="49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" bIns="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79" name="Line 334"/>
                <p:cNvSpPr/>
                <p:nvPr/>
              </p:nvSpPr>
              <p:spPr>
                <a:xfrm flipV="1">
                  <a:off x="3914280" y="5286240"/>
                  <a:ext cx="1800" cy="46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0" name="Line 335"/>
                <p:cNvSpPr/>
                <p:nvPr/>
              </p:nvSpPr>
              <p:spPr>
                <a:xfrm flipV="1">
                  <a:off x="3909600" y="4758840"/>
                  <a:ext cx="1800" cy="49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" bIns="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1" name="Line 336"/>
                <p:cNvSpPr/>
                <p:nvPr/>
              </p:nvSpPr>
              <p:spPr>
                <a:xfrm flipV="1">
                  <a:off x="3943080" y="4758840"/>
                  <a:ext cx="1440" cy="49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20" bIns="25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2" name="Line 337"/>
                <p:cNvSpPr/>
                <p:nvPr/>
              </p:nvSpPr>
              <p:spPr>
                <a:xfrm flipV="1">
                  <a:off x="3982680" y="532404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3" name="Line 338"/>
                <p:cNvSpPr/>
                <p:nvPr/>
              </p:nvSpPr>
              <p:spPr>
                <a:xfrm flipV="1">
                  <a:off x="4005000" y="532404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4" name="Line 339"/>
                <p:cNvSpPr/>
                <p:nvPr/>
              </p:nvSpPr>
              <p:spPr>
                <a:xfrm flipV="1">
                  <a:off x="4000320" y="481320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5" name="Line 340"/>
                <p:cNvSpPr/>
                <p:nvPr/>
              </p:nvSpPr>
              <p:spPr>
                <a:xfrm flipV="1">
                  <a:off x="4012920" y="481320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6" name="Line 341"/>
                <p:cNvSpPr/>
                <p:nvPr/>
              </p:nvSpPr>
              <p:spPr>
                <a:xfrm flipV="1">
                  <a:off x="4070160" y="481320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7" name="Line 342"/>
                <p:cNvSpPr/>
                <p:nvPr/>
              </p:nvSpPr>
              <p:spPr>
                <a:xfrm flipV="1">
                  <a:off x="4080960" y="481320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8" name="Line 343"/>
                <p:cNvSpPr/>
                <p:nvPr/>
              </p:nvSpPr>
              <p:spPr>
                <a:xfrm flipV="1">
                  <a:off x="4114440" y="481320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89" name="Line 344"/>
                <p:cNvSpPr/>
                <p:nvPr/>
              </p:nvSpPr>
              <p:spPr>
                <a:xfrm flipV="1">
                  <a:off x="4128840" y="5370480"/>
                  <a:ext cx="1440" cy="47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0" name="Line 345"/>
                <p:cNvSpPr/>
                <p:nvPr/>
              </p:nvSpPr>
              <p:spPr>
                <a:xfrm flipV="1">
                  <a:off x="4215960" y="541764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1" name="Line 346"/>
                <p:cNvSpPr/>
                <p:nvPr/>
              </p:nvSpPr>
              <p:spPr>
                <a:xfrm flipV="1">
                  <a:off x="4215960" y="488268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2" name="Line 347"/>
                <p:cNvSpPr/>
                <p:nvPr/>
              </p:nvSpPr>
              <p:spPr>
                <a:xfrm flipV="1">
                  <a:off x="4249440" y="541764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3" name="Line 348"/>
                <p:cNvSpPr/>
                <p:nvPr/>
              </p:nvSpPr>
              <p:spPr>
                <a:xfrm flipV="1">
                  <a:off x="4289040" y="548316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4" name="Line 349"/>
                <p:cNvSpPr/>
                <p:nvPr/>
              </p:nvSpPr>
              <p:spPr>
                <a:xfrm flipV="1">
                  <a:off x="4295520" y="488268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5" name="Line 350"/>
                <p:cNvSpPr/>
                <p:nvPr/>
              </p:nvSpPr>
              <p:spPr>
                <a:xfrm flipV="1">
                  <a:off x="4306680" y="488268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6" name="Line 351"/>
                <p:cNvSpPr/>
                <p:nvPr/>
              </p:nvSpPr>
              <p:spPr>
                <a:xfrm flipV="1">
                  <a:off x="4320720" y="548316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7" name="Line 352"/>
                <p:cNvSpPr/>
                <p:nvPr/>
              </p:nvSpPr>
              <p:spPr>
                <a:xfrm flipV="1">
                  <a:off x="4319280" y="488268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8" name="Line 353"/>
                <p:cNvSpPr/>
                <p:nvPr/>
              </p:nvSpPr>
              <p:spPr>
                <a:xfrm flipV="1">
                  <a:off x="4341600" y="488268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99" name="Line 354"/>
                <p:cNvSpPr/>
                <p:nvPr/>
              </p:nvSpPr>
              <p:spPr>
                <a:xfrm flipV="1">
                  <a:off x="4355640" y="548316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0" name="Line 355"/>
                <p:cNvSpPr/>
                <p:nvPr/>
              </p:nvSpPr>
              <p:spPr>
                <a:xfrm flipV="1">
                  <a:off x="4352400" y="488268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1" name="Line 356"/>
                <p:cNvSpPr/>
                <p:nvPr/>
              </p:nvSpPr>
              <p:spPr>
                <a:xfrm flipV="1">
                  <a:off x="4387320" y="488268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2" name="Line 357"/>
                <p:cNvSpPr/>
                <p:nvPr/>
              </p:nvSpPr>
              <p:spPr>
                <a:xfrm flipV="1">
                  <a:off x="4400280" y="548316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3" name="Line 358"/>
                <p:cNvSpPr/>
                <p:nvPr/>
              </p:nvSpPr>
              <p:spPr>
                <a:xfrm flipV="1">
                  <a:off x="4457520" y="548316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4" name="Line 359"/>
                <p:cNvSpPr/>
                <p:nvPr/>
              </p:nvSpPr>
              <p:spPr>
                <a:xfrm flipV="1">
                  <a:off x="4476240" y="488268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5" name="Line 360"/>
                <p:cNvSpPr/>
                <p:nvPr/>
              </p:nvSpPr>
              <p:spPr>
                <a:xfrm flipV="1">
                  <a:off x="4487400" y="5078520"/>
                  <a:ext cx="1800" cy="47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6" name="Line 361"/>
                <p:cNvSpPr/>
                <p:nvPr/>
              </p:nvSpPr>
              <p:spPr>
                <a:xfrm flipV="1">
                  <a:off x="4514400" y="5483160"/>
                  <a:ext cx="180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7" name="Line 362"/>
                <p:cNvSpPr/>
                <p:nvPr/>
              </p:nvSpPr>
              <p:spPr>
                <a:xfrm flipV="1">
                  <a:off x="4527360" y="5483160"/>
                  <a:ext cx="1440" cy="44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8" name="Line 363"/>
                <p:cNvSpPr/>
                <p:nvPr/>
              </p:nvSpPr>
              <p:spPr>
                <a:xfrm flipV="1">
                  <a:off x="4533480" y="5078520"/>
                  <a:ext cx="1800" cy="47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09" name="Line 364"/>
                <p:cNvSpPr/>
                <p:nvPr/>
              </p:nvSpPr>
              <p:spPr>
                <a:xfrm flipV="1">
                  <a:off x="4760640" y="5078520"/>
                  <a:ext cx="1440" cy="47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0" name="Line 365"/>
                <p:cNvSpPr/>
                <p:nvPr/>
              </p:nvSpPr>
              <p:spPr>
                <a:xfrm flipV="1">
                  <a:off x="3184200" y="3660480"/>
                  <a:ext cx="1440" cy="25146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1" name="Line 366"/>
                <p:cNvSpPr/>
                <p:nvPr/>
              </p:nvSpPr>
              <p:spPr>
                <a:xfrm flipH="1">
                  <a:off x="3131640" y="6095880"/>
                  <a:ext cx="5256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2" name="Rectangle 367"/>
                <p:cNvSpPr/>
                <p:nvPr/>
              </p:nvSpPr>
              <p:spPr>
                <a:xfrm rot="16200000">
                  <a:off x="2910240" y="601956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3" name="Line 368"/>
                <p:cNvSpPr/>
                <p:nvPr/>
              </p:nvSpPr>
              <p:spPr>
                <a:xfrm flipH="1">
                  <a:off x="3131640" y="5506920"/>
                  <a:ext cx="5256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4" name="Rectangle 369"/>
                <p:cNvSpPr/>
                <p:nvPr/>
              </p:nvSpPr>
              <p:spPr>
                <a:xfrm rot="16200000">
                  <a:off x="2910240" y="543060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2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5" name="Line 370"/>
                <p:cNvSpPr/>
                <p:nvPr/>
              </p:nvSpPr>
              <p:spPr>
                <a:xfrm flipH="1">
                  <a:off x="3131640" y="4917960"/>
                  <a:ext cx="52560" cy="180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6" name="Rectangle 371"/>
                <p:cNvSpPr/>
                <p:nvPr/>
              </p:nvSpPr>
              <p:spPr>
                <a:xfrm rot="16200000">
                  <a:off x="2910240" y="484164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5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7" name="Line 372"/>
                <p:cNvSpPr/>
                <p:nvPr/>
              </p:nvSpPr>
              <p:spPr>
                <a:xfrm flipH="1">
                  <a:off x="3131640" y="4330800"/>
                  <a:ext cx="525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8" name="Rectangle 373"/>
                <p:cNvSpPr/>
                <p:nvPr/>
              </p:nvSpPr>
              <p:spPr>
                <a:xfrm rot="16200000">
                  <a:off x="2910240" y="425268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75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19" name="Line 374"/>
                <p:cNvSpPr/>
                <p:nvPr/>
              </p:nvSpPr>
              <p:spPr>
                <a:xfrm flipH="1">
                  <a:off x="3131640" y="3741840"/>
                  <a:ext cx="5256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0" name="Rectangle 375"/>
                <p:cNvSpPr/>
                <p:nvPr/>
              </p:nvSpPr>
              <p:spPr>
                <a:xfrm rot="16200000">
                  <a:off x="2910240" y="3663720"/>
                  <a:ext cx="2462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1" name="Line 376"/>
                <p:cNvSpPr/>
                <p:nvPr/>
              </p:nvSpPr>
              <p:spPr>
                <a:xfrm>
                  <a:off x="3184200" y="6175440"/>
                  <a:ext cx="165744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2" name="Line 377"/>
                <p:cNvSpPr/>
                <p:nvPr/>
              </p:nvSpPr>
              <p:spPr>
                <a:xfrm>
                  <a:off x="3265200" y="617544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3" name="Rectangle 378"/>
                <p:cNvSpPr/>
                <p:nvPr/>
              </p:nvSpPr>
              <p:spPr>
                <a:xfrm>
                  <a:off x="3229560" y="625140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4" name="Line 379"/>
                <p:cNvSpPr/>
                <p:nvPr/>
              </p:nvSpPr>
              <p:spPr>
                <a:xfrm>
                  <a:off x="3536640" y="617544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5" name="Rectangle 380"/>
                <p:cNvSpPr/>
                <p:nvPr/>
              </p:nvSpPr>
              <p:spPr>
                <a:xfrm>
                  <a:off x="3466080" y="62514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24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6" name="Line 381"/>
                <p:cNvSpPr/>
                <p:nvPr/>
              </p:nvSpPr>
              <p:spPr>
                <a:xfrm>
                  <a:off x="3809520" y="6175440"/>
                  <a:ext cx="180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7" name="Rectangle 382"/>
                <p:cNvSpPr/>
                <p:nvPr/>
              </p:nvSpPr>
              <p:spPr>
                <a:xfrm>
                  <a:off x="3738960" y="62514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48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8" name="Line 383"/>
                <p:cNvSpPr/>
                <p:nvPr/>
              </p:nvSpPr>
              <p:spPr>
                <a:xfrm>
                  <a:off x="4080960" y="6175440"/>
                  <a:ext cx="180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29" name="Rectangle 384"/>
                <p:cNvSpPr/>
                <p:nvPr/>
              </p:nvSpPr>
              <p:spPr>
                <a:xfrm>
                  <a:off x="4010760" y="62514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72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0" name="Line 385"/>
                <p:cNvSpPr/>
                <p:nvPr/>
              </p:nvSpPr>
              <p:spPr>
                <a:xfrm>
                  <a:off x="4352400" y="6175440"/>
                  <a:ext cx="180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1" name="Rectangle 386"/>
                <p:cNvSpPr/>
                <p:nvPr/>
              </p:nvSpPr>
              <p:spPr>
                <a:xfrm>
                  <a:off x="4282200" y="6251400"/>
                  <a:ext cx="1407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96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2" name="Line 387"/>
                <p:cNvSpPr/>
                <p:nvPr/>
              </p:nvSpPr>
              <p:spPr>
                <a:xfrm>
                  <a:off x="4625640" y="6175440"/>
                  <a:ext cx="1440" cy="5076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60" bIns="3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3" name="Rectangle 388"/>
                <p:cNvSpPr/>
                <p:nvPr/>
              </p:nvSpPr>
              <p:spPr>
                <a:xfrm>
                  <a:off x="4520160" y="6251400"/>
                  <a:ext cx="2109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4" name="Rectangle 389"/>
                <p:cNvSpPr/>
                <p:nvPr/>
              </p:nvSpPr>
              <p:spPr>
                <a:xfrm>
                  <a:off x="3228480" y="5614920"/>
                  <a:ext cx="1417680" cy="51444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5" name="Line 390"/>
                <p:cNvSpPr/>
                <p:nvPr/>
              </p:nvSpPr>
              <p:spPr>
                <a:xfrm>
                  <a:off x="3282480" y="5734080"/>
                  <a:ext cx="101880" cy="1440"/>
                </a:xfrm>
                <a:prstGeom prst="line">
                  <a:avLst/>
                </a:prstGeom>
                <a:ln w="30240">
                  <a:solidFill>
                    <a:srgbClr val="1a476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6" name="Line 391"/>
                <p:cNvSpPr/>
                <p:nvPr/>
              </p:nvSpPr>
              <p:spPr>
                <a:xfrm>
                  <a:off x="3282480" y="6013440"/>
                  <a:ext cx="101880" cy="1440"/>
                </a:xfrm>
                <a:prstGeom prst="line">
                  <a:avLst/>
                </a:prstGeom>
                <a:ln w="30240">
                  <a:solidFill>
                    <a:srgbClr val="90353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7" name="Rectangle 392"/>
                <p:cNvSpPr/>
                <p:nvPr/>
              </p:nvSpPr>
              <p:spPr>
                <a:xfrm>
                  <a:off x="3546360" y="5681520"/>
                  <a:ext cx="1024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Low AKT (E/N =52/71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8" name="Rectangle 393"/>
                <p:cNvSpPr/>
                <p:nvPr/>
              </p:nvSpPr>
              <p:spPr>
                <a:xfrm>
                  <a:off x="3548520" y="5961240"/>
                  <a:ext cx="10188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High AKT (E/N=29/58)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39" name="Rectangle 394"/>
                <p:cNvSpPr/>
                <p:nvPr/>
              </p:nvSpPr>
              <p:spPr>
                <a:xfrm>
                  <a:off x="3255120" y="5261040"/>
                  <a:ext cx="52668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P=0.005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0" name="Rectangle 395"/>
                <p:cNvSpPr/>
                <p:nvPr/>
              </p:nvSpPr>
              <p:spPr>
                <a:xfrm>
                  <a:off x="4841640" y="3660840"/>
                  <a:ext cx="1882800" cy="274140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1" name="Rectangle 396"/>
                <p:cNvSpPr/>
                <p:nvPr/>
              </p:nvSpPr>
              <p:spPr>
                <a:xfrm>
                  <a:off x="5052600" y="3660840"/>
                  <a:ext cx="1671840" cy="2512800"/>
                </a:xfrm>
                <a:prstGeom prst="rect">
                  <a:avLst/>
                </a:prstGeom>
                <a:solidFill>
                  <a:srgbClr val="ffffff"/>
                </a:solidFill>
                <a:ln w="792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2" name="Freeform 397"/>
                <p:cNvSpPr/>
                <p:nvPr/>
              </p:nvSpPr>
              <p:spPr>
                <a:xfrm>
                  <a:off x="5132160" y="3741840"/>
                  <a:ext cx="1390680" cy="1166760"/>
                </a:xfrm>
                <a:custGeom>
                  <a:avLst/>
                  <a:gdLst/>
                  <a:ahLst/>
                  <a:rect l="l" t="t" r="r" b="b"/>
                  <a:pathLst>
                    <a:path w="608" h="51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6" y="0"/>
                      </a:lnTo>
                      <a:lnTo>
                        <a:pt x="16" y="60"/>
                      </a:lnTo>
                      <a:lnTo>
                        <a:pt x="27" y="60"/>
                      </a:lnTo>
                      <a:lnTo>
                        <a:pt x="27" y="121"/>
                      </a:lnTo>
                      <a:lnTo>
                        <a:pt x="88" y="121"/>
                      </a:lnTo>
                      <a:lnTo>
                        <a:pt x="121" y="121"/>
                      </a:lnTo>
                      <a:lnTo>
                        <a:pt x="121" y="186"/>
                      </a:lnTo>
                      <a:lnTo>
                        <a:pt x="132" y="186"/>
                      </a:lnTo>
                      <a:lnTo>
                        <a:pt x="132" y="251"/>
                      </a:lnTo>
                      <a:lnTo>
                        <a:pt x="292" y="251"/>
                      </a:lnTo>
                      <a:lnTo>
                        <a:pt x="294" y="251"/>
                      </a:lnTo>
                      <a:lnTo>
                        <a:pt x="320" y="251"/>
                      </a:lnTo>
                      <a:lnTo>
                        <a:pt x="321" y="251"/>
                      </a:lnTo>
                      <a:lnTo>
                        <a:pt x="325" y="251"/>
                      </a:lnTo>
                      <a:lnTo>
                        <a:pt x="325" y="328"/>
                      </a:lnTo>
                      <a:lnTo>
                        <a:pt x="331" y="328"/>
                      </a:lnTo>
                      <a:lnTo>
                        <a:pt x="331" y="406"/>
                      </a:lnTo>
                      <a:lnTo>
                        <a:pt x="364" y="406"/>
                      </a:lnTo>
                      <a:lnTo>
                        <a:pt x="425" y="406"/>
                      </a:lnTo>
                      <a:lnTo>
                        <a:pt x="447" y="406"/>
                      </a:lnTo>
                      <a:lnTo>
                        <a:pt x="447" y="510"/>
                      </a:lnTo>
                      <a:lnTo>
                        <a:pt x="524" y="510"/>
                      </a:lnTo>
                      <a:lnTo>
                        <a:pt x="525" y="510"/>
                      </a:lnTo>
                      <a:lnTo>
                        <a:pt x="530" y="510"/>
                      </a:lnTo>
                      <a:lnTo>
                        <a:pt x="531" y="510"/>
                      </a:lnTo>
                      <a:lnTo>
                        <a:pt x="590" y="510"/>
                      </a:lnTo>
                      <a:lnTo>
                        <a:pt x="592" y="510"/>
                      </a:lnTo>
                      <a:lnTo>
                        <a:pt x="596" y="510"/>
                      </a:lnTo>
                      <a:lnTo>
                        <a:pt x="597" y="510"/>
                      </a:lnTo>
                      <a:lnTo>
                        <a:pt x="607" y="510"/>
                      </a:lnTo>
                      <a:lnTo>
                        <a:pt x="608" y="510"/>
                      </a:lnTo>
                    </a:path>
                  </a:pathLst>
                </a:custGeom>
                <a:noFill/>
                <a:ln w="30240">
                  <a:solidFill>
                    <a:srgbClr val="1a476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3" name="Freeform 398"/>
                <p:cNvSpPr/>
                <p:nvPr/>
              </p:nvSpPr>
              <p:spPr>
                <a:xfrm>
                  <a:off x="5132160" y="3741840"/>
                  <a:ext cx="1400040" cy="441360"/>
                </a:xfrm>
                <a:custGeom>
                  <a:avLst/>
                  <a:gdLst/>
                  <a:ahLst/>
                  <a:rect l="l" t="t" r="r" b="b"/>
                  <a:pathLst>
                    <a:path w="612" h="193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" y="0"/>
                      </a:lnTo>
                      <a:lnTo>
                        <a:pt x="5" y="64"/>
                      </a:lnTo>
                      <a:lnTo>
                        <a:pt x="88" y="64"/>
                      </a:lnTo>
                      <a:lnTo>
                        <a:pt x="88" y="128"/>
                      </a:lnTo>
                      <a:lnTo>
                        <a:pt x="138" y="128"/>
                      </a:lnTo>
                      <a:lnTo>
                        <a:pt x="138" y="193"/>
                      </a:lnTo>
                      <a:lnTo>
                        <a:pt x="204" y="193"/>
                      </a:lnTo>
                      <a:lnTo>
                        <a:pt x="276" y="193"/>
                      </a:lnTo>
                      <a:lnTo>
                        <a:pt x="281" y="193"/>
                      </a:lnTo>
                      <a:lnTo>
                        <a:pt x="331" y="193"/>
                      </a:lnTo>
                      <a:lnTo>
                        <a:pt x="386" y="193"/>
                      </a:lnTo>
                      <a:lnTo>
                        <a:pt x="392" y="193"/>
                      </a:lnTo>
                      <a:lnTo>
                        <a:pt x="403" y="193"/>
                      </a:lnTo>
                      <a:lnTo>
                        <a:pt x="530" y="193"/>
                      </a:lnTo>
                      <a:lnTo>
                        <a:pt x="546" y="193"/>
                      </a:lnTo>
                      <a:lnTo>
                        <a:pt x="552" y="193"/>
                      </a:lnTo>
                      <a:lnTo>
                        <a:pt x="612" y="193"/>
                      </a:lnTo>
                    </a:path>
                  </a:pathLst>
                </a:custGeom>
                <a:noFill/>
                <a:ln w="30240">
                  <a:solidFill>
                    <a:srgbClr val="90353b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4" name="Line 399"/>
                <p:cNvSpPr/>
                <p:nvPr/>
              </p:nvSpPr>
              <p:spPr>
                <a:xfrm flipV="1">
                  <a:off x="5333760" y="3970440"/>
                  <a:ext cx="1440" cy="489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60" bIns="21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5" name="Line 400"/>
                <p:cNvSpPr/>
                <p:nvPr/>
              </p:nvSpPr>
              <p:spPr>
                <a:xfrm flipV="1">
                  <a:off x="5598720" y="4134960"/>
                  <a:ext cx="180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6" name="Line 401"/>
                <p:cNvSpPr/>
                <p:nvPr/>
              </p:nvSpPr>
              <p:spPr>
                <a:xfrm flipV="1">
                  <a:off x="5763960" y="413496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7" name="Line 402"/>
                <p:cNvSpPr/>
                <p:nvPr/>
              </p:nvSpPr>
              <p:spPr>
                <a:xfrm flipV="1">
                  <a:off x="5775120" y="413496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8" name="Line 403"/>
                <p:cNvSpPr/>
                <p:nvPr/>
              </p:nvSpPr>
              <p:spPr>
                <a:xfrm flipV="1">
                  <a:off x="5805000" y="4268880"/>
                  <a:ext cx="1800" cy="46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49" name="Line 404"/>
                <p:cNvSpPr/>
                <p:nvPr/>
              </p:nvSpPr>
              <p:spPr>
                <a:xfrm flipV="1">
                  <a:off x="5866920" y="4268880"/>
                  <a:ext cx="1800" cy="46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0" name="Line 405"/>
                <p:cNvSpPr/>
                <p:nvPr/>
              </p:nvSpPr>
              <p:spPr>
                <a:xfrm flipV="1">
                  <a:off x="5889240" y="4134960"/>
                  <a:ext cx="1440" cy="47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80" bIns="1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451" name="Line 407"/>
              <p:cNvSpPr/>
              <p:nvPr/>
            </p:nvSpPr>
            <p:spPr>
              <a:xfrm flipV="1">
                <a:off x="5963760" y="4624200"/>
                <a:ext cx="1800" cy="4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2" name="Line 408"/>
              <p:cNvSpPr/>
              <p:nvPr/>
            </p:nvSpPr>
            <p:spPr>
              <a:xfrm flipV="1">
                <a:off x="6014520" y="413496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3" name="Line 409"/>
              <p:cNvSpPr/>
              <p:nvPr/>
            </p:nvSpPr>
            <p:spPr>
              <a:xfrm flipV="1">
                <a:off x="6028920" y="413496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4" name="Line 410"/>
              <p:cNvSpPr/>
              <p:nvPr/>
            </p:nvSpPr>
            <p:spPr>
              <a:xfrm flipV="1">
                <a:off x="6054480" y="4134960"/>
                <a:ext cx="144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5" name="Line 411"/>
              <p:cNvSpPr/>
              <p:nvPr/>
            </p:nvSpPr>
            <p:spPr>
              <a:xfrm flipV="1">
                <a:off x="6103440" y="4624200"/>
                <a:ext cx="1800" cy="4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6" name="Line 412"/>
              <p:cNvSpPr/>
              <p:nvPr/>
            </p:nvSpPr>
            <p:spPr>
              <a:xfrm flipV="1">
                <a:off x="6332040" y="486108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7" name="Line 413"/>
              <p:cNvSpPr/>
              <p:nvPr/>
            </p:nvSpPr>
            <p:spPr>
              <a:xfrm flipV="1">
                <a:off x="6346440" y="4861080"/>
                <a:ext cx="14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8" name="Line 414"/>
              <p:cNvSpPr/>
              <p:nvPr/>
            </p:nvSpPr>
            <p:spPr>
              <a:xfrm flipV="1">
                <a:off x="6343200" y="413496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9" name="Line 415"/>
              <p:cNvSpPr/>
              <p:nvPr/>
            </p:nvSpPr>
            <p:spPr>
              <a:xfrm flipV="1">
                <a:off x="6381360" y="4134960"/>
                <a:ext cx="144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0" name="Line 416"/>
              <p:cNvSpPr/>
              <p:nvPr/>
            </p:nvSpPr>
            <p:spPr>
              <a:xfrm flipV="1">
                <a:off x="6393960" y="413496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1" name="Line 417"/>
              <p:cNvSpPr/>
              <p:nvPr/>
            </p:nvSpPr>
            <p:spPr>
              <a:xfrm flipV="1">
                <a:off x="6486120" y="486108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2" name="Line 418"/>
              <p:cNvSpPr/>
              <p:nvPr/>
            </p:nvSpPr>
            <p:spPr>
              <a:xfrm flipV="1">
                <a:off x="6497280" y="4861080"/>
                <a:ext cx="14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3" name="Line 419"/>
              <p:cNvSpPr/>
              <p:nvPr/>
            </p:nvSpPr>
            <p:spPr>
              <a:xfrm flipV="1">
                <a:off x="6522840" y="4861080"/>
                <a:ext cx="14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4" name="Line 420"/>
              <p:cNvSpPr/>
              <p:nvPr/>
            </p:nvSpPr>
            <p:spPr>
              <a:xfrm flipV="1">
                <a:off x="6532200" y="4134960"/>
                <a:ext cx="144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5" name="Line 421"/>
              <p:cNvSpPr/>
              <p:nvPr/>
            </p:nvSpPr>
            <p:spPr>
              <a:xfrm flipV="1">
                <a:off x="5052600" y="3660480"/>
                <a:ext cx="1800" cy="2514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6" name="Line 422"/>
              <p:cNvSpPr/>
              <p:nvPr/>
            </p:nvSpPr>
            <p:spPr>
              <a:xfrm flipH="1">
                <a:off x="5000040" y="6095880"/>
                <a:ext cx="522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7" name="Rectangle 423"/>
              <p:cNvSpPr/>
              <p:nvPr/>
            </p:nvSpPr>
            <p:spPr>
              <a:xfrm rot="16200000">
                <a:off x="4779000" y="601956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8" name="Line 424"/>
              <p:cNvSpPr/>
              <p:nvPr/>
            </p:nvSpPr>
            <p:spPr>
              <a:xfrm flipH="1">
                <a:off x="5000040" y="5506920"/>
                <a:ext cx="522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9" name="Rectangle 425"/>
              <p:cNvSpPr/>
              <p:nvPr/>
            </p:nvSpPr>
            <p:spPr>
              <a:xfrm rot="16200000">
                <a:off x="4779000" y="542916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2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0" name="Line 426"/>
              <p:cNvSpPr/>
              <p:nvPr/>
            </p:nvSpPr>
            <p:spPr>
              <a:xfrm flipH="1">
                <a:off x="5000040" y="4917960"/>
                <a:ext cx="5220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1" name="Rectangle 427"/>
              <p:cNvSpPr/>
              <p:nvPr/>
            </p:nvSpPr>
            <p:spPr>
              <a:xfrm rot="16200000">
                <a:off x="4779000" y="484020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5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2" name="Line 428"/>
              <p:cNvSpPr/>
              <p:nvPr/>
            </p:nvSpPr>
            <p:spPr>
              <a:xfrm flipH="1">
                <a:off x="5000040" y="4330800"/>
                <a:ext cx="522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3" name="Rectangle 429"/>
              <p:cNvSpPr/>
              <p:nvPr/>
            </p:nvSpPr>
            <p:spPr>
              <a:xfrm rot="16200000">
                <a:off x="4779000" y="425268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7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4" name="Line 430"/>
              <p:cNvSpPr/>
              <p:nvPr/>
            </p:nvSpPr>
            <p:spPr>
              <a:xfrm flipH="1">
                <a:off x="5000040" y="3741840"/>
                <a:ext cx="522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5" name="Rectangle 431"/>
              <p:cNvSpPr/>
              <p:nvPr/>
            </p:nvSpPr>
            <p:spPr>
              <a:xfrm rot="16200000">
                <a:off x="4779000" y="366372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.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6" name="Line 432"/>
              <p:cNvSpPr/>
              <p:nvPr/>
            </p:nvSpPr>
            <p:spPr>
              <a:xfrm>
                <a:off x="5052600" y="6175440"/>
                <a:ext cx="167328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7" name="Line 433"/>
              <p:cNvSpPr/>
              <p:nvPr/>
            </p:nvSpPr>
            <p:spPr>
              <a:xfrm>
                <a:off x="5132160" y="6175440"/>
                <a:ext cx="144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8" name="Rectangle 434"/>
              <p:cNvSpPr/>
              <p:nvPr/>
            </p:nvSpPr>
            <p:spPr>
              <a:xfrm>
                <a:off x="5096520" y="625140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9" name="Line 435"/>
              <p:cNvSpPr/>
              <p:nvPr/>
            </p:nvSpPr>
            <p:spPr>
              <a:xfrm>
                <a:off x="5433480" y="6175440"/>
                <a:ext cx="180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0" name="Rectangle 436"/>
              <p:cNvSpPr/>
              <p:nvPr/>
            </p:nvSpPr>
            <p:spPr>
              <a:xfrm>
                <a:off x="5363280" y="6251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1" name="Line 437"/>
              <p:cNvSpPr/>
              <p:nvPr/>
            </p:nvSpPr>
            <p:spPr>
              <a:xfrm>
                <a:off x="5738400" y="6175440"/>
                <a:ext cx="180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2" name="Rectangle 438"/>
              <p:cNvSpPr/>
              <p:nvPr/>
            </p:nvSpPr>
            <p:spPr>
              <a:xfrm>
                <a:off x="5667840" y="6251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48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3" name="Line 439"/>
              <p:cNvSpPr/>
              <p:nvPr/>
            </p:nvSpPr>
            <p:spPr>
              <a:xfrm>
                <a:off x="6040080" y="6175440"/>
                <a:ext cx="144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4" name="Rectangle 440"/>
              <p:cNvSpPr/>
              <p:nvPr/>
            </p:nvSpPr>
            <p:spPr>
              <a:xfrm>
                <a:off x="5969520" y="6251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5" name="Line 441"/>
              <p:cNvSpPr/>
              <p:nvPr/>
            </p:nvSpPr>
            <p:spPr>
              <a:xfrm>
                <a:off x="6343200" y="6175440"/>
                <a:ext cx="180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6" name="Rectangle 442"/>
              <p:cNvSpPr/>
              <p:nvPr/>
            </p:nvSpPr>
            <p:spPr>
              <a:xfrm>
                <a:off x="6272640" y="6251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9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7" name="Line 443"/>
              <p:cNvSpPr/>
              <p:nvPr/>
            </p:nvSpPr>
            <p:spPr>
              <a:xfrm>
                <a:off x="6646680" y="6175440"/>
                <a:ext cx="144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8" name="Rectangle 444"/>
              <p:cNvSpPr/>
              <p:nvPr/>
            </p:nvSpPr>
            <p:spPr>
              <a:xfrm>
                <a:off x="6540840" y="6251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9" name="Rectangle 445"/>
              <p:cNvSpPr/>
              <p:nvPr/>
            </p:nvSpPr>
            <p:spPr>
              <a:xfrm>
                <a:off x="5095440" y="5614920"/>
                <a:ext cx="1584360" cy="51444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0" name="Line 446"/>
              <p:cNvSpPr/>
              <p:nvPr/>
            </p:nvSpPr>
            <p:spPr>
              <a:xfrm>
                <a:off x="5151240" y="5734080"/>
                <a:ext cx="90360" cy="1440"/>
              </a:xfrm>
              <a:prstGeom prst="line">
                <a:avLst/>
              </a:prstGeom>
              <a:ln w="30240">
                <a:solidFill>
                  <a:srgbClr val="1a476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1" name="Line 447"/>
              <p:cNvSpPr/>
              <p:nvPr/>
            </p:nvSpPr>
            <p:spPr>
              <a:xfrm>
                <a:off x="5151240" y="6013440"/>
                <a:ext cx="90360" cy="1440"/>
              </a:xfrm>
              <a:prstGeom prst="line">
                <a:avLst/>
              </a:prstGeom>
              <a:ln w="30240">
                <a:solidFill>
                  <a:srgbClr val="90353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2" name="Rectangle 448"/>
              <p:cNvSpPr/>
              <p:nvPr/>
            </p:nvSpPr>
            <p:spPr>
              <a:xfrm>
                <a:off x="5306760" y="5681520"/>
                <a:ext cx="1323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Low AKT(pT308) (E/N =7/17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3" name="Rectangle 449"/>
              <p:cNvSpPr/>
              <p:nvPr/>
            </p:nvSpPr>
            <p:spPr>
              <a:xfrm>
                <a:off x="5308560" y="5961240"/>
                <a:ext cx="1283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High AKT(pT308 (E/N=3/16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4" name="Rectangle 450"/>
              <p:cNvSpPr/>
              <p:nvPr/>
            </p:nvSpPr>
            <p:spPr>
              <a:xfrm>
                <a:off x="5113800" y="5281560"/>
                <a:ext cx="3711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P=0.2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5" name="Rectangle 451"/>
              <p:cNvSpPr/>
              <p:nvPr/>
            </p:nvSpPr>
            <p:spPr>
              <a:xfrm>
                <a:off x="6725880" y="3660840"/>
                <a:ext cx="1884240" cy="274140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6" name="Rectangle 452"/>
              <p:cNvSpPr/>
              <p:nvPr/>
            </p:nvSpPr>
            <p:spPr>
              <a:xfrm>
                <a:off x="6932160" y="3660840"/>
                <a:ext cx="1677960" cy="251280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7" name="Freeform 453"/>
              <p:cNvSpPr/>
              <p:nvPr/>
            </p:nvSpPr>
            <p:spPr>
              <a:xfrm>
                <a:off x="7011720" y="3741840"/>
                <a:ext cx="1520640" cy="1768320"/>
              </a:xfrm>
              <a:custGeom>
                <a:avLst/>
                <a:gdLst/>
                <a:ahLst/>
                <a:rect l="l" t="t" r="r" b="b"/>
                <a:pathLst>
                  <a:path w="665" h="773">
                    <a:moveTo>
                      <a:pt x="0" y="0"/>
                    </a:moveTo>
                    <a:lnTo>
                      <a:pt x="0" y="0"/>
                    </a:lnTo>
                    <a:lnTo>
                      <a:pt x="5" y="0"/>
                    </a:lnTo>
                    <a:lnTo>
                      <a:pt x="5" y="14"/>
                    </a:lnTo>
                    <a:lnTo>
                      <a:pt x="10" y="14"/>
                    </a:lnTo>
                    <a:lnTo>
                      <a:pt x="10" y="28"/>
                    </a:lnTo>
                    <a:lnTo>
                      <a:pt x="15" y="28"/>
                    </a:lnTo>
                    <a:lnTo>
                      <a:pt x="15" y="42"/>
                    </a:lnTo>
                    <a:lnTo>
                      <a:pt x="35" y="42"/>
                    </a:lnTo>
                    <a:lnTo>
                      <a:pt x="35" y="56"/>
                    </a:lnTo>
                    <a:lnTo>
                      <a:pt x="45" y="56"/>
                    </a:lnTo>
                    <a:lnTo>
                      <a:pt x="45" y="70"/>
                    </a:lnTo>
                    <a:lnTo>
                      <a:pt x="50" y="70"/>
                    </a:lnTo>
                    <a:lnTo>
                      <a:pt x="50" y="84"/>
                    </a:lnTo>
                    <a:lnTo>
                      <a:pt x="55" y="84"/>
                    </a:lnTo>
                    <a:lnTo>
                      <a:pt x="55" y="98"/>
                    </a:lnTo>
                    <a:lnTo>
                      <a:pt x="60" y="98"/>
                    </a:lnTo>
                    <a:lnTo>
                      <a:pt x="60" y="127"/>
                    </a:lnTo>
                    <a:lnTo>
                      <a:pt x="65" y="127"/>
                    </a:lnTo>
                    <a:lnTo>
                      <a:pt x="65" y="141"/>
                    </a:lnTo>
                    <a:lnTo>
                      <a:pt x="70" y="141"/>
                    </a:lnTo>
                    <a:lnTo>
                      <a:pt x="70" y="169"/>
                    </a:lnTo>
                    <a:lnTo>
                      <a:pt x="75" y="169"/>
                    </a:lnTo>
                    <a:lnTo>
                      <a:pt x="75" y="197"/>
                    </a:lnTo>
                    <a:lnTo>
                      <a:pt x="80" y="197"/>
                    </a:lnTo>
                    <a:lnTo>
                      <a:pt x="80" y="211"/>
                    </a:lnTo>
                    <a:lnTo>
                      <a:pt x="85" y="211"/>
                    </a:lnTo>
                    <a:lnTo>
                      <a:pt x="85" y="225"/>
                    </a:lnTo>
                    <a:lnTo>
                      <a:pt x="90" y="225"/>
                    </a:lnTo>
                    <a:lnTo>
                      <a:pt x="90" y="239"/>
                    </a:lnTo>
                    <a:lnTo>
                      <a:pt x="95" y="239"/>
                    </a:lnTo>
                    <a:lnTo>
                      <a:pt x="95" y="268"/>
                    </a:lnTo>
                    <a:lnTo>
                      <a:pt x="100" y="268"/>
                    </a:lnTo>
                    <a:lnTo>
                      <a:pt x="100" y="282"/>
                    </a:lnTo>
                    <a:lnTo>
                      <a:pt x="111" y="282"/>
                    </a:lnTo>
                    <a:lnTo>
                      <a:pt x="111" y="296"/>
                    </a:lnTo>
                    <a:lnTo>
                      <a:pt x="115" y="296"/>
                    </a:lnTo>
                    <a:lnTo>
                      <a:pt x="115" y="338"/>
                    </a:lnTo>
                    <a:lnTo>
                      <a:pt x="121" y="338"/>
                    </a:lnTo>
                    <a:lnTo>
                      <a:pt x="121" y="352"/>
                    </a:lnTo>
                    <a:lnTo>
                      <a:pt x="126" y="352"/>
                    </a:lnTo>
                    <a:lnTo>
                      <a:pt x="126" y="366"/>
                    </a:lnTo>
                    <a:lnTo>
                      <a:pt x="131" y="366"/>
                    </a:lnTo>
                    <a:lnTo>
                      <a:pt x="131" y="409"/>
                    </a:lnTo>
                    <a:lnTo>
                      <a:pt x="146" y="409"/>
                    </a:lnTo>
                    <a:lnTo>
                      <a:pt x="146" y="423"/>
                    </a:lnTo>
                    <a:lnTo>
                      <a:pt x="156" y="423"/>
                    </a:lnTo>
                    <a:lnTo>
                      <a:pt x="156" y="479"/>
                    </a:lnTo>
                    <a:lnTo>
                      <a:pt x="171" y="479"/>
                    </a:lnTo>
                    <a:lnTo>
                      <a:pt x="171" y="493"/>
                    </a:lnTo>
                    <a:lnTo>
                      <a:pt x="176" y="493"/>
                    </a:lnTo>
                    <a:lnTo>
                      <a:pt x="176" y="507"/>
                    </a:lnTo>
                    <a:lnTo>
                      <a:pt x="181" y="507"/>
                    </a:lnTo>
                    <a:lnTo>
                      <a:pt x="181" y="521"/>
                    </a:lnTo>
                    <a:lnTo>
                      <a:pt x="191" y="521"/>
                    </a:lnTo>
                    <a:lnTo>
                      <a:pt x="191" y="550"/>
                    </a:lnTo>
                    <a:lnTo>
                      <a:pt x="196" y="550"/>
                    </a:lnTo>
                    <a:lnTo>
                      <a:pt x="196" y="564"/>
                    </a:lnTo>
                    <a:lnTo>
                      <a:pt x="216" y="564"/>
                    </a:lnTo>
                    <a:lnTo>
                      <a:pt x="216" y="578"/>
                    </a:lnTo>
                    <a:lnTo>
                      <a:pt x="226" y="578"/>
                    </a:lnTo>
                    <a:lnTo>
                      <a:pt x="226" y="592"/>
                    </a:lnTo>
                    <a:lnTo>
                      <a:pt x="241" y="592"/>
                    </a:lnTo>
                    <a:lnTo>
                      <a:pt x="241" y="620"/>
                    </a:lnTo>
                    <a:lnTo>
                      <a:pt x="251" y="620"/>
                    </a:lnTo>
                    <a:lnTo>
                      <a:pt x="251" y="634"/>
                    </a:lnTo>
                    <a:lnTo>
                      <a:pt x="256" y="634"/>
                    </a:lnTo>
                    <a:lnTo>
                      <a:pt x="258" y="634"/>
                    </a:lnTo>
                    <a:lnTo>
                      <a:pt x="281" y="634"/>
                    </a:lnTo>
                    <a:lnTo>
                      <a:pt x="283" y="634"/>
                    </a:lnTo>
                    <a:lnTo>
                      <a:pt x="286" y="634"/>
                    </a:lnTo>
                    <a:lnTo>
                      <a:pt x="288" y="634"/>
                    </a:lnTo>
                    <a:lnTo>
                      <a:pt x="301" y="634"/>
                    </a:lnTo>
                    <a:lnTo>
                      <a:pt x="301" y="650"/>
                    </a:lnTo>
                    <a:lnTo>
                      <a:pt x="303" y="650"/>
                    </a:lnTo>
                    <a:lnTo>
                      <a:pt x="311" y="650"/>
                    </a:lnTo>
                    <a:lnTo>
                      <a:pt x="311" y="666"/>
                    </a:lnTo>
                    <a:lnTo>
                      <a:pt x="316" y="666"/>
                    </a:lnTo>
                    <a:lnTo>
                      <a:pt x="318" y="666"/>
                    </a:lnTo>
                    <a:lnTo>
                      <a:pt x="326" y="666"/>
                    </a:lnTo>
                    <a:lnTo>
                      <a:pt x="328" y="666"/>
                    </a:lnTo>
                    <a:lnTo>
                      <a:pt x="332" y="666"/>
                    </a:lnTo>
                    <a:lnTo>
                      <a:pt x="333" y="666"/>
                    </a:lnTo>
                    <a:lnTo>
                      <a:pt x="357" y="666"/>
                    </a:lnTo>
                    <a:lnTo>
                      <a:pt x="358" y="666"/>
                    </a:lnTo>
                    <a:lnTo>
                      <a:pt x="362" y="666"/>
                    </a:lnTo>
                    <a:lnTo>
                      <a:pt x="363" y="666"/>
                    </a:lnTo>
                    <a:lnTo>
                      <a:pt x="422" y="666"/>
                    </a:lnTo>
                    <a:lnTo>
                      <a:pt x="422" y="691"/>
                    </a:lnTo>
                    <a:lnTo>
                      <a:pt x="424" y="691"/>
                    </a:lnTo>
                    <a:lnTo>
                      <a:pt x="437" y="691"/>
                    </a:lnTo>
                    <a:lnTo>
                      <a:pt x="439" y="691"/>
                    </a:lnTo>
                    <a:lnTo>
                      <a:pt x="447" y="691"/>
                    </a:lnTo>
                    <a:lnTo>
                      <a:pt x="447" y="721"/>
                    </a:lnTo>
                    <a:lnTo>
                      <a:pt x="482" y="721"/>
                    </a:lnTo>
                    <a:lnTo>
                      <a:pt x="502" y="721"/>
                    </a:lnTo>
                    <a:lnTo>
                      <a:pt x="528" y="721"/>
                    </a:lnTo>
                    <a:lnTo>
                      <a:pt x="543" y="721"/>
                    </a:lnTo>
                    <a:lnTo>
                      <a:pt x="543" y="773"/>
                    </a:lnTo>
                    <a:lnTo>
                      <a:pt x="544" y="773"/>
                    </a:lnTo>
                    <a:lnTo>
                      <a:pt x="553" y="773"/>
                    </a:lnTo>
                    <a:lnTo>
                      <a:pt x="554" y="773"/>
                    </a:lnTo>
                    <a:lnTo>
                      <a:pt x="558" y="773"/>
                    </a:lnTo>
                    <a:lnTo>
                      <a:pt x="559" y="773"/>
                    </a:lnTo>
                    <a:lnTo>
                      <a:pt x="563" y="773"/>
                    </a:lnTo>
                    <a:lnTo>
                      <a:pt x="564" y="773"/>
                    </a:lnTo>
                    <a:lnTo>
                      <a:pt x="663" y="773"/>
                    </a:lnTo>
                    <a:lnTo>
                      <a:pt x="665" y="773"/>
                    </a:lnTo>
                  </a:path>
                </a:pathLst>
              </a:custGeom>
              <a:noFill/>
              <a:ln w="30240">
                <a:solidFill>
                  <a:srgbClr val="1a476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8" name="Freeform 454"/>
              <p:cNvSpPr/>
              <p:nvPr/>
            </p:nvSpPr>
            <p:spPr>
              <a:xfrm>
                <a:off x="7011720" y="3741840"/>
                <a:ext cx="1263600" cy="1363680"/>
              </a:xfrm>
              <a:custGeom>
                <a:avLst/>
                <a:gdLst/>
                <a:ahLst/>
                <a:rect l="l" t="t" r="r" b="b"/>
                <a:pathLst>
                  <a:path w="553" h="596">
                    <a:moveTo>
                      <a:pt x="0" y="0"/>
                    </a:moveTo>
                    <a:lnTo>
                      <a:pt x="0" y="0"/>
                    </a:lnTo>
                    <a:lnTo>
                      <a:pt x="15" y="0"/>
                    </a:lnTo>
                    <a:lnTo>
                      <a:pt x="15" y="18"/>
                    </a:lnTo>
                    <a:lnTo>
                      <a:pt x="25" y="18"/>
                    </a:lnTo>
                    <a:lnTo>
                      <a:pt x="25" y="36"/>
                    </a:lnTo>
                    <a:lnTo>
                      <a:pt x="30" y="36"/>
                    </a:lnTo>
                    <a:lnTo>
                      <a:pt x="30" y="55"/>
                    </a:lnTo>
                    <a:lnTo>
                      <a:pt x="45" y="55"/>
                    </a:lnTo>
                    <a:lnTo>
                      <a:pt x="45" y="110"/>
                    </a:lnTo>
                    <a:lnTo>
                      <a:pt x="60" y="110"/>
                    </a:lnTo>
                    <a:lnTo>
                      <a:pt x="60" y="128"/>
                    </a:lnTo>
                    <a:lnTo>
                      <a:pt x="70" y="128"/>
                    </a:lnTo>
                    <a:lnTo>
                      <a:pt x="70" y="147"/>
                    </a:lnTo>
                    <a:lnTo>
                      <a:pt x="75" y="147"/>
                    </a:lnTo>
                    <a:lnTo>
                      <a:pt x="75" y="165"/>
                    </a:lnTo>
                    <a:lnTo>
                      <a:pt x="80" y="165"/>
                    </a:lnTo>
                    <a:lnTo>
                      <a:pt x="80" y="184"/>
                    </a:lnTo>
                    <a:lnTo>
                      <a:pt x="85" y="184"/>
                    </a:lnTo>
                    <a:lnTo>
                      <a:pt x="85" y="202"/>
                    </a:lnTo>
                    <a:lnTo>
                      <a:pt x="95" y="202"/>
                    </a:lnTo>
                    <a:lnTo>
                      <a:pt x="95" y="220"/>
                    </a:lnTo>
                    <a:lnTo>
                      <a:pt x="100" y="220"/>
                    </a:lnTo>
                    <a:lnTo>
                      <a:pt x="100" y="257"/>
                    </a:lnTo>
                    <a:lnTo>
                      <a:pt x="105" y="257"/>
                    </a:lnTo>
                    <a:lnTo>
                      <a:pt x="105" y="294"/>
                    </a:lnTo>
                    <a:lnTo>
                      <a:pt x="111" y="294"/>
                    </a:lnTo>
                    <a:lnTo>
                      <a:pt x="111" y="312"/>
                    </a:lnTo>
                    <a:lnTo>
                      <a:pt x="121" y="312"/>
                    </a:lnTo>
                    <a:lnTo>
                      <a:pt x="121" y="367"/>
                    </a:lnTo>
                    <a:lnTo>
                      <a:pt x="131" y="367"/>
                    </a:lnTo>
                    <a:lnTo>
                      <a:pt x="131" y="386"/>
                    </a:lnTo>
                    <a:lnTo>
                      <a:pt x="166" y="386"/>
                    </a:lnTo>
                    <a:lnTo>
                      <a:pt x="166" y="404"/>
                    </a:lnTo>
                    <a:lnTo>
                      <a:pt x="181" y="404"/>
                    </a:lnTo>
                    <a:lnTo>
                      <a:pt x="196" y="404"/>
                    </a:lnTo>
                    <a:lnTo>
                      <a:pt x="196" y="423"/>
                    </a:lnTo>
                    <a:lnTo>
                      <a:pt x="201" y="423"/>
                    </a:lnTo>
                    <a:lnTo>
                      <a:pt x="202" y="423"/>
                    </a:lnTo>
                    <a:lnTo>
                      <a:pt x="236" y="423"/>
                    </a:lnTo>
                    <a:lnTo>
                      <a:pt x="236" y="443"/>
                    </a:lnTo>
                    <a:lnTo>
                      <a:pt x="241" y="443"/>
                    </a:lnTo>
                    <a:lnTo>
                      <a:pt x="241" y="482"/>
                    </a:lnTo>
                    <a:lnTo>
                      <a:pt x="246" y="482"/>
                    </a:lnTo>
                    <a:lnTo>
                      <a:pt x="246" y="521"/>
                    </a:lnTo>
                    <a:lnTo>
                      <a:pt x="251" y="521"/>
                    </a:lnTo>
                    <a:lnTo>
                      <a:pt x="256" y="521"/>
                    </a:lnTo>
                    <a:lnTo>
                      <a:pt x="256" y="541"/>
                    </a:lnTo>
                    <a:lnTo>
                      <a:pt x="266" y="541"/>
                    </a:lnTo>
                    <a:lnTo>
                      <a:pt x="286" y="541"/>
                    </a:lnTo>
                    <a:lnTo>
                      <a:pt x="357" y="541"/>
                    </a:lnTo>
                    <a:lnTo>
                      <a:pt x="372" y="541"/>
                    </a:lnTo>
                    <a:lnTo>
                      <a:pt x="372" y="567"/>
                    </a:lnTo>
                    <a:lnTo>
                      <a:pt x="377" y="567"/>
                    </a:lnTo>
                    <a:lnTo>
                      <a:pt x="382" y="567"/>
                    </a:lnTo>
                    <a:lnTo>
                      <a:pt x="417" y="567"/>
                    </a:lnTo>
                    <a:lnTo>
                      <a:pt x="417" y="596"/>
                    </a:lnTo>
                    <a:lnTo>
                      <a:pt x="422" y="596"/>
                    </a:lnTo>
                    <a:lnTo>
                      <a:pt x="437" y="596"/>
                    </a:lnTo>
                    <a:lnTo>
                      <a:pt x="452" y="596"/>
                    </a:lnTo>
                    <a:lnTo>
                      <a:pt x="457" y="596"/>
                    </a:lnTo>
                    <a:lnTo>
                      <a:pt x="462" y="596"/>
                    </a:lnTo>
                    <a:lnTo>
                      <a:pt x="467" y="596"/>
                    </a:lnTo>
                    <a:lnTo>
                      <a:pt x="477" y="596"/>
                    </a:lnTo>
                    <a:lnTo>
                      <a:pt x="482" y="596"/>
                    </a:lnTo>
                    <a:lnTo>
                      <a:pt x="497" y="596"/>
                    </a:lnTo>
                    <a:lnTo>
                      <a:pt x="538" y="596"/>
                    </a:lnTo>
                    <a:lnTo>
                      <a:pt x="543" y="596"/>
                    </a:lnTo>
                    <a:lnTo>
                      <a:pt x="553" y="596"/>
                    </a:lnTo>
                  </a:path>
                </a:pathLst>
              </a:custGeom>
              <a:noFill/>
              <a:ln w="30240">
                <a:solidFill>
                  <a:srgbClr val="90353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9" name="Line 455"/>
              <p:cNvSpPr/>
              <p:nvPr/>
            </p:nvSpPr>
            <p:spPr>
              <a:xfrm flipV="1">
                <a:off x="7426080" y="4618080"/>
                <a:ext cx="14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0" name="Line 456"/>
              <p:cNvSpPr/>
              <p:nvPr/>
            </p:nvSpPr>
            <p:spPr>
              <a:xfrm flipV="1">
                <a:off x="7473600" y="4660560"/>
                <a:ext cx="144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1" name="Line 457"/>
              <p:cNvSpPr/>
              <p:nvPr/>
            </p:nvSpPr>
            <p:spPr>
              <a:xfrm flipV="1">
                <a:off x="7584840" y="4886280"/>
                <a:ext cx="14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2" name="Line 458"/>
              <p:cNvSpPr/>
              <p:nvPr/>
            </p:nvSpPr>
            <p:spPr>
              <a:xfrm flipV="1">
                <a:off x="7602120" y="5146560"/>
                <a:ext cx="18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3" name="Line 459"/>
              <p:cNvSpPr/>
              <p:nvPr/>
            </p:nvSpPr>
            <p:spPr>
              <a:xfrm flipV="1">
                <a:off x="7619760" y="4930920"/>
                <a:ext cx="1440" cy="4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4" name="Line 460"/>
              <p:cNvSpPr/>
              <p:nvPr/>
            </p:nvSpPr>
            <p:spPr>
              <a:xfrm flipV="1">
                <a:off x="7659360" y="5146560"/>
                <a:ext cx="144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5" name="Line 461"/>
              <p:cNvSpPr/>
              <p:nvPr/>
            </p:nvSpPr>
            <p:spPr>
              <a:xfrm flipV="1">
                <a:off x="7670520" y="5146560"/>
                <a:ext cx="144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6" name="Line 462"/>
              <p:cNvSpPr/>
              <p:nvPr/>
            </p:nvSpPr>
            <p:spPr>
              <a:xfrm flipV="1">
                <a:off x="7665840" y="4930920"/>
                <a:ext cx="1440" cy="4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7" name="Line 463"/>
              <p:cNvSpPr/>
              <p:nvPr/>
            </p:nvSpPr>
            <p:spPr>
              <a:xfrm flipV="1">
                <a:off x="7703640" y="5179680"/>
                <a:ext cx="180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8" name="Line 464"/>
              <p:cNvSpPr/>
              <p:nvPr/>
            </p:nvSpPr>
            <p:spPr>
              <a:xfrm flipV="1">
                <a:off x="7738560" y="5219640"/>
                <a:ext cx="18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9" name="Line 465"/>
              <p:cNvSpPr/>
              <p:nvPr/>
            </p:nvSpPr>
            <p:spPr>
              <a:xfrm flipV="1">
                <a:off x="7760880" y="5219640"/>
                <a:ext cx="18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0" name="Line 466"/>
              <p:cNvSpPr/>
              <p:nvPr/>
            </p:nvSpPr>
            <p:spPr>
              <a:xfrm flipV="1">
                <a:off x="7773480" y="5219640"/>
                <a:ext cx="18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1" name="Line 467"/>
              <p:cNvSpPr/>
              <p:nvPr/>
            </p:nvSpPr>
            <p:spPr>
              <a:xfrm flipV="1">
                <a:off x="7830720" y="5219640"/>
                <a:ext cx="180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2" name="Line 468"/>
              <p:cNvSpPr/>
              <p:nvPr/>
            </p:nvSpPr>
            <p:spPr>
              <a:xfrm flipV="1">
                <a:off x="7827480" y="4930920"/>
                <a:ext cx="1800" cy="48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3" name="Line 469"/>
              <p:cNvSpPr/>
              <p:nvPr/>
            </p:nvSpPr>
            <p:spPr>
              <a:xfrm flipV="1">
                <a:off x="7841880" y="5219640"/>
                <a:ext cx="1440" cy="46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4" name="Line 470"/>
              <p:cNvSpPr/>
              <p:nvPr/>
            </p:nvSpPr>
            <p:spPr>
              <a:xfrm flipV="1">
                <a:off x="7873560" y="499104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5" name="Line 471"/>
              <p:cNvSpPr/>
              <p:nvPr/>
            </p:nvSpPr>
            <p:spPr>
              <a:xfrm flipV="1">
                <a:off x="7884720" y="499104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6" name="Line 472"/>
              <p:cNvSpPr/>
              <p:nvPr/>
            </p:nvSpPr>
            <p:spPr>
              <a:xfrm flipV="1">
                <a:off x="7981560" y="5273280"/>
                <a:ext cx="144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7" name="Line 473"/>
              <p:cNvSpPr/>
              <p:nvPr/>
            </p:nvSpPr>
            <p:spPr>
              <a:xfrm flipV="1">
                <a:off x="7976880" y="5057280"/>
                <a:ext cx="144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8" name="Line 474"/>
              <p:cNvSpPr/>
              <p:nvPr/>
            </p:nvSpPr>
            <p:spPr>
              <a:xfrm flipV="1">
                <a:off x="8015040" y="5273280"/>
                <a:ext cx="1440" cy="49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9" name="Line 475"/>
              <p:cNvSpPr/>
              <p:nvPr/>
            </p:nvSpPr>
            <p:spPr>
              <a:xfrm flipV="1">
                <a:off x="8010000" y="505728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0" name="Line 476"/>
              <p:cNvSpPr/>
              <p:nvPr/>
            </p:nvSpPr>
            <p:spPr>
              <a:xfrm flipV="1">
                <a:off x="8044920" y="505728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1" name="Line 477"/>
              <p:cNvSpPr/>
              <p:nvPr/>
            </p:nvSpPr>
            <p:spPr>
              <a:xfrm flipV="1">
                <a:off x="8056080" y="505728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2" name="Line 478"/>
              <p:cNvSpPr/>
              <p:nvPr/>
            </p:nvSpPr>
            <p:spPr>
              <a:xfrm flipV="1">
                <a:off x="8067240" y="505728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3" name="Line 479"/>
              <p:cNvSpPr/>
              <p:nvPr/>
            </p:nvSpPr>
            <p:spPr>
              <a:xfrm flipV="1">
                <a:off x="8078400" y="5057280"/>
                <a:ext cx="144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4" name="Line 480"/>
              <p:cNvSpPr/>
              <p:nvPr/>
            </p:nvSpPr>
            <p:spPr>
              <a:xfrm flipV="1">
                <a:off x="8102160" y="505728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5" name="Line 481"/>
              <p:cNvSpPr/>
              <p:nvPr/>
            </p:nvSpPr>
            <p:spPr>
              <a:xfrm flipV="1">
                <a:off x="8113320" y="5344920"/>
                <a:ext cx="1800" cy="4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6" name="Line 482"/>
              <p:cNvSpPr/>
              <p:nvPr/>
            </p:nvSpPr>
            <p:spPr>
              <a:xfrm flipV="1">
                <a:off x="8113320" y="505728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7" name="Line 483"/>
              <p:cNvSpPr/>
              <p:nvPr/>
            </p:nvSpPr>
            <p:spPr>
              <a:xfrm flipV="1">
                <a:off x="8148240" y="505728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8" name="Line 484"/>
              <p:cNvSpPr/>
              <p:nvPr/>
            </p:nvSpPr>
            <p:spPr>
              <a:xfrm flipV="1">
                <a:off x="8159400" y="5344920"/>
                <a:ext cx="1440" cy="4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9" name="Line 485"/>
              <p:cNvSpPr/>
              <p:nvPr/>
            </p:nvSpPr>
            <p:spPr>
              <a:xfrm flipV="1">
                <a:off x="8218080" y="5344920"/>
                <a:ext cx="1800" cy="45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0" name="Line 486"/>
              <p:cNvSpPr/>
              <p:nvPr/>
            </p:nvSpPr>
            <p:spPr>
              <a:xfrm flipV="1">
                <a:off x="8241840" y="505728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1" name="Line 487"/>
              <p:cNvSpPr/>
              <p:nvPr/>
            </p:nvSpPr>
            <p:spPr>
              <a:xfrm flipV="1">
                <a:off x="8254800" y="5462640"/>
                <a:ext cx="14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2" name="Line 488"/>
              <p:cNvSpPr/>
              <p:nvPr/>
            </p:nvSpPr>
            <p:spPr>
              <a:xfrm flipV="1">
                <a:off x="8253000" y="5057280"/>
                <a:ext cx="180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3" name="Line 489"/>
              <p:cNvSpPr/>
              <p:nvPr/>
            </p:nvSpPr>
            <p:spPr>
              <a:xfrm flipV="1">
                <a:off x="8278560" y="5462640"/>
                <a:ext cx="14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4" name="Line 490"/>
              <p:cNvSpPr/>
              <p:nvPr/>
            </p:nvSpPr>
            <p:spPr>
              <a:xfrm flipV="1">
                <a:off x="8275320" y="5057280"/>
                <a:ext cx="1440" cy="4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5" name="Line 491"/>
              <p:cNvSpPr/>
              <p:nvPr/>
            </p:nvSpPr>
            <p:spPr>
              <a:xfrm flipV="1">
                <a:off x="8289720" y="5462640"/>
                <a:ext cx="144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6" name="Line 492"/>
              <p:cNvSpPr/>
              <p:nvPr/>
            </p:nvSpPr>
            <p:spPr>
              <a:xfrm flipV="1">
                <a:off x="8300520" y="546264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7" name="Line 493"/>
              <p:cNvSpPr/>
              <p:nvPr/>
            </p:nvSpPr>
            <p:spPr>
              <a:xfrm flipV="1">
                <a:off x="8532360" y="5462640"/>
                <a:ext cx="1800" cy="4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8" name="Line 494"/>
              <p:cNvSpPr/>
              <p:nvPr/>
            </p:nvSpPr>
            <p:spPr>
              <a:xfrm flipV="1">
                <a:off x="6932160" y="3660480"/>
                <a:ext cx="1800" cy="25146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9" name="Line 495"/>
              <p:cNvSpPr/>
              <p:nvPr/>
            </p:nvSpPr>
            <p:spPr>
              <a:xfrm flipH="1">
                <a:off x="6881040" y="6095880"/>
                <a:ext cx="507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0" name="Rectangle 496"/>
              <p:cNvSpPr/>
              <p:nvPr/>
            </p:nvSpPr>
            <p:spPr>
              <a:xfrm rot="16200000">
                <a:off x="6658560" y="601956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1" name="Line 497"/>
              <p:cNvSpPr/>
              <p:nvPr/>
            </p:nvSpPr>
            <p:spPr>
              <a:xfrm flipH="1">
                <a:off x="6881040" y="5506920"/>
                <a:ext cx="507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2" name="Rectangle 498"/>
              <p:cNvSpPr/>
              <p:nvPr/>
            </p:nvSpPr>
            <p:spPr>
              <a:xfrm rot="16200000">
                <a:off x="6658560" y="543060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2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3" name="Line 499"/>
              <p:cNvSpPr/>
              <p:nvPr/>
            </p:nvSpPr>
            <p:spPr>
              <a:xfrm flipH="1">
                <a:off x="6881040" y="4917960"/>
                <a:ext cx="507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4" name="Rectangle 500"/>
              <p:cNvSpPr/>
              <p:nvPr/>
            </p:nvSpPr>
            <p:spPr>
              <a:xfrm rot="16200000">
                <a:off x="6658560" y="48416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5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5" name="Line 501"/>
              <p:cNvSpPr/>
              <p:nvPr/>
            </p:nvSpPr>
            <p:spPr>
              <a:xfrm flipH="1">
                <a:off x="6881040" y="4330800"/>
                <a:ext cx="507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6" name="Rectangle 502"/>
              <p:cNvSpPr/>
              <p:nvPr/>
            </p:nvSpPr>
            <p:spPr>
              <a:xfrm rot="16200000">
                <a:off x="6658560" y="425448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7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7" name="Line 503"/>
              <p:cNvSpPr/>
              <p:nvPr/>
            </p:nvSpPr>
            <p:spPr>
              <a:xfrm flipH="1">
                <a:off x="6881040" y="3741840"/>
                <a:ext cx="507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8" name="Rectangle 504"/>
              <p:cNvSpPr/>
              <p:nvPr/>
            </p:nvSpPr>
            <p:spPr>
              <a:xfrm rot="16200000">
                <a:off x="6658560" y="366372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.0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9" name="Line 505"/>
              <p:cNvSpPr/>
              <p:nvPr/>
            </p:nvSpPr>
            <p:spPr>
              <a:xfrm>
                <a:off x="6932160" y="6175440"/>
                <a:ext cx="16797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0" name="Line 506"/>
              <p:cNvSpPr/>
              <p:nvPr/>
            </p:nvSpPr>
            <p:spPr>
              <a:xfrm>
                <a:off x="7011720" y="6175440"/>
                <a:ext cx="144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1" name="Rectangle 507"/>
              <p:cNvSpPr/>
              <p:nvPr/>
            </p:nvSpPr>
            <p:spPr>
              <a:xfrm>
                <a:off x="6976080" y="625140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2" name="Line 508"/>
              <p:cNvSpPr/>
              <p:nvPr/>
            </p:nvSpPr>
            <p:spPr>
              <a:xfrm>
                <a:off x="7287840" y="6175440"/>
                <a:ext cx="144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3" name="Rectangle 509"/>
              <p:cNvSpPr/>
              <p:nvPr/>
            </p:nvSpPr>
            <p:spPr>
              <a:xfrm>
                <a:off x="7217280" y="6251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24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4" name="Line 510"/>
              <p:cNvSpPr/>
              <p:nvPr/>
            </p:nvSpPr>
            <p:spPr>
              <a:xfrm>
                <a:off x="7562520" y="6175440"/>
                <a:ext cx="144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5" name="Rectangle 511"/>
              <p:cNvSpPr/>
              <p:nvPr/>
            </p:nvSpPr>
            <p:spPr>
              <a:xfrm>
                <a:off x="7491960" y="6251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48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6" name="Line 512"/>
              <p:cNvSpPr/>
              <p:nvPr/>
            </p:nvSpPr>
            <p:spPr>
              <a:xfrm>
                <a:off x="7838640" y="6175440"/>
                <a:ext cx="180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7" name="Rectangle 513"/>
              <p:cNvSpPr/>
              <p:nvPr/>
            </p:nvSpPr>
            <p:spPr>
              <a:xfrm>
                <a:off x="7768080" y="6251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7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8" name="Line 514"/>
              <p:cNvSpPr/>
              <p:nvPr/>
            </p:nvSpPr>
            <p:spPr>
              <a:xfrm>
                <a:off x="8113320" y="6175440"/>
                <a:ext cx="180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9" name="Rectangle 515"/>
              <p:cNvSpPr/>
              <p:nvPr/>
            </p:nvSpPr>
            <p:spPr>
              <a:xfrm>
                <a:off x="8042760" y="625140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9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0" name="Line 516"/>
              <p:cNvSpPr/>
              <p:nvPr/>
            </p:nvSpPr>
            <p:spPr>
              <a:xfrm>
                <a:off x="8389440" y="6175440"/>
                <a:ext cx="1800" cy="50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1" name="Rectangle 517"/>
              <p:cNvSpPr/>
              <p:nvPr/>
            </p:nvSpPr>
            <p:spPr>
              <a:xfrm>
                <a:off x="8283960" y="6251400"/>
                <a:ext cx="210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2" name="Rectangle 518"/>
              <p:cNvSpPr/>
              <p:nvPr/>
            </p:nvSpPr>
            <p:spPr>
              <a:xfrm>
                <a:off x="6975000" y="5614920"/>
                <a:ext cx="1590840" cy="514440"/>
              </a:xfrm>
              <a:prstGeom prst="rect">
                <a:avLst/>
              </a:prstGeom>
              <a:solidFill>
                <a:srgbClr val="ffffff"/>
              </a:solidFill>
              <a:ln w="792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3" name="Line 519"/>
              <p:cNvSpPr/>
              <p:nvPr/>
            </p:nvSpPr>
            <p:spPr>
              <a:xfrm>
                <a:off x="7030800" y="5734080"/>
                <a:ext cx="88920" cy="1440"/>
              </a:xfrm>
              <a:prstGeom prst="line">
                <a:avLst/>
              </a:prstGeom>
              <a:ln w="30240">
                <a:solidFill>
                  <a:srgbClr val="1a476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4" name="Line 520"/>
              <p:cNvSpPr/>
              <p:nvPr/>
            </p:nvSpPr>
            <p:spPr>
              <a:xfrm>
                <a:off x="7030800" y="6013440"/>
                <a:ext cx="88920" cy="1440"/>
              </a:xfrm>
              <a:prstGeom prst="line">
                <a:avLst/>
              </a:prstGeom>
              <a:ln w="30240">
                <a:solidFill>
                  <a:srgbClr val="90353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5" name="Rectangle 521"/>
              <p:cNvSpPr/>
              <p:nvPr/>
            </p:nvSpPr>
            <p:spPr>
              <a:xfrm>
                <a:off x="7128720" y="5681520"/>
                <a:ext cx="1379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Low AKT(pT308) (E/N =50/73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6" name="Rectangle 522"/>
              <p:cNvSpPr/>
              <p:nvPr/>
            </p:nvSpPr>
            <p:spPr>
              <a:xfrm>
                <a:off x="7160760" y="5961240"/>
                <a:ext cx="1340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High AKT(pT308 (E/N=31/56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7" name="Rectangle 523"/>
              <p:cNvSpPr/>
              <p:nvPr/>
            </p:nvSpPr>
            <p:spPr>
              <a:xfrm>
                <a:off x="6982560" y="5322960"/>
                <a:ext cx="3711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P=0.2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1T16:47:52Z</dcterms:created>
  <dc:creator>Khandan Keyomarsi</dc:creator>
  <dc:description/>
  <dc:language>en-US</dc:language>
  <cp:lastModifiedBy>Khandan Keyomarsi</cp:lastModifiedBy>
  <dcterms:modified xsi:type="dcterms:W3CDTF">2012-02-01T22:16:14Z</dcterms:modified>
  <cp:revision>2</cp:revision>
  <dc:subject/>
  <dc:title>PowerPoint Presentation</dc:title>
</cp:coreProperties>
</file>